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08" y="-5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992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5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323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454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476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976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641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10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490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355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856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A156D1-7385-4B86-A4F3-DBE11960B8FA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5A3ED-A461-4859-AAB4-FD4230008D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500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Titre 1"/>
          <p:cNvSpPr txBox="1">
            <a:spLocks/>
          </p:cNvSpPr>
          <p:nvPr/>
        </p:nvSpPr>
        <p:spPr bwMode="auto">
          <a:xfrm>
            <a:off x="7114290" y="-14041"/>
            <a:ext cx="2007976" cy="2746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fr-FR" altLang="fr-FR" sz="1800" dirty="0" err="1">
                <a:latin typeface="Arial" charset="0"/>
              </a:rPr>
              <a:t>Suppl</a:t>
            </a:r>
            <a:r>
              <a:rPr lang="fr-FR" altLang="fr-FR" sz="1800" dirty="0">
                <a:latin typeface="Arial" charset="0"/>
              </a:rPr>
              <a:t> Figure </a:t>
            </a:r>
            <a:r>
              <a:rPr lang="fr-FR" altLang="fr-FR" sz="1800" dirty="0" smtClean="0">
                <a:latin typeface="Arial" charset="0"/>
              </a:rPr>
              <a:t>3</a:t>
            </a:r>
            <a:endParaRPr lang="fr-FR" altLang="fr-FR" sz="1800" dirty="0">
              <a:latin typeface="Arial" charset="0"/>
            </a:endParaRPr>
          </a:p>
        </p:txBody>
      </p:sp>
      <p:grpSp>
        <p:nvGrpSpPr>
          <p:cNvPr id="370" name="Groupe 369"/>
          <p:cNvGrpSpPr/>
          <p:nvPr/>
        </p:nvGrpSpPr>
        <p:grpSpPr>
          <a:xfrm>
            <a:off x="504870" y="371401"/>
            <a:ext cx="7984590" cy="6419930"/>
            <a:chOff x="504870" y="438070"/>
            <a:chExt cx="7984590" cy="6187815"/>
          </a:xfrm>
        </p:grpSpPr>
        <p:grpSp>
          <p:nvGrpSpPr>
            <p:cNvPr id="4" name="Groupe 3"/>
            <p:cNvGrpSpPr/>
            <p:nvPr/>
          </p:nvGrpSpPr>
          <p:grpSpPr>
            <a:xfrm>
              <a:off x="504870" y="438070"/>
              <a:ext cx="7984590" cy="6187815"/>
              <a:chOff x="504870" y="568696"/>
              <a:chExt cx="7984590" cy="6187815"/>
            </a:xfrm>
          </p:grpSpPr>
          <p:sp>
            <p:nvSpPr>
              <p:cNvPr id="351" name="Rectangle 193"/>
              <p:cNvSpPr>
                <a:spLocks noChangeArrowheads="1"/>
              </p:cNvSpPr>
              <p:nvPr/>
            </p:nvSpPr>
            <p:spPr bwMode="auto">
              <a:xfrm>
                <a:off x="4466224" y="1489069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effectLst/>
                  </a:rPr>
                  <a:t>39%</a:t>
                </a:r>
              </a:p>
            </p:txBody>
          </p:sp>
          <p:sp>
            <p:nvSpPr>
              <p:cNvPr id="258" name="Rectangle 306"/>
              <p:cNvSpPr>
                <a:spLocks noChangeArrowheads="1"/>
              </p:cNvSpPr>
              <p:nvPr/>
            </p:nvSpPr>
            <p:spPr bwMode="auto">
              <a:xfrm>
                <a:off x="4466084" y="3169529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70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2" name="Rectangle 193"/>
              <p:cNvSpPr>
                <a:spLocks noChangeArrowheads="1"/>
              </p:cNvSpPr>
              <p:nvPr/>
            </p:nvSpPr>
            <p:spPr bwMode="auto">
              <a:xfrm>
                <a:off x="6847332" y="3724248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2" name="Rectangle 269"/>
              <p:cNvSpPr>
                <a:spLocks noChangeArrowheads="1"/>
              </p:cNvSpPr>
              <p:nvPr/>
            </p:nvSpPr>
            <p:spPr bwMode="auto">
              <a:xfrm>
                <a:off x="1742419" y="3781167"/>
                <a:ext cx="230832" cy="1384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27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" name="Line 42"/>
              <p:cNvSpPr>
                <a:spLocks noChangeShapeType="1"/>
              </p:cNvSpPr>
              <p:nvPr/>
            </p:nvSpPr>
            <p:spPr bwMode="auto">
              <a:xfrm>
                <a:off x="3735397" y="6405947"/>
                <a:ext cx="19111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Line 43"/>
              <p:cNvSpPr>
                <a:spLocks noChangeShapeType="1"/>
              </p:cNvSpPr>
              <p:nvPr/>
            </p:nvSpPr>
            <p:spPr bwMode="auto">
              <a:xfrm>
                <a:off x="3735397" y="6409745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Line 44"/>
              <p:cNvSpPr>
                <a:spLocks noChangeShapeType="1"/>
              </p:cNvSpPr>
              <p:nvPr/>
            </p:nvSpPr>
            <p:spPr bwMode="auto">
              <a:xfrm>
                <a:off x="4118747" y="6409745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Line 45"/>
              <p:cNvSpPr>
                <a:spLocks noChangeShapeType="1"/>
              </p:cNvSpPr>
              <p:nvPr/>
            </p:nvSpPr>
            <p:spPr bwMode="auto">
              <a:xfrm>
                <a:off x="4502095" y="6409745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Line 46"/>
              <p:cNvSpPr>
                <a:spLocks noChangeShapeType="1"/>
              </p:cNvSpPr>
              <p:nvPr/>
            </p:nvSpPr>
            <p:spPr bwMode="auto">
              <a:xfrm>
                <a:off x="4879808" y="6409745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Line 47"/>
              <p:cNvSpPr>
                <a:spLocks noChangeShapeType="1"/>
              </p:cNvSpPr>
              <p:nvPr/>
            </p:nvSpPr>
            <p:spPr bwMode="auto">
              <a:xfrm>
                <a:off x="5263158" y="6409745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Line 48"/>
              <p:cNvSpPr>
                <a:spLocks noChangeShapeType="1"/>
              </p:cNvSpPr>
              <p:nvPr/>
            </p:nvSpPr>
            <p:spPr bwMode="auto">
              <a:xfrm>
                <a:off x="5646507" y="6409745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49"/>
              <p:cNvSpPr>
                <a:spLocks noChangeArrowheads="1"/>
              </p:cNvSpPr>
              <p:nvPr/>
            </p:nvSpPr>
            <p:spPr bwMode="auto">
              <a:xfrm>
                <a:off x="3679811" y="6493519"/>
                <a:ext cx="75466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" name="Rectangle 50"/>
              <p:cNvSpPr>
                <a:spLocks noChangeArrowheads="1"/>
              </p:cNvSpPr>
              <p:nvPr/>
            </p:nvSpPr>
            <p:spPr bwMode="auto">
              <a:xfrm>
                <a:off x="4027779" y="6493519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" name="Rectangle 51"/>
              <p:cNvSpPr>
                <a:spLocks noChangeArrowheads="1"/>
              </p:cNvSpPr>
              <p:nvPr/>
            </p:nvSpPr>
            <p:spPr bwMode="auto">
              <a:xfrm>
                <a:off x="4411128" y="6493519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" name="Rectangle 52"/>
              <p:cNvSpPr>
                <a:spLocks noChangeArrowheads="1"/>
              </p:cNvSpPr>
              <p:nvPr/>
            </p:nvSpPr>
            <p:spPr bwMode="auto">
              <a:xfrm>
                <a:off x="4788839" y="6493519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" name="Rectangle 53"/>
              <p:cNvSpPr>
                <a:spLocks noChangeArrowheads="1"/>
              </p:cNvSpPr>
              <p:nvPr/>
            </p:nvSpPr>
            <p:spPr bwMode="auto">
              <a:xfrm>
                <a:off x="5172190" y="6493519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" name="Rectangle 54"/>
              <p:cNvSpPr>
                <a:spLocks noChangeArrowheads="1"/>
              </p:cNvSpPr>
              <p:nvPr/>
            </p:nvSpPr>
            <p:spPr bwMode="auto">
              <a:xfrm>
                <a:off x="5555538" y="6493519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8" name="Line 55"/>
              <p:cNvSpPr>
                <a:spLocks noChangeShapeType="1"/>
              </p:cNvSpPr>
              <p:nvPr/>
            </p:nvSpPr>
            <p:spPr bwMode="auto">
              <a:xfrm flipV="1">
                <a:off x="3735397" y="5073396"/>
                <a:ext cx="0" cy="128399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Line 56"/>
              <p:cNvSpPr>
                <a:spLocks noChangeShapeType="1"/>
              </p:cNvSpPr>
              <p:nvPr/>
            </p:nvSpPr>
            <p:spPr bwMode="auto">
              <a:xfrm flipH="1">
                <a:off x="3695934" y="6357389"/>
                <a:ext cx="394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Line 57"/>
              <p:cNvSpPr>
                <a:spLocks noChangeShapeType="1"/>
              </p:cNvSpPr>
              <p:nvPr/>
            </p:nvSpPr>
            <p:spPr bwMode="auto">
              <a:xfrm flipH="1">
                <a:off x="3695934" y="6100591"/>
                <a:ext cx="394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Line 58"/>
              <p:cNvSpPr>
                <a:spLocks noChangeShapeType="1"/>
              </p:cNvSpPr>
              <p:nvPr/>
            </p:nvSpPr>
            <p:spPr bwMode="auto">
              <a:xfrm flipH="1">
                <a:off x="3695934" y="5843792"/>
                <a:ext cx="394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Line 59"/>
              <p:cNvSpPr>
                <a:spLocks noChangeShapeType="1"/>
              </p:cNvSpPr>
              <p:nvPr/>
            </p:nvSpPr>
            <p:spPr bwMode="auto">
              <a:xfrm flipH="1">
                <a:off x="3695934" y="5586994"/>
                <a:ext cx="394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Line 60"/>
              <p:cNvSpPr>
                <a:spLocks noChangeShapeType="1"/>
              </p:cNvSpPr>
              <p:nvPr/>
            </p:nvSpPr>
            <p:spPr bwMode="auto">
              <a:xfrm flipH="1">
                <a:off x="3695934" y="5330195"/>
                <a:ext cx="394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Line 61"/>
              <p:cNvSpPr>
                <a:spLocks noChangeShapeType="1"/>
              </p:cNvSpPr>
              <p:nvPr/>
            </p:nvSpPr>
            <p:spPr bwMode="auto">
              <a:xfrm flipH="1">
                <a:off x="3695934" y="5073396"/>
                <a:ext cx="394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62"/>
              <p:cNvSpPr>
                <a:spLocks noChangeArrowheads="1"/>
              </p:cNvSpPr>
              <p:nvPr/>
            </p:nvSpPr>
            <p:spPr bwMode="auto">
              <a:xfrm>
                <a:off x="3497439" y="6299917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6" name="Rectangle 63"/>
              <p:cNvSpPr>
                <a:spLocks noChangeArrowheads="1"/>
              </p:cNvSpPr>
              <p:nvPr/>
            </p:nvSpPr>
            <p:spPr bwMode="auto">
              <a:xfrm>
                <a:off x="3497439" y="6043118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" name="Rectangle 64"/>
              <p:cNvSpPr>
                <a:spLocks noChangeArrowheads="1"/>
              </p:cNvSpPr>
              <p:nvPr/>
            </p:nvSpPr>
            <p:spPr bwMode="auto">
              <a:xfrm>
                <a:off x="3497439" y="5786319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" name="Rectangle 65"/>
              <p:cNvSpPr>
                <a:spLocks noChangeArrowheads="1"/>
              </p:cNvSpPr>
              <p:nvPr/>
            </p:nvSpPr>
            <p:spPr bwMode="auto">
              <a:xfrm>
                <a:off x="3497439" y="5529521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" name="Rectangle 66"/>
              <p:cNvSpPr>
                <a:spLocks noChangeArrowheads="1"/>
              </p:cNvSpPr>
              <p:nvPr/>
            </p:nvSpPr>
            <p:spPr bwMode="auto">
              <a:xfrm>
                <a:off x="3497439" y="5272722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" name="Rectangle 67"/>
              <p:cNvSpPr>
                <a:spLocks noChangeArrowheads="1"/>
              </p:cNvSpPr>
              <p:nvPr/>
            </p:nvSpPr>
            <p:spPr bwMode="auto">
              <a:xfrm>
                <a:off x="3497439" y="5015924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" name="Rectangle 69"/>
              <p:cNvSpPr>
                <a:spLocks noChangeArrowheads="1"/>
              </p:cNvSpPr>
              <p:nvPr/>
            </p:nvSpPr>
            <p:spPr bwMode="auto">
              <a:xfrm>
                <a:off x="3771235" y="4804743"/>
                <a:ext cx="1772728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Bailey, non-</a:t>
                </a:r>
                <a:r>
                  <a:rPr kumimoji="0" lang="fr-FR" altLang="fr-FR" sz="1200" i="0" u="sng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earning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(N=79)</a:t>
                </a:r>
                <a:endParaRPr kumimoji="0" lang="fr-FR" altLang="fr-FR" sz="10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3" name="Rectangle 71"/>
              <p:cNvSpPr>
                <a:spLocks noChangeArrowheads="1"/>
              </p:cNvSpPr>
              <p:nvPr/>
            </p:nvSpPr>
            <p:spPr bwMode="auto">
              <a:xfrm>
                <a:off x="3963890" y="6613475"/>
                <a:ext cx="1509303" cy="139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nths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after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diagnosis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" name="Freeform 73"/>
              <p:cNvSpPr>
                <a:spLocks/>
              </p:cNvSpPr>
              <p:nvPr/>
            </p:nvSpPr>
            <p:spPr bwMode="auto">
              <a:xfrm>
                <a:off x="3735397" y="5073396"/>
                <a:ext cx="1928022" cy="1283993"/>
              </a:xfrm>
              <a:custGeom>
                <a:avLst/>
                <a:gdLst>
                  <a:gd name="T0" fmla="*/ 0 w 342"/>
                  <a:gd name="T1" fmla="*/ 0 h 515"/>
                  <a:gd name="T2" fmla="*/ 45 w 342"/>
                  <a:gd name="T3" fmla="*/ 0 h 515"/>
                  <a:gd name="T4" fmla="*/ 45 w 342"/>
                  <a:gd name="T5" fmla="*/ 11 h 515"/>
                  <a:gd name="T6" fmla="*/ 49 w 342"/>
                  <a:gd name="T7" fmla="*/ 11 h 515"/>
                  <a:gd name="T8" fmla="*/ 49 w 342"/>
                  <a:gd name="T9" fmla="*/ 22 h 515"/>
                  <a:gd name="T10" fmla="*/ 58 w 342"/>
                  <a:gd name="T11" fmla="*/ 22 h 515"/>
                  <a:gd name="T12" fmla="*/ 58 w 342"/>
                  <a:gd name="T13" fmla="*/ 34 h 515"/>
                  <a:gd name="T14" fmla="*/ 66 w 342"/>
                  <a:gd name="T15" fmla="*/ 34 h 515"/>
                  <a:gd name="T16" fmla="*/ 66 w 342"/>
                  <a:gd name="T17" fmla="*/ 45 h 515"/>
                  <a:gd name="T18" fmla="*/ 70 w 342"/>
                  <a:gd name="T19" fmla="*/ 45 h 515"/>
                  <a:gd name="T20" fmla="*/ 70 w 342"/>
                  <a:gd name="T21" fmla="*/ 56 h 515"/>
                  <a:gd name="T22" fmla="*/ 81 w 342"/>
                  <a:gd name="T23" fmla="*/ 56 h 515"/>
                  <a:gd name="T24" fmla="*/ 81 w 342"/>
                  <a:gd name="T25" fmla="*/ 68 h 515"/>
                  <a:gd name="T26" fmla="*/ 89 w 342"/>
                  <a:gd name="T27" fmla="*/ 68 h 515"/>
                  <a:gd name="T28" fmla="*/ 89 w 342"/>
                  <a:gd name="T29" fmla="*/ 81 h 515"/>
                  <a:gd name="T30" fmla="*/ 90 w 342"/>
                  <a:gd name="T31" fmla="*/ 81 h 515"/>
                  <a:gd name="T32" fmla="*/ 90 w 342"/>
                  <a:gd name="T33" fmla="*/ 93 h 515"/>
                  <a:gd name="T34" fmla="*/ 93 w 342"/>
                  <a:gd name="T35" fmla="*/ 93 h 515"/>
                  <a:gd name="T36" fmla="*/ 93 w 342"/>
                  <a:gd name="T37" fmla="*/ 105 h 515"/>
                  <a:gd name="T38" fmla="*/ 95 w 342"/>
                  <a:gd name="T39" fmla="*/ 105 h 515"/>
                  <a:gd name="T40" fmla="*/ 95 w 342"/>
                  <a:gd name="T41" fmla="*/ 131 h 515"/>
                  <a:gd name="T42" fmla="*/ 97 w 342"/>
                  <a:gd name="T43" fmla="*/ 131 h 515"/>
                  <a:gd name="T44" fmla="*/ 97 w 342"/>
                  <a:gd name="T45" fmla="*/ 144 h 515"/>
                  <a:gd name="T46" fmla="*/ 102 w 342"/>
                  <a:gd name="T47" fmla="*/ 144 h 515"/>
                  <a:gd name="T48" fmla="*/ 102 w 342"/>
                  <a:gd name="T49" fmla="*/ 157 h 515"/>
                  <a:gd name="T50" fmla="*/ 107 w 342"/>
                  <a:gd name="T51" fmla="*/ 157 h 515"/>
                  <a:gd name="T52" fmla="*/ 107 w 342"/>
                  <a:gd name="T53" fmla="*/ 170 h 515"/>
                  <a:gd name="T54" fmla="*/ 108 w 342"/>
                  <a:gd name="T55" fmla="*/ 170 h 515"/>
                  <a:gd name="T56" fmla="*/ 108 w 342"/>
                  <a:gd name="T57" fmla="*/ 183 h 515"/>
                  <a:gd name="T58" fmla="*/ 137 w 342"/>
                  <a:gd name="T59" fmla="*/ 183 h 515"/>
                  <a:gd name="T60" fmla="*/ 137 w 342"/>
                  <a:gd name="T61" fmla="*/ 197 h 515"/>
                  <a:gd name="T62" fmla="*/ 138 w 342"/>
                  <a:gd name="T63" fmla="*/ 197 h 515"/>
                  <a:gd name="T64" fmla="*/ 138 w 342"/>
                  <a:gd name="T65" fmla="*/ 211 h 515"/>
                  <a:gd name="T66" fmla="*/ 140 w 342"/>
                  <a:gd name="T67" fmla="*/ 211 h 515"/>
                  <a:gd name="T68" fmla="*/ 140 w 342"/>
                  <a:gd name="T69" fmla="*/ 225 h 515"/>
                  <a:gd name="T70" fmla="*/ 158 w 342"/>
                  <a:gd name="T71" fmla="*/ 225 h 515"/>
                  <a:gd name="T72" fmla="*/ 158 w 342"/>
                  <a:gd name="T73" fmla="*/ 241 h 515"/>
                  <a:gd name="T74" fmla="*/ 174 w 342"/>
                  <a:gd name="T75" fmla="*/ 241 h 515"/>
                  <a:gd name="T76" fmla="*/ 174 w 342"/>
                  <a:gd name="T77" fmla="*/ 258 h 515"/>
                  <a:gd name="T78" fmla="*/ 180 w 342"/>
                  <a:gd name="T79" fmla="*/ 258 h 515"/>
                  <a:gd name="T80" fmla="*/ 180 w 342"/>
                  <a:gd name="T81" fmla="*/ 275 h 515"/>
                  <a:gd name="T82" fmla="*/ 203 w 342"/>
                  <a:gd name="T83" fmla="*/ 275 h 515"/>
                  <a:gd name="T84" fmla="*/ 203 w 342"/>
                  <a:gd name="T85" fmla="*/ 299 h 515"/>
                  <a:gd name="T86" fmla="*/ 226 w 342"/>
                  <a:gd name="T87" fmla="*/ 299 h 515"/>
                  <a:gd name="T88" fmla="*/ 226 w 342"/>
                  <a:gd name="T89" fmla="*/ 330 h 515"/>
                  <a:gd name="T90" fmla="*/ 233 w 342"/>
                  <a:gd name="T91" fmla="*/ 330 h 515"/>
                  <a:gd name="T92" fmla="*/ 233 w 342"/>
                  <a:gd name="T93" fmla="*/ 367 h 515"/>
                  <a:gd name="T94" fmla="*/ 243 w 342"/>
                  <a:gd name="T95" fmla="*/ 367 h 515"/>
                  <a:gd name="T96" fmla="*/ 243 w 342"/>
                  <a:gd name="T97" fmla="*/ 441 h 515"/>
                  <a:gd name="T98" fmla="*/ 342 w 342"/>
                  <a:gd name="T99" fmla="*/ 441 h 515"/>
                  <a:gd name="T100" fmla="*/ 342 w 342"/>
                  <a:gd name="T101" fmla="*/ 515 h 5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</a:cxnLst>
                <a:rect l="0" t="0" r="r" b="b"/>
                <a:pathLst>
                  <a:path w="342" h="515">
                    <a:moveTo>
                      <a:pt x="0" y="0"/>
                    </a:moveTo>
                    <a:lnTo>
                      <a:pt x="45" y="0"/>
                    </a:lnTo>
                    <a:lnTo>
                      <a:pt x="45" y="11"/>
                    </a:lnTo>
                    <a:lnTo>
                      <a:pt x="49" y="11"/>
                    </a:lnTo>
                    <a:lnTo>
                      <a:pt x="49" y="22"/>
                    </a:lnTo>
                    <a:lnTo>
                      <a:pt x="58" y="22"/>
                    </a:lnTo>
                    <a:lnTo>
                      <a:pt x="58" y="34"/>
                    </a:lnTo>
                    <a:lnTo>
                      <a:pt x="66" y="34"/>
                    </a:lnTo>
                    <a:lnTo>
                      <a:pt x="66" y="45"/>
                    </a:lnTo>
                    <a:lnTo>
                      <a:pt x="70" y="45"/>
                    </a:lnTo>
                    <a:lnTo>
                      <a:pt x="70" y="56"/>
                    </a:lnTo>
                    <a:lnTo>
                      <a:pt x="81" y="56"/>
                    </a:lnTo>
                    <a:lnTo>
                      <a:pt x="81" y="68"/>
                    </a:lnTo>
                    <a:lnTo>
                      <a:pt x="89" y="68"/>
                    </a:lnTo>
                    <a:lnTo>
                      <a:pt x="89" y="81"/>
                    </a:lnTo>
                    <a:lnTo>
                      <a:pt x="90" y="81"/>
                    </a:lnTo>
                    <a:lnTo>
                      <a:pt x="90" y="93"/>
                    </a:lnTo>
                    <a:lnTo>
                      <a:pt x="93" y="93"/>
                    </a:lnTo>
                    <a:lnTo>
                      <a:pt x="93" y="105"/>
                    </a:lnTo>
                    <a:lnTo>
                      <a:pt x="95" y="105"/>
                    </a:lnTo>
                    <a:lnTo>
                      <a:pt x="95" y="131"/>
                    </a:lnTo>
                    <a:lnTo>
                      <a:pt x="97" y="131"/>
                    </a:lnTo>
                    <a:lnTo>
                      <a:pt x="97" y="144"/>
                    </a:lnTo>
                    <a:lnTo>
                      <a:pt x="102" y="144"/>
                    </a:lnTo>
                    <a:lnTo>
                      <a:pt x="102" y="157"/>
                    </a:lnTo>
                    <a:lnTo>
                      <a:pt x="107" y="157"/>
                    </a:lnTo>
                    <a:lnTo>
                      <a:pt x="107" y="170"/>
                    </a:lnTo>
                    <a:lnTo>
                      <a:pt x="108" y="170"/>
                    </a:lnTo>
                    <a:lnTo>
                      <a:pt x="108" y="183"/>
                    </a:lnTo>
                    <a:lnTo>
                      <a:pt x="137" y="183"/>
                    </a:lnTo>
                    <a:lnTo>
                      <a:pt x="137" y="197"/>
                    </a:lnTo>
                    <a:lnTo>
                      <a:pt x="138" y="197"/>
                    </a:lnTo>
                    <a:lnTo>
                      <a:pt x="138" y="211"/>
                    </a:lnTo>
                    <a:lnTo>
                      <a:pt x="140" y="211"/>
                    </a:lnTo>
                    <a:lnTo>
                      <a:pt x="140" y="225"/>
                    </a:lnTo>
                    <a:lnTo>
                      <a:pt x="158" y="225"/>
                    </a:lnTo>
                    <a:lnTo>
                      <a:pt x="158" y="241"/>
                    </a:lnTo>
                    <a:lnTo>
                      <a:pt x="174" y="241"/>
                    </a:lnTo>
                    <a:lnTo>
                      <a:pt x="174" y="258"/>
                    </a:lnTo>
                    <a:lnTo>
                      <a:pt x="180" y="258"/>
                    </a:lnTo>
                    <a:lnTo>
                      <a:pt x="180" y="275"/>
                    </a:lnTo>
                    <a:lnTo>
                      <a:pt x="203" y="275"/>
                    </a:lnTo>
                    <a:lnTo>
                      <a:pt x="203" y="299"/>
                    </a:lnTo>
                    <a:lnTo>
                      <a:pt x="226" y="299"/>
                    </a:lnTo>
                    <a:lnTo>
                      <a:pt x="226" y="330"/>
                    </a:lnTo>
                    <a:lnTo>
                      <a:pt x="233" y="330"/>
                    </a:lnTo>
                    <a:lnTo>
                      <a:pt x="233" y="367"/>
                    </a:lnTo>
                    <a:lnTo>
                      <a:pt x="243" y="367"/>
                    </a:lnTo>
                    <a:lnTo>
                      <a:pt x="243" y="441"/>
                    </a:lnTo>
                    <a:lnTo>
                      <a:pt x="342" y="441"/>
                    </a:lnTo>
                    <a:lnTo>
                      <a:pt x="342" y="515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Freeform 74"/>
              <p:cNvSpPr>
                <a:spLocks/>
              </p:cNvSpPr>
              <p:nvPr/>
            </p:nvSpPr>
            <p:spPr bwMode="auto">
              <a:xfrm>
                <a:off x="3735397" y="5073396"/>
                <a:ext cx="1606685" cy="1283993"/>
              </a:xfrm>
              <a:custGeom>
                <a:avLst/>
                <a:gdLst>
                  <a:gd name="T0" fmla="*/ 0 w 285"/>
                  <a:gd name="T1" fmla="*/ 0 h 515"/>
                  <a:gd name="T2" fmla="*/ 44 w 285"/>
                  <a:gd name="T3" fmla="*/ 0 h 515"/>
                  <a:gd name="T4" fmla="*/ 44 w 285"/>
                  <a:gd name="T5" fmla="*/ 18 h 515"/>
                  <a:gd name="T6" fmla="*/ 46 w 285"/>
                  <a:gd name="T7" fmla="*/ 18 h 515"/>
                  <a:gd name="T8" fmla="*/ 46 w 285"/>
                  <a:gd name="T9" fmla="*/ 37 h 515"/>
                  <a:gd name="T10" fmla="*/ 49 w 285"/>
                  <a:gd name="T11" fmla="*/ 37 h 515"/>
                  <a:gd name="T12" fmla="*/ 49 w 285"/>
                  <a:gd name="T13" fmla="*/ 55 h 515"/>
                  <a:gd name="T14" fmla="*/ 53 w 285"/>
                  <a:gd name="T15" fmla="*/ 55 h 515"/>
                  <a:gd name="T16" fmla="*/ 53 w 285"/>
                  <a:gd name="T17" fmla="*/ 74 h 515"/>
                  <a:gd name="T18" fmla="*/ 57 w 285"/>
                  <a:gd name="T19" fmla="*/ 74 h 515"/>
                  <a:gd name="T20" fmla="*/ 57 w 285"/>
                  <a:gd name="T21" fmla="*/ 92 h 515"/>
                  <a:gd name="T22" fmla="*/ 59 w 285"/>
                  <a:gd name="T23" fmla="*/ 92 h 515"/>
                  <a:gd name="T24" fmla="*/ 59 w 285"/>
                  <a:gd name="T25" fmla="*/ 110 h 515"/>
                  <a:gd name="T26" fmla="*/ 61 w 285"/>
                  <a:gd name="T27" fmla="*/ 110 h 515"/>
                  <a:gd name="T28" fmla="*/ 61 w 285"/>
                  <a:gd name="T29" fmla="*/ 129 h 515"/>
                  <a:gd name="T30" fmla="*/ 64 w 285"/>
                  <a:gd name="T31" fmla="*/ 129 h 515"/>
                  <a:gd name="T32" fmla="*/ 64 w 285"/>
                  <a:gd name="T33" fmla="*/ 147 h 515"/>
                  <a:gd name="T34" fmla="*/ 64 w 285"/>
                  <a:gd name="T35" fmla="*/ 147 h 515"/>
                  <a:gd name="T36" fmla="*/ 64 w 285"/>
                  <a:gd name="T37" fmla="*/ 167 h 515"/>
                  <a:gd name="T38" fmla="*/ 74 w 285"/>
                  <a:gd name="T39" fmla="*/ 167 h 515"/>
                  <a:gd name="T40" fmla="*/ 74 w 285"/>
                  <a:gd name="T41" fmla="*/ 186 h 515"/>
                  <a:gd name="T42" fmla="*/ 79 w 285"/>
                  <a:gd name="T43" fmla="*/ 186 h 515"/>
                  <a:gd name="T44" fmla="*/ 79 w 285"/>
                  <a:gd name="T45" fmla="*/ 205 h 515"/>
                  <a:gd name="T46" fmla="*/ 87 w 285"/>
                  <a:gd name="T47" fmla="*/ 205 h 515"/>
                  <a:gd name="T48" fmla="*/ 87 w 285"/>
                  <a:gd name="T49" fmla="*/ 225 h 515"/>
                  <a:gd name="T50" fmla="*/ 93 w 285"/>
                  <a:gd name="T51" fmla="*/ 225 h 515"/>
                  <a:gd name="T52" fmla="*/ 93 w 285"/>
                  <a:gd name="T53" fmla="*/ 244 h 515"/>
                  <a:gd name="T54" fmla="*/ 112 w 285"/>
                  <a:gd name="T55" fmla="*/ 244 h 515"/>
                  <a:gd name="T56" fmla="*/ 112 w 285"/>
                  <a:gd name="T57" fmla="*/ 265 h 515"/>
                  <a:gd name="T58" fmla="*/ 112 w 285"/>
                  <a:gd name="T59" fmla="*/ 265 h 515"/>
                  <a:gd name="T60" fmla="*/ 112 w 285"/>
                  <a:gd name="T61" fmla="*/ 286 h 515"/>
                  <a:gd name="T62" fmla="*/ 119 w 285"/>
                  <a:gd name="T63" fmla="*/ 286 h 515"/>
                  <a:gd name="T64" fmla="*/ 119 w 285"/>
                  <a:gd name="T65" fmla="*/ 309 h 515"/>
                  <a:gd name="T66" fmla="*/ 120 w 285"/>
                  <a:gd name="T67" fmla="*/ 309 h 515"/>
                  <a:gd name="T68" fmla="*/ 120 w 285"/>
                  <a:gd name="T69" fmla="*/ 332 h 515"/>
                  <a:gd name="T70" fmla="*/ 134 w 285"/>
                  <a:gd name="T71" fmla="*/ 332 h 515"/>
                  <a:gd name="T72" fmla="*/ 134 w 285"/>
                  <a:gd name="T73" fmla="*/ 355 h 515"/>
                  <a:gd name="T74" fmla="*/ 161 w 285"/>
                  <a:gd name="T75" fmla="*/ 355 h 515"/>
                  <a:gd name="T76" fmla="*/ 161 w 285"/>
                  <a:gd name="T77" fmla="*/ 378 h 515"/>
                  <a:gd name="T78" fmla="*/ 161 w 285"/>
                  <a:gd name="T79" fmla="*/ 378 h 515"/>
                  <a:gd name="T80" fmla="*/ 161 w 285"/>
                  <a:gd name="T81" fmla="*/ 401 h 515"/>
                  <a:gd name="T82" fmla="*/ 216 w 285"/>
                  <a:gd name="T83" fmla="*/ 401 h 515"/>
                  <a:gd name="T84" fmla="*/ 216 w 285"/>
                  <a:gd name="T85" fmla="*/ 439 h 515"/>
                  <a:gd name="T86" fmla="*/ 243 w 285"/>
                  <a:gd name="T87" fmla="*/ 439 h 515"/>
                  <a:gd name="T88" fmla="*/ 243 w 285"/>
                  <a:gd name="T89" fmla="*/ 477 h 515"/>
                  <a:gd name="T90" fmla="*/ 285 w 285"/>
                  <a:gd name="T91" fmla="*/ 477 h 515"/>
                  <a:gd name="T92" fmla="*/ 285 w 285"/>
                  <a:gd name="T93" fmla="*/ 515 h 5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285" h="515">
                    <a:moveTo>
                      <a:pt x="0" y="0"/>
                    </a:moveTo>
                    <a:lnTo>
                      <a:pt x="44" y="0"/>
                    </a:lnTo>
                    <a:lnTo>
                      <a:pt x="44" y="18"/>
                    </a:lnTo>
                    <a:lnTo>
                      <a:pt x="46" y="18"/>
                    </a:lnTo>
                    <a:lnTo>
                      <a:pt x="46" y="37"/>
                    </a:lnTo>
                    <a:lnTo>
                      <a:pt x="49" y="37"/>
                    </a:lnTo>
                    <a:lnTo>
                      <a:pt x="49" y="55"/>
                    </a:lnTo>
                    <a:lnTo>
                      <a:pt x="53" y="55"/>
                    </a:lnTo>
                    <a:lnTo>
                      <a:pt x="53" y="74"/>
                    </a:lnTo>
                    <a:lnTo>
                      <a:pt x="57" y="74"/>
                    </a:lnTo>
                    <a:lnTo>
                      <a:pt x="57" y="92"/>
                    </a:lnTo>
                    <a:lnTo>
                      <a:pt x="59" y="92"/>
                    </a:lnTo>
                    <a:lnTo>
                      <a:pt x="59" y="110"/>
                    </a:lnTo>
                    <a:lnTo>
                      <a:pt x="61" y="110"/>
                    </a:lnTo>
                    <a:lnTo>
                      <a:pt x="61" y="129"/>
                    </a:lnTo>
                    <a:lnTo>
                      <a:pt x="64" y="129"/>
                    </a:lnTo>
                    <a:lnTo>
                      <a:pt x="64" y="147"/>
                    </a:lnTo>
                    <a:lnTo>
                      <a:pt x="64" y="147"/>
                    </a:lnTo>
                    <a:lnTo>
                      <a:pt x="64" y="167"/>
                    </a:lnTo>
                    <a:lnTo>
                      <a:pt x="74" y="167"/>
                    </a:lnTo>
                    <a:lnTo>
                      <a:pt x="74" y="186"/>
                    </a:lnTo>
                    <a:lnTo>
                      <a:pt x="79" y="186"/>
                    </a:lnTo>
                    <a:lnTo>
                      <a:pt x="79" y="205"/>
                    </a:lnTo>
                    <a:lnTo>
                      <a:pt x="87" y="205"/>
                    </a:lnTo>
                    <a:lnTo>
                      <a:pt x="87" y="225"/>
                    </a:lnTo>
                    <a:lnTo>
                      <a:pt x="93" y="225"/>
                    </a:lnTo>
                    <a:lnTo>
                      <a:pt x="93" y="244"/>
                    </a:lnTo>
                    <a:lnTo>
                      <a:pt x="112" y="244"/>
                    </a:lnTo>
                    <a:lnTo>
                      <a:pt x="112" y="265"/>
                    </a:lnTo>
                    <a:lnTo>
                      <a:pt x="112" y="265"/>
                    </a:lnTo>
                    <a:lnTo>
                      <a:pt x="112" y="286"/>
                    </a:lnTo>
                    <a:lnTo>
                      <a:pt x="119" y="286"/>
                    </a:lnTo>
                    <a:lnTo>
                      <a:pt x="119" y="309"/>
                    </a:lnTo>
                    <a:lnTo>
                      <a:pt x="120" y="309"/>
                    </a:lnTo>
                    <a:lnTo>
                      <a:pt x="120" y="332"/>
                    </a:lnTo>
                    <a:lnTo>
                      <a:pt x="134" y="332"/>
                    </a:lnTo>
                    <a:lnTo>
                      <a:pt x="134" y="355"/>
                    </a:lnTo>
                    <a:lnTo>
                      <a:pt x="161" y="355"/>
                    </a:lnTo>
                    <a:lnTo>
                      <a:pt x="161" y="378"/>
                    </a:lnTo>
                    <a:lnTo>
                      <a:pt x="161" y="378"/>
                    </a:lnTo>
                    <a:lnTo>
                      <a:pt x="161" y="401"/>
                    </a:lnTo>
                    <a:lnTo>
                      <a:pt x="216" y="401"/>
                    </a:lnTo>
                    <a:lnTo>
                      <a:pt x="216" y="439"/>
                    </a:lnTo>
                    <a:lnTo>
                      <a:pt x="243" y="439"/>
                    </a:lnTo>
                    <a:lnTo>
                      <a:pt x="243" y="477"/>
                    </a:lnTo>
                    <a:lnTo>
                      <a:pt x="285" y="477"/>
                    </a:lnTo>
                    <a:lnTo>
                      <a:pt x="285" y="515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75"/>
              <p:cNvSpPr>
                <a:spLocks noChangeArrowheads="1"/>
              </p:cNvSpPr>
              <p:nvPr/>
            </p:nvSpPr>
            <p:spPr bwMode="auto">
              <a:xfrm>
                <a:off x="3809450" y="6203681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152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8" name="Rectangle 76"/>
              <p:cNvSpPr>
                <a:spLocks noChangeArrowheads="1"/>
              </p:cNvSpPr>
              <p:nvPr/>
            </p:nvSpPr>
            <p:spPr bwMode="auto">
              <a:xfrm>
                <a:off x="4693588" y="5535647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3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9" name="Rectangle 77"/>
              <p:cNvSpPr>
                <a:spLocks noChangeArrowheads="1"/>
              </p:cNvSpPr>
              <p:nvPr/>
            </p:nvSpPr>
            <p:spPr bwMode="auto">
              <a:xfrm>
                <a:off x="4693588" y="5918547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22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0" name="Line 78"/>
              <p:cNvSpPr>
                <a:spLocks noChangeShapeType="1"/>
              </p:cNvSpPr>
              <p:nvPr/>
            </p:nvSpPr>
            <p:spPr bwMode="auto">
              <a:xfrm>
                <a:off x="6461619" y="6405948"/>
                <a:ext cx="196807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Line 79"/>
              <p:cNvSpPr>
                <a:spLocks noChangeShapeType="1"/>
              </p:cNvSpPr>
              <p:nvPr/>
            </p:nvSpPr>
            <p:spPr bwMode="auto">
              <a:xfrm>
                <a:off x="6461619" y="6403149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Line 80"/>
              <p:cNvSpPr>
                <a:spLocks noChangeShapeType="1"/>
              </p:cNvSpPr>
              <p:nvPr/>
            </p:nvSpPr>
            <p:spPr bwMode="auto">
              <a:xfrm>
                <a:off x="6852965" y="6403149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Line 81"/>
              <p:cNvSpPr>
                <a:spLocks noChangeShapeType="1"/>
              </p:cNvSpPr>
              <p:nvPr/>
            </p:nvSpPr>
            <p:spPr bwMode="auto">
              <a:xfrm>
                <a:off x="7249984" y="6403149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Line 82"/>
              <p:cNvSpPr>
                <a:spLocks noChangeShapeType="1"/>
              </p:cNvSpPr>
              <p:nvPr/>
            </p:nvSpPr>
            <p:spPr bwMode="auto">
              <a:xfrm>
                <a:off x="7641330" y="6403149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Line 83"/>
              <p:cNvSpPr>
                <a:spLocks noChangeShapeType="1"/>
              </p:cNvSpPr>
              <p:nvPr/>
            </p:nvSpPr>
            <p:spPr bwMode="auto">
              <a:xfrm>
                <a:off x="8032676" y="6403149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Line 84"/>
              <p:cNvSpPr>
                <a:spLocks noChangeShapeType="1"/>
              </p:cNvSpPr>
              <p:nvPr/>
            </p:nvSpPr>
            <p:spPr bwMode="auto">
              <a:xfrm>
                <a:off x="8429695" y="6403149"/>
                <a:ext cx="0" cy="524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85"/>
              <p:cNvSpPr>
                <a:spLocks noChangeArrowheads="1"/>
              </p:cNvSpPr>
              <p:nvPr/>
            </p:nvSpPr>
            <p:spPr bwMode="auto">
              <a:xfrm>
                <a:off x="6406113" y="6487021"/>
                <a:ext cx="75466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8" name="Rectangle 86"/>
              <p:cNvSpPr>
                <a:spLocks noChangeArrowheads="1"/>
              </p:cNvSpPr>
              <p:nvPr/>
            </p:nvSpPr>
            <p:spPr bwMode="auto">
              <a:xfrm>
                <a:off x="6761799" y="6487021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9" name="Rectangle 87"/>
              <p:cNvSpPr>
                <a:spLocks noChangeArrowheads="1"/>
              </p:cNvSpPr>
              <p:nvPr/>
            </p:nvSpPr>
            <p:spPr bwMode="auto">
              <a:xfrm>
                <a:off x="7158818" y="6487021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0" name="Rectangle 88"/>
              <p:cNvSpPr>
                <a:spLocks noChangeArrowheads="1"/>
              </p:cNvSpPr>
              <p:nvPr/>
            </p:nvSpPr>
            <p:spPr bwMode="auto">
              <a:xfrm>
                <a:off x="7550164" y="6487021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1" name="Rectangle 89"/>
              <p:cNvSpPr>
                <a:spLocks noChangeArrowheads="1"/>
              </p:cNvSpPr>
              <p:nvPr/>
            </p:nvSpPr>
            <p:spPr bwMode="auto">
              <a:xfrm>
                <a:off x="7941510" y="6487021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2" name="Rectangle 90"/>
              <p:cNvSpPr>
                <a:spLocks noChangeArrowheads="1"/>
              </p:cNvSpPr>
              <p:nvPr/>
            </p:nvSpPr>
            <p:spPr bwMode="auto">
              <a:xfrm>
                <a:off x="8338529" y="6487021"/>
                <a:ext cx="150931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3" name="Line 91"/>
              <p:cNvSpPr>
                <a:spLocks noChangeShapeType="1"/>
              </p:cNvSpPr>
              <p:nvPr/>
            </p:nvSpPr>
            <p:spPr bwMode="auto">
              <a:xfrm flipV="1">
                <a:off x="6461619" y="5063008"/>
                <a:ext cx="0" cy="128763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Line 92"/>
              <p:cNvSpPr>
                <a:spLocks noChangeShapeType="1"/>
              </p:cNvSpPr>
              <p:nvPr/>
            </p:nvSpPr>
            <p:spPr bwMode="auto">
              <a:xfrm flipH="1">
                <a:off x="6427589" y="6350644"/>
                <a:ext cx="3403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Line 93"/>
              <p:cNvSpPr>
                <a:spLocks noChangeShapeType="1"/>
              </p:cNvSpPr>
              <p:nvPr/>
            </p:nvSpPr>
            <p:spPr bwMode="auto">
              <a:xfrm flipH="1">
                <a:off x="6427589" y="6093117"/>
                <a:ext cx="3403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Line 94"/>
              <p:cNvSpPr>
                <a:spLocks noChangeShapeType="1"/>
              </p:cNvSpPr>
              <p:nvPr/>
            </p:nvSpPr>
            <p:spPr bwMode="auto">
              <a:xfrm flipH="1">
                <a:off x="6427589" y="5835589"/>
                <a:ext cx="3403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Line 95"/>
              <p:cNvSpPr>
                <a:spLocks noChangeShapeType="1"/>
              </p:cNvSpPr>
              <p:nvPr/>
            </p:nvSpPr>
            <p:spPr bwMode="auto">
              <a:xfrm flipH="1">
                <a:off x="6427589" y="5578062"/>
                <a:ext cx="3403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Line 96"/>
              <p:cNvSpPr>
                <a:spLocks noChangeShapeType="1"/>
              </p:cNvSpPr>
              <p:nvPr/>
            </p:nvSpPr>
            <p:spPr bwMode="auto">
              <a:xfrm flipH="1">
                <a:off x="6427589" y="5320535"/>
                <a:ext cx="3403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Line 97"/>
              <p:cNvSpPr>
                <a:spLocks noChangeShapeType="1"/>
              </p:cNvSpPr>
              <p:nvPr/>
            </p:nvSpPr>
            <p:spPr bwMode="auto">
              <a:xfrm flipH="1">
                <a:off x="6427589" y="5063008"/>
                <a:ext cx="3403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98"/>
              <p:cNvSpPr>
                <a:spLocks noChangeArrowheads="1"/>
              </p:cNvSpPr>
              <p:nvPr/>
            </p:nvSpPr>
            <p:spPr bwMode="auto">
              <a:xfrm>
                <a:off x="6222707" y="6293142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1" name="Rectangle 99"/>
              <p:cNvSpPr>
                <a:spLocks noChangeArrowheads="1"/>
              </p:cNvSpPr>
              <p:nvPr/>
            </p:nvSpPr>
            <p:spPr bwMode="auto">
              <a:xfrm>
                <a:off x="6222707" y="6035615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2" name="Rectangle 100"/>
              <p:cNvSpPr>
                <a:spLocks noChangeArrowheads="1"/>
              </p:cNvSpPr>
              <p:nvPr/>
            </p:nvSpPr>
            <p:spPr bwMode="auto">
              <a:xfrm>
                <a:off x="6222707" y="5778088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3" name="Rectangle 101"/>
              <p:cNvSpPr>
                <a:spLocks noChangeArrowheads="1"/>
              </p:cNvSpPr>
              <p:nvPr/>
            </p:nvSpPr>
            <p:spPr bwMode="auto">
              <a:xfrm>
                <a:off x="6222707" y="5520561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4" name="Rectangle 102"/>
              <p:cNvSpPr>
                <a:spLocks noChangeArrowheads="1"/>
              </p:cNvSpPr>
              <p:nvPr/>
            </p:nvSpPr>
            <p:spPr bwMode="auto">
              <a:xfrm>
                <a:off x="6222707" y="5263034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5" name="Rectangle 103"/>
              <p:cNvSpPr>
                <a:spLocks noChangeArrowheads="1"/>
              </p:cNvSpPr>
              <p:nvPr/>
            </p:nvSpPr>
            <p:spPr bwMode="auto">
              <a:xfrm>
                <a:off x="6222707" y="5005507"/>
                <a:ext cx="188664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6" name="Rectangle 105"/>
              <p:cNvSpPr>
                <a:spLocks noChangeArrowheads="1"/>
              </p:cNvSpPr>
              <p:nvPr/>
            </p:nvSpPr>
            <p:spPr bwMode="auto">
              <a:xfrm>
                <a:off x="6463911" y="4804743"/>
                <a:ext cx="1865895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TCGA, non-</a:t>
                </a:r>
                <a:r>
                  <a:rPr kumimoji="0" lang="fr-FR" altLang="fr-FR" sz="1200" i="0" u="sng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earning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(N=156)</a:t>
                </a:r>
                <a:endParaRPr kumimoji="0" lang="fr-FR" altLang="fr-FR" sz="10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8" name="Rectangle 107"/>
              <p:cNvSpPr>
                <a:spLocks noChangeArrowheads="1"/>
              </p:cNvSpPr>
              <p:nvPr/>
            </p:nvSpPr>
            <p:spPr bwMode="auto">
              <a:xfrm>
                <a:off x="6695973" y="6607155"/>
                <a:ext cx="1509303" cy="139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nths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after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diagnosis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0" name="Freeform 109"/>
              <p:cNvSpPr>
                <a:spLocks/>
              </p:cNvSpPr>
              <p:nvPr/>
            </p:nvSpPr>
            <p:spPr bwMode="auto">
              <a:xfrm>
                <a:off x="6461619" y="5063008"/>
                <a:ext cx="1939718" cy="1287636"/>
              </a:xfrm>
              <a:custGeom>
                <a:avLst/>
                <a:gdLst>
                  <a:gd name="T0" fmla="*/ 0 w 342"/>
                  <a:gd name="T1" fmla="*/ 0 h 515"/>
                  <a:gd name="T2" fmla="*/ 42 w 342"/>
                  <a:gd name="T3" fmla="*/ 0 h 515"/>
                  <a:gd name="T4" fmla="*/ 42 w 342"/>
                  <a:gd name="T5" fmla="*/ 8 h 515"/>
                  <a:gd name="T6" fmla="*/ 49 w 342"/>
                  <a:gd name="T7" fmla="*/ 8 h 515"/>
                  <a:gd name="T8" fmla="*/ 49 w 342"/>
                  <a:gd name="T9" fmla="*/ 17 h 515"/>
                  <a:gd name="T10" fmla="*/ 50 w 342"/>
                  <a:gd name="T11" fmla="*/ 17 h 515"/>
                  <a:gd name="T12" fmla="*/ 50 w 342"/>
                  <a:gd name="T13" fmla="*/ 26 h 515"/>
                  <a:gd name="T14" fmla="*/ 67 w 342"/>
                  <a:gd name="T15" fmla="*/ 26 h 515"/>
                  <a:gd name="T16" fmla="*/ 67 w 342"/>
                  <a:gd name="T17" fmla="*/ 36 h 515"/>
                  <a:gd name="T18" fmla="*/ 76 w 342"/>
                  <a:gd name="T19" fmla="*/ 36 h 515"/>
                  <a:gd name="T20" fmla="*/ 76 w 342"/>
                  <a:gd name="T21" fmla="*/ 46 h 515"/>
                  <a:gd name="T22" fmla="*/ 87 w 342"/>
                  <a:gd name="T23" fmla="*/ 46 h 515"/>
                  <a:gd name="T24" fmla="*/ 87 w 342"/>
                  <a:gd name="T25" fmla="*/ 58 h 515"/>
                  <a:gd name="T26" fmla="*/ 98 w 342"/>
                  <a:gd name="T27" fmla="*/ 58 h 515"/>
                  <a:gd name="T28" fmla="*/ 98 w 342"/>
                  <a:gd name="T29" fmla="*/ 71 h 515"/>
                  <a:gd name="T30" fmla="*/ 106 w 342"/>
                  <a:gd name="T31" fmla="*/ 71 h 515"/>
                  <a:gd name="T32" fmla="*/ 106 w 342"/>
                  <a:gd name="T33" fmla="*/ 83 h 515"/>
                  <a:gd name="T34" fmla="*/ 108 w 342"/>
                  <a:gd name="T35" fmla="*/ 83 h 515"/>
                  <a:gd name="T36" fmla="*/ 108 w 342"/>
                  <a:gd name="T37" fmla="*/ 96 h 515"/>
                  <a:gd name="T38" fmla="*/ 110 w 342"/>
                  <a:gd name="T39" fmla="*/ 96 h 515"/>
                  <a:gd name="T40" fmla="*/ 110 w 342"/>
                  <a:gd name="T41" fmla="*/ 109 h 515"/>
                  <a:gd name="T42" fmla="*/ 111 w 342"/>
                  <a:gd name="T43" fmla="*/ 109 h 515"/>
                  <a:gd name="T44" fmla="*/ 111 w 342"/>
                  <a:gd name="T45" fmla="*/ 123 h 515"/>
                  <a:gd name="T46" fmla="*/ 111 w 342"/>
                  <a:gd name="T47" fmla="*/ 123 h 515"/>
                  <a:gd name="T48" fmla="*/ 111 w 342"/>
                  <a:gd name="T49" fmla="*/ 136 h 515"/>
                  <a:gd name="T50" fmla="*/ 117 w 342"/>
                  <a:gd name="T51" fmla="*/ 136 h 515"/>
                  <a:gd name="T52" fmla="*/ 117 w 342"/>
                  <a:gd name="T53" fmla="*/ 150 h 515"/>
                  <a:gd name="T54" fmla="*/ 121 w 342"/>
                  <a:gd name="T55" fmla="*/ 150 h 515"/>
                  <a:gd name="T56" fmla="*/ 121 w 342"/>
                  <a:gd name="T57" fmla="*/ 164 h 515"/>
                  <a:gd name="T58" fmla="*/ 129 w 342"/>
                  <a:gd name="T59" fmla="*/ 164 h 515"/>
                  <a:gd name="T60" fmla="*/ 129 w 342"/>
                  <a:gd name="T61" fmla="*/ 178 h 515"/>
                  <a:gd name="T62" fmla="*/ 143 w 342"/>
                  <a:gd name="T63" fmla="*/ 178 h 515"/>
                  <a:gd name="T64" fmla="*/ 143 w 342"/>
                  <a:gd name="T65" fmla="*/ 193 h 515"/>
                  <a:gd name="T66" fmla="*/ 145 w 342"/>
                  <a:gd name="T67" fmla="*/ 193 h 515"/>
                  <a:gd name="T68" fmla="*/ 145 w 342"/>
                  <a:gd name="T69" fmla="*/ 208 h 515"/>
                  <a:gd name="T70" fmla="*/ 149 w 342"/>
                  <a:gd name="T71" fmla="*/ 208 h 515"/>
                  <a:gd name="T72" fmla="*/ 149 w 342"/>
                  <a:gd name="T73" fmla="*/ 222 h 515"/>
                  <a:gd name="T74" fmla="*/ 152 w 342"/>
                  <a:gd name="T75" fmla="*/ 222 h 515"/>
                  <a:gd name="T76" fmla="*/ 152 w 342"/>
                  <a:gd name="T77" fmla="*/ 238 h 515"/>
                  <a:gd name="T78" fmla="*/ 157 w 342"/>
                  <a:gd name="T79" fmla="*/ 238 h 515"/>
                  <a:gd name="T80" fmla="*/ 157 w 342"/>
                  <a:gd name="T81" fmla="*/ 253 h 515"/>
                  <a:gd name="T82" fmla="*/ 158 w 342"/>
                  <a:gd name="T83" fmla="*/ 253 h 515"/>
                  <a:gd name="T84" fmla="*/ 158 w 342"/>
                  <a:gd name="T85" fmla="*/ 269 h 515"/>
                  <a:gd name="T86" fmla="*/ 160 w 342"/>
                  <a:gd name="T87" fmla="*/ 269 h 515"/>
                  <a:gd name="T88" fmla="*/ 160 w 342"/>
                  <a:gd name="T89" fmla="*/ 284 h 515"/>
                  <a:gd name="T90" fmla="*/ 168 w 342"/>
                  <a:gd name="T91" fmla="*/ 284 h 515"/>
                  <a:gd name="T92" fmla="*/ 168 w 342"/>
                  <a:gd name="T93" fmla="*/ 303 h 515"/>
                  <a:gd name="T94" fmla="*/ 257 w 342"/>
                  <a:gd name="T95" fmla="*/ 303 h 515"/>
                  <a:gd name="T96" fmla="*/ 257 w 342"/>
                  <a:gd name="T97" fmla="*/ 374 h 515"/>
                  <a:gd name="T98" fmla="*/ 303 w 342"/>
                  <a:gd name="T99" fmla="*/ 374 h 515"/>
                  <a:gd name="T100" fmla="*/ 303 w 342"/>
                  <a:gd name="T101" fmla="*/ 445 h 515"/>
                  <a:gd name="T102" fmla="*/ 342 w 342"/>
                  <a:gd name="T103" fmla="*/ 445 h 515"/>
                  <a:gd name="T104" fmla="*/ 342 w 342"/>
                  <a:gd name="T105" fmla="*/ 515 h 5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</a:cxnLst>
                <a:rect l="0" t="0" r="r" b="b"/>
                <a:pathLst>
                  <a:path w="342" h="515">
                    <a:moveTo>
                      <a:pt x="0" y="0"/>
                    </a:moveTo>
                    <a:lnTo>
                      <a:pt x="42" y="0"/>
                    </a:lnTo>
                    <a:lnTo>
                      <a:pt x="42" y="8"/>
                    </a:lnTo>
                    <a:lnTo>
                      <a:pt x="49" y="8"/>
                    </a:lnTo>
                    <a:lnTo>
                      <a:pt x="49" y="17"/>
                    </a:lnTo>
                    <a:lnTo>
                      <a:pt x="50" y="17"/>
                    </a:lnTo>
                    <a:lnTo>
                      <a:pt x="50" y="26"/>
                    </a:lnTo>
                    <a:lnTo>
                      <a:pt x="67" y="26"/>
                    </a:lnTo>
                    <a:lnTo>
                      <a:pt x="67" y="36"/>
                    </a:lnTo>
                    <a:lnTo>
                      <a:pt x="76" y="36"/>
                    </a:lnTo>
                    <a:lnTo>
                      <a:pt x="76" y="46"/>
                    </a:lnTo>
                    <a:lnTo>
                      <a:pt x="87" y="46"/>
                    </a:lnTo>
                    <a:lnTo>
                      <a:pt x="87" y="58"/>
                    </a:lnTo>
                    <a:lnTo>
                      <a:pt x="98" y="58"/>
                    </a:lnTo>
                    <a:lnTo>
                      <a:pt x="98" y="71"/>
                    </a:lnTo>
                    <a:lnTo>
                      <a:pt x="106" y="71"/>
                    </a:lnTo>
                    <a:lnTo>
                      <a:pt x="106" y="83"/>
                    </a:lnTo>
                    <a:lnTo>
                      <a:pt x="108" y="83"/>
                    </a:lnTo>
                    <a:lnTo>
                      <a:pt x="108" y="96"/>
                    </a:lnTo>
                    <a:lnTo>
                      <a:pt x="110" y="96"/>
                    </a:lnTo>
                    <a:lnTo>
                      <a:pt x="110" y="109"/>
                    </a:lnTo>
                    <a:lnTo>
                      <a:pt x="111" y="109"/>
                    </a:lnTo>
                    <a:lnTo>
                      <a:pt x="111" y="123"/>
                    </a:lnTo>
                    <a:lnTo>
                      <a:pt x="111" y="123"/>
                    </a:lnTo>
                    <a:lnTo>
                      <a:pt x="111" y="136"/>
                    </a:lnTo>
                    <a:lnTo>
                      <a:pt x="117" y="136"/>
                    </a:lnTo>
                    <a:lnTo>
                      <a:pt x="117" y="150"/>
                    </a:lnTo>
                    <a:lnTo>
                      <a:pt x="121" y="150"/>
                    </a:lnTo>
                    <a:lnTo>
                      <a:pt x="121" y="164"/>
                    </a:lnTo>
                    <a:lnTo>
                      <a:pt x="129" y="164"/>
                    </a:lnTo>
                    <a:lnTo>
                      <a:pt x="129" y="178"/>
                    </a:lnTo>
                    <a:lnTo>
                      <a:pt x="143" y="178"/>
                    </a:lnTo>
                    <a:lnTo>
                      <a:pt x="143" y="193"/>
                    </a:lnTo>
                    <a:lnTo>
                      <a:pt x="145" y="193"/>
                    </a:lnTo>
                    <a:lnTo>
                      <a:pt x="145" y="208"/>
                    </a:lnTo>
                    <a:lnTo>
                      <a:pt x="149" y="208"/>
                    </a:lnTo>
                    <a:lnTo>
                      <a:pt x="149" y="222"/>
                    </a:lnTo>
                    <a:lnTo>
                      <a:pt x="152" y="222"/>
                    </a:lnTo>
                    <a:lnTo>
                      <a:pt x="152" y="238"/>
                    </a:lnTo>
                    <a:lnTo>
                      <a:pt x="157" y="238"/>
                    </a:lnTo>
                    <a:lnTo>
                      <a:pt x="157" y="253"/>
                    </a:lnTo>
                    <a:lnTo>
                      <a:pt x="158" y="253"/>
                    </a:lnTo>
                    <a:lnTo>
                      <a:pt x="158" y="269"/>
                    </a:lnTo>
                    <a:lnTo>
                      <a:pt x="160" y="269"/>
                    </a:lnTo>
                    <a:lnTo>
                      <a:pt x="160" y="284"/>
                    </a:lnTo>
                    <a:lnTo>
                      <a:pt x="168" y="284"/>
                    </a:lnTo>
                    <a:lnTo>
                      <a:pt x="168" y="303"/>
                    </a:lnTo>
                    <a:lnTo>
                      <a:pt x="257" y="303"/>
                    </a:lnTo>
                    <a:lnTo>
                      <a:pt x="257" y="374"/>
                    </a:lnTo>
                    <a:lnTo>
                      <a:pt x="303" y="374"/>
                    </a:lnTo>
                    <a:lnTo>
                      <a:pt x="303" y="445"/>
                    </a:lnTo>
                    <a:lnTo>
                      <a:pt x="342" y="445"/>
                    </a:lnTo>
                    <a:lnTo>
                      <a:pt x="342" y="515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Freeform 110"/>
              <p:cNvSpPr>
                <a:spLocks/>
              </p:cNvSpPr>
              <p:nvPr/>
            </p:nvSpPr>
            <p:spPr bwMode="auto">
              <a:xfrm>
                <a:off x="6461619" y="5063008"/>
                <a:ext cx="1366877" cy="1287636"/>
              </a:xfrm>
              <a:custGeom>
                <a:avLst/>
                <a:gdLst>
                  <a:gd name="T0" fmla="*/ 0 w 241"/>
                  <a:gd name="T1" fmla="*/ 0 h 515"/>
                  <a:gd name="T2" fmla="*/ 51 w 241"/>
                  <a:gd name="T3" fmla="*/ 0 h 515"/>
                  <a:gd name="T4" fmla="*/ 51 w 241"/>
                  <a:gd name="T5" fmla="*/ 17 h 515"/>
                  <a:gd name="T6" fmla="*/ 55 w 241"/>
                  <a:gd name="T7" fmla="*/ 17 h 515"/>
                  <a:gd name="T8" fmla="*/ 55 w 241"/>
                  <a:gd name="T9" fmla="*/ 35 h 515"/>
                  <a:gd name="T10" fmla="*/ 56 w 241"/>
                  <a:gd name="T11" fmla="*/ 35 h 515"/>
                  <a:gd name="T12" fmla="*/ 56 w 241"/>
                  <a:gd name="T13" fmla="*/ 53 h 515"/>
                  <a:gd name="T14" fmla="*/ 57 w 241"/>
                  <a:gd name="T15" fmla="*/ 53 h 515"/>
                  <a:gd name="T16" fmla="*/ 57 w 241"/>
                  <a:gd name="T17" fmla="*/ 72 h 515"/>
                  <a:gd name="T18" fmla="*/ 63 w 241"/>
                  <a:gd name="T19" fmla="*/ 72 h 515"/>
                  <a:gd name="T20" fmla="*/ 63 w 241"/>
                  <a:gd name="T21" fmla="*/ 92 h 515"/>
                  <a:gd name="T22" fmla="*/ 67 w 241"/>
                  <a:gd name="T23" fmla="*/ 92 h 515"/>
                  <a:gd name="T24" fmla="*/ 67 w 241"/>
                  <a:gd name="T25" fmla="*/ 113 h 515"/>
                  <a:gd name="T26" fmla="*/ 70 w 241"/>
                  <a:gd name="T27" fmla="*/ 113 h 515"/>
                  <a:gd name="T28" fmla="*/ 70 w 241"/>
                  <a:gd name="T29" fmla="*/ 136 h 515"/>
                  <a:gd name="T30" fmla="*/ 90 w 241"/>
                  <a:gd name="T31" fmla="*/ 136 h 515"/>
                  <a:gd name="T32" fmla="*/ 90 w 241"/>
                  <a:gd name="T33" fmla="*/ 165 h 515"/>
                  <a:gd name="T34" fmla="*/ 104 w 241"/>
                  <a:gd name="T35" fmla="*/ 165 h 515"/>
                  <a:gd name="T36" fmla="*/ 104 w 241"/>
                  <a:gd name="T37" fmla="*/ 194 h 515"/>
                  <a:gd name="T38" fmla="*/ 105 w 241"/>
                  <a:gd name="T39" fmla="*/ 194 h 515"/>
                  <a:gd name="T40" fmla="*/ 105 w 241"/>
                  <a:gd name="T41" fmla="*/ 223 h 515"/>
                  <a:gd name="T42" fmla="*/ 136 w 241"/>
                  <a:gd name="T43" fmla="*/ 223 h 515"/>
                  <a:gd name="T44" fmla="*/ 136 w 241"/>
                  <a:gd name="T45" fmla="*/ 260 h 515"/>
                  <a:gd name="T46" fmla="*/ 137 w 241"/>
                  <a:gd name="T47" fmla="*/ 260 h 515"/>
                  <a:gd name="T48" fmla="*/ 137 w 241"/>
                  <a:gd name="T49" fmla="*/ 296 h 515"/>
                  <a:gd name="T50" fmla="*/ 138 w 241"/>
                  <a:gd name="T51" fmla="*/ 296 h 515"/>
                  <a:gd name="T52" fmla="*/ 138 w 241"/>
                  <a:gd name="T53" fmla="*/ 333 h 515"/>
                  <a:gd name="T54" fmla="*/ 156 w 241"/>
                  <a:gd name="T55" fmla="*/ 333 h 515"/>
                  <a:gd name="T56" fmla="*/ 156 w 241"/>
                  <a:gd name="T57" fmla="*/ 378 h 515"/>
                  <a:gd name="T58" fmla="*/ 241 w 241"/>
                  <a:gd name="T59" fmla="*/ 378 h 515"/>
                  <a:gd name="T60" fmla="*/ 241 w 241"/>
                  <a:gd name="T61" fmla="*/ 515 h 5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241" h="515">
                    <a:moveTo>
                      <a:pt x="0" y="0"/>
                    </a:moveTo>
                    <a:lnTo>
                      <a:pt x="51" y="0"/>
                    </a:lnTo>
                    <a:lnTo>
                      <a:pt x="51" y="17"/>
                    </a:lnTo>
                    <a:lnTo>
                      <a:pt x="55" y="17"/>
                    </a:lnTo>
                    <a:lnTo>
                      <a:pt x="55" y="35"/>
                    </a:lnTo>
                    <a:lnTo>
                      <a:pt x="56" y="35"/>
                    </a:lnTo>
                    <a:lnTo>
                      <a:pt x="56" y="53"/>
                    </a:lnTo>
                    <a:lnTo>
                      <a:pt x="57" y="53"/>
                    </a:lnTo>
                    <a:lnTo>
                      <a:pt x="57" y="72"/>
                    </a:lnTo>
                    <a:lnTo>
                      <a:pt x="63" y="72"/>
                    </a:lnTo>
                    <a:lnTo>
                      <a:pt x="63" y="92"/>
                    </a:lnTo>
                    <a:lnTo>
                      <a:pt x="67" y="92"/>
                    </a:lnTo>
                    <a:lnTo>
                      <a:pt x="67" y="113"/>
                    </a:lnTo>
                    <a:lnTo>
                      <a:pt x="70" y="113"/>
                    </a:lnTo>
                    <a:lnTo>
                      <a:pt x="70" y="136"/>
                    </a:lnTo>
                    <a:lnTo>
                      <a:pt x="90" y="136"/>
                    </a:lnTo>
                    <a:lnTo>
                      <a:pt x="90" y="165"/>
                    </a:lnTo>
                    <a:lnTo>
                      <a:pt x="104" y="165"/>
                    </a:lnTo>
                    <a:lnTo>
                      <a:pt x="104" y="194"/>
                    </a:lnTo>
                    <a:lnTo>
                      <a:pt x="105" y="194"/>
                    </a:lnTo>
                    <a:lnTo>
                      <a:pt x="105" y="223"/>
                    </a:lnTo>
                    <a:lnTo>
                      <a:pt x="136" y="223"/>
                    </a:lnTo>
                    <a:lnTo>
                      <a:pt x="136" y="260"/>
                    </a:lnTo>
                    <a:lnTo>
                      <a:pt x="137" y="260"/>
                    </a:lnTo>
                    <a:lnTo>
                      <a:pt x="137" y="296"/>
                    </a:lnTo>
                    <a:lnTo>
                      <a:pt x="138" y="296"/>
                    </a:lnTo>
                    <a:lnTo>
                      <a:pt x="138" y="333"/>
                    </a:lnTo>
                    <a:lnTo>
                      <a:pt x="156" y="333"/>
                    </a:lnTo>
                    <a:lnTo>
                      <a:pt x="156" y="378"/>
                    </a:lnTo>
                    <a:lnTo>
                      <a:pt x="241" y="378"/>
                    </a:lnTo>
                    <a:lnTo>
                      <a:pt x="241" y="515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111"/>
              <p:cNvSpPr>
                <a:spLocks noChangeArrowheads="1"/>
              </p:cNvSpPr>
              <p:nvPr/>
            </p:nvSpPr>
            <p:spPr bwMode="auto">
              <a:xfrm>
                <a:off x="6543234" y="6203681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375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3" name="Rectangle 112"/>
              <p:cNvSpPr>
                <a:spLocks noChangeArrowheads="1"/>
              </p:cNvSpPr>
              <p:nvPr/>
            </p:nvSpPr>
            <p:spPr bwMode="auto">
              <a:xfrm>
                <a:off x="7429892" y="5660995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5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4" name="Rectangle 113"/>
              <p:cNvSpPr>
                <a:spLocks noChangeArrowheads="1"/>
              </p:cNvSpPr>
              <p:nvPr/>
            </p:nvSpPr>
            <p:spPr bwMode="auto">
              <a:xfrm>
                <a:off x="7429892" y="5855088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27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5" name="Line 118"/>
              <p:cNvSpPr>
                <a:spLocks noChangeShapeType="1"/>
              </p:cNvSpPr>
              <p:nvPr/>
            </p:nvSpPr>
            <p:spPr bwMode="auto">
              <a:xfrm>
                <a:off x="920792" y="2156846"/>
                <a:ext cx="194226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Line 119"/>
              <p:cNvSpPr>
                <a:spLocks noChangeShapeType="1"/>
              </p:cNvSpPr>
              <p:nvPr/>
            </p:nvSpPr>
            <p:spPr bwMode="auto">
              <a:xfrm>
                <a:off x="920792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Line 120"/>
              <p:cNvSpPr>
                <a:spLocks noChangeShapeType="1"/>
              </p:cNvSpPr>
              <p:nvPr/>
            </p:nvSpPr>
            <p:spPr bwMode="auto">
              <a:xfrm>
                <a:off x="1244502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Line 121"/>
              <p:cNvSpPr>
                <a:spLocks noChangeShapeType="1"/>
              </p:cNvSpPr>
              <p:nvPr/>
            </p:nvSpPr>
            <p:spPr bwMode="auto">
              <a:xfrm>
                <a:off x="1568212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Line 122"/>
              <p:cNvSpPr>
                <a:spLocks noChangeShapeType="1"/>
              </p:cNvSpPr>
              <p:nvPr/>
            </p:nvSpPr>
            <p:spPr bwMode="auto">
              <a:xfrm>
                <a:off x="1891923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Line 123"/>
              <p:cNvSpPr>
                <a:spLocks noChangeShapeType="1"/>
              </p:cNvSpPr>
              <p:nvPr/>
            </p:nvSpPr>
            <p:spPr bwMode="auto">
              <a:xfrm>
                <a:off x="2215633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Line 124"/>
              <p:cNvSpPr>
                <a:spLocks noChangeShapeType="1"/>
              </p:cNvSpPr>
              <p:nvPr/>
            </p:nvSpPr>
            <p:spPr bwMode="auto">
              <a:xfrm>
                <a:off x="2539343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Line 125"/>
              <p:cNvSpPr>
                <a:spLocks noChangeShapeType="1"/>
              </p:cNvSpPr>
              <p:nvPr/>
            </p:nvSpPr>
            <p:spPr bwMode="auto">
              <a:xfrm>
                <a:off x="2863053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126"/>
              <p:cNvSpPr>
                <a:spLocks noChangeArrowheads="1"/>
              </p:cNvSpPr>
              <p:nvPr/>
            </p:nvSpPr>
            <p:spPr bwMode="auto">
              <a:xfrm>
                <a:off x="881827" y="2249132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4" name="Rectangle 127"/>
              <p:cNvSpPr>
                <a:spLocks noChangeArrowheads="1"/>
              </p:cNvSpPr>
              <p:nvPr/>
            </p:nvSpPr>
            <p:spPr bwMode="auto">
              <a:xfrm>
                <a:off x="1187554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5" name="Rectangle 128"/>
              <p:cNvSpPr>
                <a:spLocks noChangeArrowheads="1"/>
              </p:cNvSpPr>
              <p:nvPr/>
            </p:nvSpPr>
            <p:spPr bwMode="auto">
              <a:xfrm>
                <a:off x="1511264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6" name="Rectangle 129"/>
              <p:cNvSpPr>
                <a:spLocks noChangeArrowheads="1"/>
              </p:cNvSpPr>
              <p:nvPr/>
            </p:nvSpPr>
            <p:spPr bwMode="auto">
              <a:xfrm>
                <a:off x="1834975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7" name="Rectangle 130"/>
              <p:cNvSpPr>
                <a:spLocks noChangeArrowheads="1"/>
              </p:cNvSpPr>
              <p:nvPr/>
            </p:nvSpPr>
            <p:spPr bwMode="auto">
              <a:xfrm>
                <a:off x="2158685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8" name="Rectangle 131"/>
              <p:cNvSpPr>
                <a:spLocks noChangeArrowheads="1"/>
              </p:cNvSpPr>
              <p:nvPr/>
            </p:nvSpPr>
            <p:spPr bwMode="auto">
              <a:xfrm>
                <a:off x="2482395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9" name="Rectangle 132"/>
              <p:cNvSpPr>
                <a:spLocks noChangeArrowheads="1"/>
              </p:cNvSpPr>
              <p:nvPr/>
            </p:nvSpPr>
            <p:spPr bwMode="auto">
              <a:xfrm>
                <a:off x="2806105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90" name="Line 133"/>
              <p:cNvSpPr>
                <a:spLocks noChangeShapeType="1"/>
              </p:cNvSpPr>
              <p:nvPr/>
            </p:nvSpPr>
            <p:spPr bwMode="auto">
              <a:xfrm flipV="1">
                <a:off x="920792" y="822401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Line 134"/>
              <p:cNvSpPr>
                <a:spLocks noChangeShapeType="1"/>
              </p:cNvSpPr>
              <p:nvPr/>
            </p:nvSpPr>
            <p:spPr bwMode="auto">
              <a:xfrm flipH="1">
                <a:off x="884824" y="2104855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Line 135"/>
              <p:cNvSpPr>
                <a:spLocks noChangeShapeType="1"/>
              </p:cNvSpPr>
              <p:nvPr/>
            </p:nvSpPr>
            <p:spPr bwMode="auto">
              <a:xfrm flipH="1">
                <a:off x="884824" y="184489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Line 136"/>
              <p:cNvSpPr>
                <a:spLocks noChangeShapeType="1"/>
              </p:cNvSpPr>
              <p:nvPr/>
            </p:nvSpPr>
            <p:spPr bwMode="auto">
              <a:xfrm flipH="1">
                <a:off x="884824" y="1593606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Line 137"/>
              <p:cNvSpPr>
                <a:spLocks noChangeShapeType="1"/>
              </p:cNvSpPr>
              <p:nvPr/>
            </p:nvSpPr>
            <p:spPr bwMode="auto">
              <a:xfrm flipH="1">
                <a:off x="884824" y="1333649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Line 138"/>
              <p:cNvSpPr>
                <a:spLocks noChangeShapeType="1"/>
              </p:cNvSpPr>
              <p:nvPr/>
            </p:nvSpPr>
            <p:spPr bwMode="auto">
              <a:xfrm flipH="1">
                <a:off x="884824" y="108235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Line 139"/>
              <p:cNvSpPr>
                <a:spLocks noChangeShapeType="1"/>
              </p:cNvSpPr>
              <p:nvPr/>
            </p:nvSpPr>
            <p:spPr bwMode="auto">
              <a:xfrm flipH="1">
                <a:off x="884824" y="82240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Rectangle 140"/>
              <p:cNvSpPr>
                <a:spLocks noChangeArrowheads="1"/>
              </p:cNvSpPr>
              <p:nvPr/>
            </p:nvSpPr>
            <p:spPr bwMode="auto">
              <a:xfrm>
                <a:off x="710979" y="2037779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98" name="Rectangle 141"/>
              <p:cNvSpPr>
                <a:spLocks noChangeArrowheads="1"/>
              </p:cNvSpPr>
              <p:nvPr/>
            </p:nvSpPr>
            <p:spPr bwMode="auto">
              <a:xfrm>
                <a:off x="710979" y="1786487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99" name="Rectangle 142"/>
              <p:cNvSpPr>
                <a:spLocks noChangeArrowheads="1"/>
              </p:cNvSpPr>
              <p:nvPr/>
            </p:nvSpPr>
            <p:spPr bwMode="auto">
              <a:xfrm>
                <a:off x="710979" y="152653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0" name="Rectangle 143"/>
              <p:cNvSpPr>
                <a:spLocks noChangeArrowheads="1"/>
              </p:cNvSpPr>
              <p:nvPr/>
            </p:nvSpPr>
            <p:spPr bwMode="auto">
              <a:xfrm>
                <a:off x="710979" y="127523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1" name="Rectangle 144"/>
              <p:cNvSpPr>
                <a:spLocks noChangeArrowheads="1"/>
              </p:cNvSpPr>
              <p:nvPr/>
            </p:nvSpPr>
            <p:spPr bwMode="auto">
              <a:xfrm>
                <a:off x="710979" y="1015282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2" name="Rectangle 145"/>
              <p:cNvSpPr>
                <a:spLocks noChangeArrowheads="1"/>
              </p:cNvSpPr>
              <p:nvPr/>
            </p:nvSpPr>
            <p:spPr bwMode="auto">
              <a:xfrm>
                <a:off x="710979" y="76399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3" name="Rectangle 147"/>
              <p:cNvSpPr>
                <a:spLocks noChangeArrowheads="1"/>
              </p:cNvSpPr>
              <p:nvPr/>
            </p:nvSpPr>
            <p:spPr bwMode="auto">
              <a:xfrm>
                <a:off x="1584438" y="569596"/>
                <a:ext cx="804707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Chen</a:t>
                </a:r>
                <a:r>
                  <a:rPr kumimoji="0" lang="fr-FR" altLang="fr-FR" sz="12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(N=63)</a:t>
                </a:r>
                <a:endParaRPr kumimoji="0" lang="fr-FR" altLang="fr-FR" sz="1000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6" name="Rectangle 150"/>
              <p:cNvSpPr>
                <a:spLocks noChangeArrowheads="1"/>
              </p:cNvSpPr>
              <p:nvPr/>
            </p:nvSpPr>
            <p:spPr bwMode="auto">
              <a:xfrm rot="16200000">
                <a:off x="197310" y="1370182"/>
                <a:ext cx="796238" cy="181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Overall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rvival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" name="Freeform 151"/>
              <p:cNvSpPr>
                <a:spLocks/>
              </p:cNvSpPr>
              <p:nvPr/>
            </p:nvSpPr>
            <p:spPr bwMode="auto">
              <a:xfrm>
                <a:off x="920792" y="822401"/>
                <a:ext cx="1942261" cy="909849"/>
              </a:xfrm>
              <a:custGeom>
                <a:avLst/>
                <a:gdLst>
                  <a:gd name="T0" fmla="*/ 0 w 324"/>
                  <a:gd name="T1" fmla="*/ 0 h 105"/>
                  <a:gd name="T2" fmla="*/ 16 w 324"/>
                  <a:gd name="T3" fmla="*/ 0 h 105"/>
                  <a:gd name="T4" fmla="*/ 16 w 324"/>
                  <a:gd name="T5" fmla="*/ 4 h 105"/>
                  <a:gd name="T6" fmla="*/ 25 w 324"/>
                  <a:gd name="T7" fmla="*/ 4 h 105"/>
                  <a:gd name="T8" fmla="*/ 25 w 324"/>
                  <a:gd name="T9" fmla="*/ 8 h 105"/>
                  <a:gd name="T10" fmla="*/ 34 w 324"/>
                  <a:gd name="T11" fmla="*/ 8 h 105"/>
                  <a:gd name="T12" fmla="*/ 34 w 324"/>
                  <a:gd name="T13" fmla="*/ 11 h 105"/>
                  <a:gd name="T14" fmla="*/ 48 w 324"/>
                  <a:gd name="T15" fmla="*/ 11 h 105"/>
                  <a:gd name="T16" fmla="*/ 48 w 324"/>
                  <a:gd name="T17" fmla="*/ 15 h 105"/>
                  <a:gd name="T18" fmla="*/ 58 w 324"/>
                  <a:gd name="T19" fmla="*/ 15 h 105"/>
                  <a:gd name="T20" fmla="*/ 58 w 324"/>
                  <a:gd name="T21" fmla="*/ 19 h 105"/>
                  <a:gd name="T22" fmla="*/ 66 w 324"/>
                  <a:gd name="T23" fmla="*/ 19 h 105"/>
                  <a:gd name="T24" fmla="*/ 66 w 324"/>
                  <a:gd name="T25" fmla="*/ 23 h 105"/>
                  <a:gd name="T26" fmla="*/ 73 w 324"/>
                  <a:gd name="T27" fmla="*/ 23 h 105"/>
                  <a:gd name="T28" fmla="*/ 73 w 324"/>
                  <a:gd name="T29" fmla="*/ 26 h 105"/>
                  <a:gd name="T30" fmla="*/ 74 w 324"/>
                  <a:gd name="T31" fmla="*/ 26 h 105"/>
                  <a:gd name="T32" fmla="*/ 74 w 324"/>
                  <a:gd name="T33" fmla="*/ 30 h 105"/>
                  <a:gd name="T34" fmla="*/ 84 w 324"/>
                  <a:gd name="T35" fmla="*/ 30 h 105"/>
                  <a:gd name="T36" fmla="*/ 84 w 324"/>
                  <a:gd name="T37" fmla="*/ 34 h 105"/>
                  <a:gd name="T38" fmla="*/ 86 w 324"/>
                  <a:gd name="T39" fmla="*/ 34 h 105"/>
                  <a:gd name="T40" fmla="*/ 86 w 324"/>
                  <a:gd name="T41" fmla="*/ 37 h 105"/>
                  <a:gd name="T42" fmla="*/ 88 w 324"/>
                  <a:gd name="T43" fmla="*/ 37 h 105"/>
                  <a:gd name="T44" fmla="*/ 88 w 324"/>
                  <a:gd name="T45" fmla="*/ 41 h 105"/>
                  <a:gd name="T46" fmla="*/ 89 w 324"/>
                  <a:gd name="T47" fmla="*/ 41 h 105"/>
                  <a:gd name="T48" fmla="*/ 89 w 324"/>
                  <a:gd name="T49" fmla="*/ 45 h 105"/>
                  <a:gd name="T50" fmla="*/ 96 w 324"/>
                  <a:gd name="T51" fmla="*/ 45 h 105"/>
                  <a:gd name="T52" fmla="*/ 96 w 324"/>
                  <a:gd name="T53" fmla="*/ 48 h 105"/>
                  <a:gd name="T54" fmla="*/ 106 w 324"/>
                  <a:gd name="T55" fmla="*/ 48 h 105"/>
                  <a:gd name="T56" fmla="*/ 106 w 324"/>
                  <a:gd name="T57" fmla="*/ 52 h 105"/>
                  <a:gd name="T58" fmla="*/ 108 w 324"/>
                  <a:gd name="T59" fmla="*/ 52 h 105"/>
                  <a:gd name="T60" fmla="*/ 108 w 324"/>
                  <a:gd name="T61" fmla="*/ 56 h 105"/>
                  <a:gd name="T62" fmla="*/ 114 w 324"/>
                  <a:gd name="T63" fmla="*/ 56 h 105"/>
                  <a:gd name="T64" fmla="*/ 114 w 324"/>
                  <a:gd name="T65" fmla="*/ 59 h 105"/>
                  <a:gd name="T66" fmla="*/ 142 w 324"/>
                  <a:gd name="T67" fmla="*/ 59 h 105"/>
                  <a:gd name="T68" fmla="*/ 142 w 324"/>
                  <a:gd name="T69" fmla="*/ 64 h 105"/>
                  <a:gd name="T70" fmla="*/ 153 w 324"/>
                  <a:gd name="T71" fmla="*/ 64 h 105"/>
                  <a:gd name="T72" fmla="*/ 153 w 324"/>
                  <a:gd name="T73" fmla="*/ 68 h 105"/>
                  <a:gd name="T74" fmla="*/ 163 w 324"/>
                  <a:gd name="T75" fmla="*/ 68 h 105"/>
                  <a:gd name="T76" fmla="*/ 163 w 324"/>
                  <a:gd name="T77" fmla="*/ 74 h 105"/>
                  <a:gd name="T78" fmla="*/ 171 w 324"/>
                  <a:gd name="T79" fmla="*/ 74 h 105"/>
                  <a:gd name="T80" fmla="*/ 171 w 324"/>
                  <a:gd name="T81" fmla="*/ 79 h 105"/>
                  <a:gd name="T82" fmla="*/ 172 w 324"/>
                  <a:gd name="T83" fmla="*/ 79 h 105"/>
                  <a:gd name="T84" fmla="*/ 172 w 324"/>
                  <a:gd name="T85" fmla="*/ 85 h 105"/>
                  <a:gd name="T86" fmla="*/ 178 w 324"/>
                  <a:gd name="T87" fmla="*/ 85 h 105"/>
                  <a:gd name="T88" fmla="*/ 178 w 324"/>
                  <a:gd name="T89" fmla="*/ 91 h 105"/>
                  <a:gd name="T90" fmla="*/ 197 w 324"/>
                  <a:gd name="T91" fmla="*/ 91 h 105"/>
                  <a:gd name="T92" fmla="*/ 197 w 324"/>
                  <a:gd name="T93" fmla="*/ 98 h 105"/>
                  <a:gd name="T94" fmla="*/ 204 w 324"/>
                  <a:gd name="T95" fmla="*/ 98 h 105"/>
                  <a:gd name="T96" fmla="*/ 204 w 324"/>
                  <a:gd name="T97" fmla="*/ 105 h 105"/>
                  <a:gd name="T98" fmla="*/ 324 w 324"/>
                  <a:gd name="T99" fmla="*/ 105 h 105"/>
                  <a:gd name="T100" fmla="*/ 324 w 324"/>
                  <a:gd name="T101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</a:cxnLst>
                <a:rect l="0" t="0" r="r" b="b"/>
                <a:pathLst>
                  <a:path w="324" h="105">
                    <a:moveTo>
                      <a:pt x="0" y="0"/>
                    </a:moveTo>
                    <a:lnTo>
                      <a:pt x="16" y="0"/>
                    </a:lnTo>
                    <a:lnTo>
                      <a:pt x="16" y="4"/>
                    </a:lnTo>
                    <a:lnTo>
                      <a:pt x="25" y="4"/>
                    </a:lnTo>
                    <a:lnTo>
                      <a:pt x="25" y="8"/>
                    </a:lnTo>
                    <a:lnTo>
                      <a:pt x="34" y="8"/>
                    </a:lnTo>
                    <a:lnTo>
                      <a:pt x="34" y="11"/>
                    </a:lnTo>
                    <a:lnTo>
                      <a:pt x="48" y="11"/>
                    </a:lnTo>
                    <a:lnTo>
                      <a:pt x="48" y="15"/>
                    </a:lnTo>
                    <a:lnTo>
                      <a:pt x="58" y="15"/>
                    </a:lnTo>
                    <a:lnTo>
                      <a:pt x="58" y="19"/>
                    </a:lnTo>
                    <a:lnTo>
                      <a:pt x="66" y="19"/>
                    </a:lnTo>
                    <a:lnTo>
                      <a:pt x="66" y="23"/>
                    </a:lnTo>
                    <a:lnTo>
                      <a:pt x="73" y="23"/>
                    </a:lnTo>
                    <a:lnTo>
                      <a:pt x="73" y="26"/>
                    </a:lnTo>
                    <a:lnTo>
                      <a:pt x="74" y="26"/>
                    </a:lnTo>
                    <a:lnTo>
                      <a:pt x="74" y="30"/>
                    </a:lnTo>
                    <a:lnTo>
                      <a:pt x="84" y="30"/>
                    </a:lnTo>
                    <a:lnTo>
                      <a:pt x="84" y="34"/>
                    </a:lnTo>
                    <a:lnTo>
                      <a:pt x="86" y="34"/>
                    </a:lnTo>
                    <a:lnTo>
                      <a:pt x="86" y="37"/>
                    </a:lnTo>
                    <a:lnTo>
                      <a:pt x="88" y="37"/>
                    </a:lnTo>
                    <a:lnTo>
                      <a:pt x="88" y="41"/>
                    </a:lnTo>
                    <a:lnTo>
                      <a:pt x="89" y="41"/>
                    </a:lnTo>
                    <a:lnTo>
                      <a:pt x="89" y="45"/>
                    </a:lnTo>
                    <a:lnTo>
                      <a:pt x="96" y="45"/>
                    </a:lnTo>
                    <a:lnTo>
                      <a:pt x="96" y="48"/>
                    </a:lnTo>
                    <a:lnTo>
                      <a:pt x="106" y="48"/>
                    </a:lnTo>
                    <a:lnTo>
                      <a:pt x="106" y="52"/>
                    </a:lnTo>
                    <a:lnTo>
                      <a:pt x="108" y="52"/>
                    </a:lnTo>
                    <a:lnTo>
                      <a:pt x="108" y="56"/>
                    </a:lnTo>
                    <a:lnTo>
                      <a:pt x="114" y="56"/>
                    </a:lnTo>
                    <a:lnTo>
                      <a:pt x="114" y="59"/>
                    </a:lnTo>
                    <a:lnTo>
                      <a:pt x="142" y="59"/>
                    </a:lnTo>
                    <a:lnTo>
                      <a:pt x="142" y="64"/>
                    </a:lnTo>
                    <a:lnTo>
                      <a:pt x="153" y="64"/>
                    </a:lnTo>
                    <a:lnTo>
                      <a:pt x="153" y="68"/>
                    </a:lnTo>
                    <a:lnTo>
                      <a:pt x="163" y="68"/>
                    </a:lnTo>
                    <a:lnTo>
                      <a:pt x="163" y="74"/>
                    </a:lnTo>
                    <a:lnTo>
                      <a:pt x="171" y="74"/>
                    </a:lnTo>
                    <a:lnTo>
                      <a:pt x="171" y="79"/>
                    </a:lnTo>
                    <a:lnTo>
                      <a:pt x="172" y="79"/>
                    </a:lnTo>
                    <a:lnTo>
                      <a:pt x="172" y="85"/>
                    </a:lnTo>
                    <a:lnTo>
                      <a:pt x="178" y="85"/>
                    </a:lnTo>
                    <a:lnTo>
                      <a:pt x="178" y="91"/>
                    </a:lnTo>
                    <a:lnTo>
                      <a:pt x="197" y="91"/>
                    </a:lnTo>
                    <a:lnTo>
                      <a:pt x="197" y="98"/>
                    </a:lnTo>
                    <a:lnTo>
                      <a:pt x="204" y="98"/>
                    </a:lnTo>
                    <a:lnTo>
                      <a:pt x="204" y="105"/>
                    </a:lnTo>
                    <a:lnTo>
                      <a:pt x="324" y="105"/>
                    </a:lnTo>
                    <a:lnTo>
                      <a:pt x="324" y="105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Freeform 152"/>
              <p:cNvSpPr>
                <a:spLocks/>
              </p:cNvSpPr>
              <p:nvPr/>
            </p:nvSpPr>
            <p:spPr bwMode="auto">
              <a:xfrm>
                <a:off x="920792" y="822401"/>
                <a:ext cx="1942261" cy="1100484"/>
              </a:xfrm>
              <a:custGeom>
                <a:avLst/>
                <a:gdLst>
                  <a:gd name="T0" fmla="*/ 0 w 324"/>
                  <a:gd name="T1" fmla="*/ 0 h 127"/>
                  <a:gd name="T2" fmla="*/ 21 w 324"/>
                  <a:gd name="T3" fmla="*/ 0 h 127"/>
                  <a:gd name="T4" fmla="*/ 21 w 324"/>
                  <a:gd name="T5" fmla="*/ 7 h 127"/>
                  <a:gd name="T6" fmla="*/ 28 w 324"/>
                  <a:gd name="T7" fmla="*/ 7 h 127"/>
                  <a:gd name="T8" fmla="*/ 28 w 324"/>
                  <a:gd name="T9" fmla="*/ 13 h 127"/>
                  <a:gd name="T10" fmla="*/ 41 w 324"/>
                  <a:gd name="T11" fmla="*/ 13 h 127"/>
                  <a:gd name="T12" fmla="*/ 41 w 324"/>
                  <a:gd name="T13" fmla="*/ 20 h 127"/>
                  <a:gd name="T14" fmla="*/ 43 w 324"/>
                  <a:gd name="T15" fmla="*/ 20 h 127"/>
                  <a:gd name="T16" fmla="*/ 43 w 324"/>
                  <a:gd name="T17" fmla="*/ 26 h 127"/>
                  <a:gd name="T18" fmla="*/ 48 w 324"/>
                  <a:gd name="T19" fmla="*/ 26 h 127"/>
                  <a:gd name="T20" fmla="*/ 48 w 324"/>
                  <a:gd name="T21" fmla="*/ 32 h 127"/>
                  <a:gd name="T22" fmla="*/ 50 w 324"/>
                  <a:gd name="T23" fmla="*/ 32 h 127"/>
                  <a:gd name="T24" fmla="*/ 50 w 324"/>
                  <a:gd name="T25" fmla="*/ 39 h 127"/>
                  <a:gd name="T26" fmla="*/ 54 w 324"/>
                  <a:gd name="T27" fmla="*/ 39 h 127"/>
                  <a:gd name="T28" fmla="*/ 54 w 324"/>
                  <a:gd name="T29" fmla="*/ 45 h 127"/>
                  <a:gd name="T30" fmla="*/ 68 w 324"/>
                  <a:gd name="T31" fmla="*/ 45 h 127"/>
                  <a:gd name="T32" fmla="*/ 68 w 324"/>
                  <a:gd name="T33" fmla="*/ 52 h 127"/>
                  <a:gd name="T34" fmla="*/ 76 w 324"/>
                  <a:gd name="T35" fmla="*/ 52 h 127"/>
                  <a:gd name="T36" fmla="*/ 76 w 324"/>
                  <a:gd name="T37" fmla="*/ 59 h 127"/>
                  <a:gd name="T38" fmla="*/ 85 w 324"/>
                  <a:gd name="T39" fmla="*/ 59 h 127"/>
                  <a:gd name="T40" fmla="*/ 85 w 324"/>
                  <a:gd name="T41" fmla="*/ 66 h 127"/>
                  <a:gd name="T42" fmla="*/ 88 w 324"/>
                  <a:gd name="T43" fmla="*/ 66 h 127"/>
                  <a:gd name="T44" fmla="*/ 88 w 324"/>
                  <a:gd name="T45" fmla="*/ 73 h 127"/>
                  <a:gd name="T46" fmla="*/ 95 w 324"/>
                  <a:gd name="T47" fmla="*/ 73 h 127"/>
                  <a:gd name="T48" fmla="*/ 95 w 324"/>
                  <a:gd name="T49" fmla="*/ 80 h 127"/>
                  <a:gd name="T50" fmla="*/ 97 w 324"/>
                  <a:gd name="T51" fmla="*/ 80 h 127"/>
                  <a:gd name="T52" fmla="*/ 97 w 324"/>
                  <a:gd name="T53" fmla="*/ 86 h 127"/>
                  <a:gd name="T54" fmla="*/ 111 w 324"/>
                  <a:gd name="T55" fmla="*/ 86 h 127"/>
                  <a:gd name="T56" fmla="*/ 111 w 324"/>
                  <a:gd name="T57" fmla="*/ 93 h 127"/>
                  <a:gd name="T58" fmla="*/ 112 w 324"/>
                  <a:gd name="T59" fmla="*/ 93 h 127"/>
                  <a:gd name="T60" fmla="*/ 112 w 324"/>
                  <a:gd name="T61" fmla="*/ 100 h 127"/>
                  <a:gd name="T62" fmla="*/ 116 w 324"/>
                  <a:gd name="T63" fmla="*/ 100 h 127"/>
                  <a:gd name="T64" fmla="*/ 116 w 324"/>
                  <a:gd name="T65" fmla="*/ 107 h 127"/>
                  <a:gd name="T66" fmla="*/ 157 w 324"/>
                  <a:gd name="T67" fmla="*/ 107 h 127"/>
                  <a:gd name="T68" fmla="*/ 157 w 324"/>
                  <a:gd name="T69" fmla="*/ 117 h 127"/>
                  <a:gd name="T70" fmla="*/ 165 w 324"/>
                  <a:gd name="T71" fmla="*/ 117 h 127"/>
                  <a:gd name="T72" fmla="*/ 165 w 324"/>
                  <a:gd name="T73" fmla="*/ 127 h 127"/>
                  <a:gd name="T74" fmla="*/ 324 w 324"/>
                  <a:gd name="T75" fmla="*/ 127 h 127"/>
                  <a:gd name="T76" fmla="*/ 324 w 324"/>
                  <a:gd name="T77" fmla="*/ 127 h 1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</a:cxnLst>
                <a:rect l="0" t="0" r="r" b="b"/>
                <a:pathLst>
                  <a:path w="324" h="127">
                    <a:moveTo>
                      <a:pt x="0" y="0"/>
                    </a:moveTo>
                    <a:lnTo>
                      <a:pt x="21" y="0"/>
                    </a:lnTo>
                    <a:lnTo>
                      <a:pt x="21" y="7"/>
                    </a:lnTo>
                    <a:lnTo>
                      <a:pt x="28" y="7"/>
                    </a:lnTo>
                    <a:lnTo>
                      <a:pt x="28" y="13"/>
                    </a:lnTo>
                    <a:lnTo>
                      <a:pt x="41" y="13"/>
                    </a:lnTo>
                    <a:lnTo>
                      <a:pt x="41" y="20"/>
                    </a:lnTo>
                    <a:lnTo>
                      <a:pt x="43" y="20"/>
                    </a:lnTo>
                    <a:lnTo>
                      <a:pt x="43" y="26"/>
                    </a:lnTo>
                    <a:lnTo>
                      <a:pt x="48" y="26"/>
                    </a:lnTo>
                    <a:lnTo>
                      <a:pt x="48" y="32"/>
                    </a:lnTo>
                    <a:lnTo>
                      <a:pt x="50" y="32"/>
                    </a:lnTo>
                    <a:lnTo>
                      <a:pt x="50" y="39"/>
                    </a:lnTo>
                    <a:lnTo>
                      <a:pt x="54" y="39"/>
                    </a:lnTo>
                    <a:lnTo>
                      <a:pt x="54" y="45"/>
                    </a:lnTo>
                    <a:lnTo>
                      <a:pt x="68" y="45"/>
                    </a:lnTo>
                    <a:lnTo>
                      <a:pt x="68" y="52"/>
                    </a:lnTo>
                    <a:lnTo>
                      <a:pt x="76" y="52"/>
                    </a:lnTo>
                    <a:lnTo>
                      <a:pt x="76" y="59"/>
                    </a:lnTo>
                    <a:lnTo>
                      <a:pt x="85" y="59"/>
                    </a:lnTo>
                    <a:lnTo>
                      <a:pt x="85" y="66"/>
                    </a:lnTo>
                    <a:lnTo>
                      <a:pt x="88" y="66"/>
                    </a:lnTo>
                    <a:lnTo>
                      <a:pt x="88" y="73"/>
                    </a:lnTo>
                    <a:lnTo>
                      <a:pt x="95" y="73"/>
                    </a:lnTo>
                    <a:lnTo>
                      <a:pt x="95" y="80"/>
                    </a:lnTo>
                    <a:lnTo>
                      <a:pt x="97" y="80"/>
                    </a:lnTo>
                    <a:lnTo>
                      <a:pt x="97" y="86"/>
                    </a:lnTo>
                    <a:lnTo>
                      <a:pt x="111" y="86"/>
                    </a:lnTo>
                    <a:lnTo>
                      <a:pt x="111" y="93"/>
                    </a:lnTo>
                    <a:lnTo>
                      <a:pt x="112" y="93"/>
                    </a:lnTo>
                    <a:lnTo>
                      <a:pt x="112" y="100"/>
                    </a:lnTo>
                    <a:lnTo>
                      <a:pt x="116" y="100"/>
                    </a:lnTo>
                    <a:lnTo>
                      <a:pt x="116" y="107"/>
                    </a:lnTo>
                    <a:lnTo>
                      <a:pt x="157" y="107"/>
                    </a:lnTo>
                    <a:lnTo>
                      <a:pt x="157" y="117"/>
                    </a:lnTo>
                    <a:lnTo>
                      <a:pt x="165" y="117"/>
                    </a:lnTo>
                    <a:lnTo>
                      <a:pt x="165" y="127"/>
                    </a:lnTo>
                    <a:lnTo>
                      <a:pt x="324" y="127"/>
                    </a:lnTo>
                    <a:lnTo>
                      <a:pt x="324" y="127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angle 153"/>
              <p:cNvSpPr>
                <a:spLocks noChangeArrowheads="1"/>
              </p:cNvSpPr>
              <p:nvPr/>
            </p:nvSpPr>
            <p:spPr bwMode="auto">
              <a:xfrm>
                <a:off x="1000089" y="1957790"/>
                <a:ext cx="54181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187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11" name="Rectangle 155"/>
              <p:cNvSpPr>
                <a:spLocks noChangeArrowheads="1"/>
              </p:cNvSpPr>
              <p:nvPr/>
            </p:nvSpPr>
            <p:spPr bwMode="auto">
              <a:xfrm>
                <a:off x="1742419" y="1602462"/>
                <a:ext cx="230832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28%</a:t>
                </a:r>
              </a:p>
            </p:txBody>
          </p:sp>
          <p:sp>
            <p:nvSpPr>
              <p:cNvPr id="112" name="Line 156"/>
              <p:cNvSpPr>
                <a:spLocks noChangeShapeType="1"/>
              </p:cNvSpPr>
              <p:nvPr/>
            </p:nvSpPr>
            <p:spPr bwMode="auto">
              <a:xfrm>
                <a:off x="3635670" y="2156846"/>
                <a:ext cx="194226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Line 157"/>
              <p:cNvSpPr>
                <a:spLocks noChangeShapeType="1"/>
              </p:cNvSpPr>
              <p:nvPr/>
            </p:nvSpPr>
            <p:spPr bwMode="auto">
              <a:xfrm>
                <a:off x="3635670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Line 158"/>
              <p:cNvSpPr>
                <a:spLocks noChangeShapeType="1"/>
              </p:cNvSpPr>
              <p:nvPr/>
            </p:nvSpPr>
            <p:spPr bwMode="auto">
              <a:xfrm>
                <a:off x="3959380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Line 159"/>
              <p:cNvSpPr>
                <a:spLocks noChangeShapeType="1"/>
              </p:cNvSpPr>
              <p:nvPr/>
            </p:nvSpPr>
            <p:spPr bwMode="auto">
              <a:xfrm>
                <a:off x="4283090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Line 160"/>
              <p:cNvSpPr>
                <a:spLocks noChangeShapeType="1"/>
              </p:cNvSpPr>
              <p:nvPr/>
            </p:nvSpPr>
            <p:spPr bwMode="auto">
              <a:xfrm>
                <a:off x="4606801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Line 161"/>
              <p:cNvSpPr>
                <a:spLocks noChangeShapeType="1"/>
              </p:cNvSpPr>
              <p:nvPr/>
            </p:nvSpPr>
            <p:spPr bwMode="auto">
              <a:xfrm>
                <a:off x="4930511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Line 162"/>
              <p:cNvSpPr>
                <a:spLocks noChangeShapeType="1"/>
              </p:cNvSpPr>
              <p:nvPr/>
            </p:nvSpPr>
            <p:spPr bwMode="auto">
              <a:xfrm>
                <a:off x="5254221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Line 163"/>
              <p:cNvSpPr>
                <a:spLocks noChangeShapeType="1"/>
              </p:cNvSpPr>
              <p:nvPr/>
            </p:nvSpPr>
            <p:spPr bwMode="auto">
              <a:xfrm>
                <a:off x="5577931" y="2156846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Rectangle 164"/>
              <p:cNvSpPr>
                <a:spLocks noChangeArrowheads="1"/>
              </p:cNvSpPr>
              <p:nvPr/>
            </p:nvSpPr>
            <p:spPr bwMode="auto">
              <a:xfrm>
                <a:off x="3596706" y="2249132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1" name="Rectangle 165"/>
              <p:cNvSpPr>
                <a:spLocks noChangeArrowheads="1"/>
              </p:cNvSpPr>
              <p:nvPr/>
            </p:nvSpPr>
            <p:spPr bwMode="auto">
              <a:xfrm>
                <a:off x="3902432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2" name="Rectangle 166"/>
              <p:cNvSpPr>
                <a:spLocks noChangeArrowheads="1"/>
              </p:cNvSpPr>
              <p:nvPr/>
            </p:nvSpPr>
            <p:spPr bwMode="auto">
              <a:xfrm>
                <a:off x="4226142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3" name="Rectangle 167"/>
              <p:cNvSpPr>
                <a:spLocks noChangeArrowheads="1"/>
              </p:cNvSpPr>
              <p:nvPr/>
            </p:nvSpPr>
            <p:spPr bwMode="auto">
              <a:xfrm>
                <a:off x="4549852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4" name="Rectangle 168"/>
              <p:cNvSpPr>
                <a:spLocks noChangeArrowheads="1"/>
              </p:cNvSpPr>
              <p:nvPr/>
            </p:nvSpPr>
            <p:spPr bwMode="auto">
              <a:xfrm>
                <a:off x="4873563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5" name="Rectangle 169"/>
              <p:cNvSpPr>
                <a:spLocks noChangeArrowheads="1"/>
              </p:cNvSpPr>
              <p:nvPr/>
            </p:nvSpPr>
            <p:spPr bwMode="auto">
              <a:xfrm>
                <a:off x="5197273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6" name="Rectangle 170"/>
              <p:cNvSpPr>
                <a:spLocks noChangeArrowheads="1"/>
              </p:cNvSpPr>
              <p:nvPr/>
            </p:nvSpPr>
            <p:spPr bwMode="auto">
              <a:xfrm>
                <a:off x="5520983" y="22491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7" name="Line 171"/>
              <p:cNvSpPr>
                <a:spLocks noChangeShapeType="1"/>
              </p:cNvSpPr>
              <p:nvPr/>
            </p:nvSpPr>
            <p:spPr bwMode="auto">
              <a:xfrm flipV="1">
                <a:off x="3635670" y="822401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Line 172"/>
              <p:cNvSpPr>
                <a:spLocks noChangeShapeType="1"/>
              </p:cNvSpPr>
              <p:nvPr/>
            </p:nvSpPr>
            <p:spPr bwMode="auto">
              <a:xfrm flipH="1">
                <a:off x="3599702" y="2104855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Line 173"/>
              <p:cNvSpPr>
                <a:spLocks noChangeShapeType="1"/>
              </p:cNvSpPr>
              <p:nvPr/>
            </p:nvSpPr>
            <p:spPr bwMode="auto">
              <a:xfrm flipH="1">
                <a:off x="3599702" y="184489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Line 174"/>
              <p:cNvSpPr>
                <a:spLocks noChangeShapeType="1"/>
              </p:cNvSpPr>
              <p:nvPr/>
            </p:nvSpPr>
            <p:spPr bwMode="auto">
              <a:xfrm flipH="1">
                <a:off x="3599702" y="1593606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Line 175"/>
              <p:cNvSpPr>
                <a:spLocks noChangeShapeType="1"/>
              </p:cNvSpPr>
              <p:nvPr/>
            </p:nvSpPr>
            <p:spPr bwMode="auto">
              <a:xfrm flipH="1">
                <a:off x="3599702" y="1333649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Line 176"/>
              <p:cNvSpPr>
                <a:spLocks noChangeShapeType="1"/>
              </p:cNvSpPr>
              <p:nvPr/>
            </p:nvSpPr>
            <p:spPr bwMode="auto">
              <a:xfrm flipH="1">
                <a:off x="3599702" y="108235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Line 177"/>
              <p:cNvSpPr>
                <a:spLocks noChangeShapeType="1"/>
              </p:cNvSpPr>
              <p:nvPr/>
            </p:nvSpPr>
            <p:spPr bwMode="auto">
              <a:xfrm flipH="1">
                <a:off x="3599702" y="82240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Rectangle 178"/>
              <p:cNvSpPr>
                <a:spLocks noChangeArrowheads="1"/>
              </p:cNvSpPr>
              <p:nvPr/>
            </p:nvSpPr>
            <p:spPr bwMode="auto">
              <a:xfrm>
                <a:off x="3425858" y="2037779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5" name="Rectangle 179"/>
              <p:cNvSpPr>
                <a:spLocks noChangeArrowheads="1"/>
              </p:cNvSpPr>
              <p:nvPr/>
            </p:nvSpPr>
            <p:spPr bwMode="auto">
              <a:xfrm>
                <a:off x="3425858" y="1786487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6" name="Rectangle 180"/>
              <p:cNvSpPr>
                <a:spLocks noChangeArrowheads="1"/>
              </p:cNvSpPr>
              <p:nvPr/>
            </p:nvSpPr>
            <p:spPr bwMode="auto">
              <a:xfrm>
                <a:off x="3425858" y="152653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7" name="Rectangle 181"/>
              <p:cNvSpPr>
                <a:spLocks noChangeArrowheads="1"/>
              </p:cNvSpPr>
              <p:nvPr/>
            </p:nvSpPr>
            <p:spPr bwMode="auto">
              <a:xfrm>
                <a:off x="3425858" y="127523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8" name="Rectangle 182"/>
              <p:cNvSpPr>
                <a:spLocks noChangeArrowheads="1"/>
              </p:cNvSpPr>
              <p:nvPr/>
            </p:nvSpPr>
            <p:spPr bwMode="auto">
              <a:xfrm>
                <a:off x="3425858" y="1015282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9" name="Rectangle 183"/>
              <p:cNvSpPr>
                <a:spLocks noChangeArrowheads="1"/>
              </p:cNvSpPr>
              <p:nvPr/>
            </p:nvSpPr>
            <p:spPr bwMode="auto">
              <a:xfrm>
                <a:off x="3425858" y="76399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0" name="Rectangle 185"/>
              <p:cNvSpPr>
                <a:spLocks noChangeArrowheads="1"/>
              </p:cNvSpPr>
              <p:nvPr/>
            </p:nvSpPr>
            <p:spPr bwMode="auto">
              <a:xfrm>
                <a:off x="4233790" y="569596"/>
                <a:ext cx="1051570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Collisson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(N=27)</a:t>
                </a:r>
                <a:endParaRPr kumimoji="0" lang="fr-FR" altLang="fr-FR" sz="10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4" name="Freeform 189"/>
              <p:cNvSpPr>
                <a:spLocks/>
              </p:cNvSpPr>
              <p:nvPr/>
            </p:nvSpPr>
            <p:spPr bwMode="auto">
              <a:xfrm>
                <a:off x="3635670" y="822401"/>
                <a:ext cx="1942261" cy="953175"/>
              </a:xfrm>
              <a:custGeom>
                <a:avLst/>
                <a:gdLst>
                  <a:gd name="T0" fmla="*/ 0 w 324"/>
                  <a:gd name="T1" fmla="*/ 0 h 110"/>
                  <a:gd name="T2" fmla="*/ 4 w 324"/>
                  <a:gd name="T3" fmla="*/ 0 h 110"/>
                  <a:gd name="T4" fmla="*/ 4 w 324"/>
                  <a:gd name="T5" fmla="*/ 8 h 110"/>
                  <a:gd name="T6" fmla="*/ 12 w 324"/>
                  <a:gd name="T7" fmla="*/ 8 h 110"/>
                  <a:gd name="T8" fmla="*/ 12 w 324"/>
                  <a:gd name="T9" fmla="*/ 15 h 110"/>
                  <a:gd name="T10" fmla="*/ 17 w 324"/>
                  <a:gd name="T11" fmla="*/ 15 h 110"/>
                  <a:gd name="T12" fmla="*/ 17 w 324"/>
                  <a:gd name="T13" fmla="*/ 23 h 110"/>
                  <a:gd name="T14" fmla="*/ 36 w 324"/>
                  <a:gd name="T15" fmla="*/ 23 h 110"/>
                  <a:gd name="T16" fmla="*/ 36 w 324"/>
                  <a:gd name="T17" fmla="*/ 30 h 110"/>
                  <a:gd name="T18" fmla="*/ 42 w 324"/>
                  <a:gd name="T19" fmla="*/ 30 h 110"/>
                  <a:gd name="T20" fmla="*/ 42 w 324"/>
                  <a:gd name="T21" fmla="*/ 38 h 110"/>
                  <a:gd name="T22" fmla="*/ 61 w 324"/>
                  <a:gd name="T23" fmla="*/ 38 h 110"/>
                  <a:gd name="T24" fmla="*/ 61 w 324"/>
                  <a:gd name="T25" fmla="*/ 46 h 110"/>
                  <a:gd name="T26" fmla="*/ 88 w 324"/>
                  <a:gd name="T27" fmla="*/ 46 h 110"/>
                  <a:gd name="T28" fmla="*/ 88 w 324"/>
                  <a:gd name="T29" fmla="*/ 54 h 110"/>
                  <a:gd name="T30" fmla="*/ 102 w 324"/>
                  <a:gd name="T31" fmla="*/ 54 h 110"/>
                  <a:gd name="T32" fmla="*/ 102 w 324"/>
                  <a:gd name="T33" fmla="*/ 62 h 110"/>
                  <a:gd name="T34" fmla="*/ 102 w 324"/>
                  <a:gd name="T35" fmla="*/ 62 h 110"/>
                  <a:gd name="T36" fmla="*/ 102 w 324"/>
                  <a:gd name="T37" fmla="*/ 70 h 110"/>
                  <a:gd name="T38" fmla="*/ 112 w 324"/>
                  <a:gd name="T39" fmla="*/ 70 h 110"/>
                  <a:gd name="T40" fmla="*/ 112 w 324"/>
                  <a:gd name="T41" fmla="*/ 77 h 110"/>
                  <a:gd name="T42" fmla="*/ 115 w 324"/>
                  <a:gd name="T43" fmla="*/ 77 h 110"/>
                  <a:gd name="T44" fmla="*/ 115 w 324"/>
                  <a:gd name="T45" fmla="*/ 85 h 110"/>
                  <a:gd name="T46" fmla="*/ 117 w 324"/>
                  <a:gd name="T47" fmla="*/ 85 h 110"/>
                  <a:gd name="T48" fmla="*/ 117 w 324"/>
                  <a:gd name="T49" fmla="*/ 93 h 110"/>
                  <a:gd name="T50" fmla="*/ 150 w 324"/>
                  <a:gd name="T51" fmla="*/ 93 h 110"/>
                  <a:gd name="T52" fmla="*/ 150 w 324"/>
                  <a:gd name="T53" fmla="*/ 101 h 110"/>
                  <a:gd name="T54" fmla="*/ 200 w 324"/>
                  <a:gd name="T55" fmla="*/ 101 h 110"/>
                  <a:gd name="T56" fmla="*/ 200 w 324"/>
                  <a:gd name="T57" fmla="*/ 110 h 110"/>
                  <a:gd name="T58" fmla="*/ 324 w 324"/>
                  <a:gd name="T59" fmla="*/ 110 h 110"/>
                  <a:gd name="T60" fmla="*/ 324 w 324"/>
                  <a:gd name="T61" fmla="*/ 11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324" h="110">
                    <a:moveTo>
                      <a:pt x="0" y="0"/>
                    </a:moveTo>
                    <a:lnTo>
                      <a:pt x="4" y="0"/>
                    </a:lnTo>
                    <a:lnTo>
                      <a:pt x="4" y="8"/>
                    </a:lnTo>
                    <a:lnTo>
                      <a:pt x="12" y="8"/>
                    </a:lnTo>
                    <a:lnTo>
                      <a:pt x="12" y="15"/>
                    </a:lnTo>
                    <a:lnTo>
                      <a:pt x="17" y="15"/>
                    </a:lnTo>
                    <a:lnTo>
                      <a:pt x="17" y="23"/>
                    </a:lnTo>
                    <a:lnTo>
                      <a:pt x="36" y="23"/>
                    </a:lnTo>
                    <a:lnTo>
                      <a:pt x="36" y="30"/>
                    </a:lnTo>
                    <a:lnTo>
                      <a:pt x="42" y="30"/>
                    </a:lnTo>
                    <a:lnTo>
                      <a:pt x="42" y="38"/>
                    </a:lnTo>
                    <a:lnTo>
                      <a:pt x="61" y="38"/>
                    </a:lnTo>
                    <a:lnTo>
                      <a:pt x="61" y="46"/>
                    </a:lnTo>
                    <a:lnTo>
                      <a:pt x="88" y="46"/>
                    </a:lnTo>
                    <a:lnTo>
                      <a:pt x="88" y="54"/>
                    </a:lnTo>
                    <a:lnTo>
                      <a:pt x="102" y="54"/>
                    </a:lnTo>
                    <a:lnTo>
                      <a:pt x="102" y="62"/>
                    </a:lnTo>
                    <a:lnTo>
                      <a:pt x="102" y="62"/>
                    </a:lnTo>
                    <a:lnTo>
                      <a:pt x="102" y="70"/>
                    </a:lnTo>
                    <a:lnTo>
                      <a:pt x="112" y="70"/>
                    </a:lnTo>
                    <a:lnTo>
                      <a:pt x="112" y="77"/>
                    </a:lnTo>
                    <a:lnTo>
                      <a:pt x="115" y="77"/>
                    </a:lnTo>
                    <a:lnTo>
                      <a:pt x="115" y="85"/>
                    </a:lnTo>
                    <a:lnTo>
                      <a:pt x="117" y="85"/>
                    </a:lnTo>
                    <a:lnTo>
                      <a:pt x="117" y="93"/>
                    </a:lnTo>
                    <a:lnTo>
                      <a:pt x="150" y="93"/>
                    </a:lnTo>
                    <a:lnTo>
                      <a:pt x="150" y="101"/>
                    </a:lnTo>
                    <a:lnTo>
                      <a:pt x="200" y="101"/>
                    </a:lnTo>
                    <a:lnTo>
                      <a:pt x="200" y="110"/>
                    </a:lnTo>
                    <a:lnTo>
                      <a:pt x="324" y="110"/>
                    </a:lnTo>
                    <a:lnTo>
                      <a:pt x="324" y="110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Freeform 190"/>
              <p:cNvSpPr>
                <a:spLocks/>
              </p:cNvSpPr>
              <p:nvPr/>
            </p:nvSpPr>
            <p:spPr bwMode="auto">
              <a:xfrm>
                <a:off x="3635670" y="822401"/>
                <a:ext cx="989115" cy="1282454"/>
              </a:xfrm>
              <a:custGeom>
                <a:avLst/>
                <a:gdLst>
                  <a:gd name="T0" fmla="*/ 0 w 165"/>
                  <a:gd name="T1" fmla="*/ 0 h 148"/>
                  <a:gd name="T2" fmla="*/ 8 w 165"/>
                  <a:gd name="T3" fmla="*/ 0 h 148"/>
                  <a:gd name="T4" fmla="*/ 8 w 165"/>
                  <a:gd name="T5" fmla="*/ 21 h 148"/>
                  <a:gd name="T6" fmla="*/ 26 w 165"/>
                  <a:gd name="T7" fmla="*/ 21 h 148"/>
                  <a:gd name="T8" fmla="*/ 26 w 165"/>
                  <a:gd name="T9" fmla="*/ 43 h 148"/>
                  <a:gd name="T10" fmla="*/ 26 w 165"/>
                  <a:gd name="T11" fmla="*/ 43 h 148"/>
                  <a:gd name="T12" fmla="*/ 26 w 165"/>
                  <a:gd name="T13" fmla="*/ 64 h 148"/>
                  <a:gd name="T14" fmla="*/ 36 w 165"/>
                  <a:gd name="T15" fmla="*/ 64 h 148"/>
                  <a:gd name="T16" fmla="*/ 36 w 165"/>
                  <a:gd name="T17" fmla="*/ 92 h 148"/>
                  <a:gd name="T18" fmla="*/ 84 w 165"/>
                  <a:gd name="T19" fmla="*/ 92 h 148"/>
                  <a:gd name="T20" fmla="*/ 84 w 165"/>
                  <a:gd name="T21" fmla="*/ 120 h 148"/>
                  <a:gd name="T22" fmla="*/ 165 w 165"/>
                  <a:gd name="T23" fmla="*/ 120 h 148"/>
                  <a:gd name="T24" fmla="*/ 165 w 165"/>
                  <a:gd name="T25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165" h="148">
                    <a:moveTo>
                      <a:pt x="0" y="0"/>
                    </a:moveTo>
                    <a:lnTo>
                      <a:pt x="8" y="0"/>
                    </a:lnTo>
                    <a:lnTo>
                      <a:pt x="8" y="21"/>
                    </a:lnTo>
                    <a:lnTo>
                      <a:pt x="26" y="21"/>
                    </a:lnTo>
                    <a:lnTo>
                      <a:pt x="26" y="43"/>
                    </a:lnTo>
                    <a:lnTo>
                      <a:pt x="26" y="43"/>
                    </a:lnTo>
                    <a:lnTo>
                      <a:pt x="26" y="64"/>
                    </a:lnTo>
                    <a:lnTo>
                      <a:pt x="36" y="64"/>
                    </a:lnTo>
                    <a:lnTo>
                      <a:pt x="36" y="92"/>
                    </a:lnTo>
                    <a:lnTo>
                      <a:pt x="84" y="92"/>
                    </a:lnTo>
                    <a:lnTo>
                      <a:pt x="84" y="120"/>
                    </a:lnTo>
                    <a:lnTo>
                      <a:pt x="165" y="120"/>
                    </a:lnTo>
                    <a:lnTo>
                      <a:pt x="165" y="148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Rectangle 191"/>
              <p:cNvSpPr>
                <a:spLocks noChangeArrowheads="1"/>
              </p:cNvSpPr>
              <p:nvPr/>
            </p:nvSpPr>
            <p:spPr bwMode="auto">
              <a:xfrm>
                <a:off x="3723754" y="1957790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582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7" name="Rectangle 192"/>
              <p:cNvSpPr>
                <a:spLocks noChangeArrowheads="1"/>
              </p:cNvSpPr>
              <p:nvPr/>
            </p:nvSpPr>
            <p:spPr bwMode="auto">
              <a:xfrm>
                <a:off x="4715534" y="1148699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8" name="Rectangle 193"/>
              <p:cNvSpPr>
                <a:spLocks noChangeArrowheads="1"/>
              </p:cNvSpPr>
              <p:nvPr/>
            </p:nvSpPr>
            <p:spPr bwMode="auto">
              <a:xfrm>
                <a:off x="3662184" y="1671712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9" name="Line 194"/>
              <p:cNvSpPr>
                <a:spLocks noChangeShapeType="1"/>
              </p:cNvSpPr>
              <p:nvPr/>
            </p:nvSpPr>
            <p:spPr bwMode="auto">
              <a:xfrm>
                <a:off x="6393403" y="2155947"/>
                <a:ext cx="19422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Line 195"/>
              <p:cNvSpPr>
                <a:spLocks noChangeShapeType="1"/>
              </p:cNvSpPr>
              <p:nvPr/>
            </p:nvSpPr>
            <p:spPr bwMode="auto">
              <a:xfrm>
                <a:off x="6393403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Line 196"/>
              <p:cNvSpPr>
                <a:spLocks noChangeShapeType="1"/>
              </p:cNvSpPr>
              <p:nvPr/>
            </p:nvSpPr>
            <p:spPr bwMode="auto">
              <a:xfrm>
                <a:off x="6717114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Line 197"/>
              <p:cNvSpPr>
                <a:spLocks noChangeShapeType="1"/>
              </p:cNvSpPr>
              <p:nvPr/>
            </p:nvSpPr>
            <p:spPr bwMode="auto">
              <a:xfrm>
                <a:off x="7040824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Line 198"/>
              <p:cNvSpPr>
                <a:spLocks noChangeShapeType="1"/>
              </p:cNvSpPr>
              <p:nvPr/>
            </p:nvSpPr>
            <p:spPr bwMode="auto">
              <a:xfrm>
                <a:off x="7364534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Line 199"/>
              <p:cNvSpPr>
                <a:spLocks noChangeShapeType="1"/>
              </p:cNvSpPr>
              <p:nvPr/>
            </p:nvSpPr>
            <p:spPr bwMode="auto">
              <a:xfrm>
                <a:off x="7688244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Line 200"/>
              <p:cNvSpPr>
                <a:spLocks noChangeShapeType="1"/>
              </p:cNvSpPr>
              <p:nvPr/>
            </p:nvSpPr>
            <p:spPr bwMode="auto">
              <a:xfrm>
                <a:off x="8011955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Line 201"/>
              <p:cNvSpPr>
                <a:spLocks noChangeShapeType="1"/>
              </p:cNvSpPr>
              <p:nvPr/>
            </p:nvSpPr>
            <p:spPr bwMode="auto">
              <a:xfrm>
                <a:off x="8335665" y="2155947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Rectangle 202"/>
              <p:cNvSpPr>
                <a:spLocks noChangeArrowheads="1"/>
              </p:cNvSpPr>
              <p:nvPr/>
            </p:nvSpPr>
            <p:spPr bwMode="auto">
              <a:xfrm>
                <a:off x="6354438" y="2248232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8" name="Rectangle 203"/>
              <p:cNvSpPr>
                <a:spLocks noChangeArrowheads="1"/>
              </p:cNvSpPr>
              <p:nvPr/>
            </p:nvSpPr>
            <p:spPr bwMode="auto">
              <a:xfrm>
                <a:off x="6660166" y="22482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9" name="Rectangle 204"/>
              <p:cNvSpPr>
                <a:spLocks noChangeArrowheads="1"/>
              </p:cNvSpPr>
              <p:nvPr/>
            </p:nvSpPr>
            <p:spPr bwMode="auto">
              <a:xfrm>
                <a:off x="6983874" y="22482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0" name="Rectangle 205"/>
              <p:cNvSpPr>
                <a:spLocks noChangeArrowheads="1"/>
              </p:cNvSpPr>
              <p:nvPr/>
            </p:nvSpPr>
            <p:spPr bwMode="auto">
              <a:xfrm>
                <a:off x="7307584" y="22482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1" name="Rectangle 206"/>
              <p:cNvSpPr>
                <a:spLocks noChangeArrowheads="1"/>
              </p:cNvSpPr>
              <p:nvPr/>
            </p:nvSpPr>
            <p:spPr bwMode="auto">
              <a:xfrm>
                <a:off x="7631296" y="22482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2" name="Rectangle 207"/>
              <p:cNvSpPr>
                <a:spLocks noChangeArrowheads="1"/>
              </p:cNvSpPr>
              <p:nvPr/>
            </p:nvSpPr>
            <p:spPr bwMode="auto">
              <a:xfrm>
                <a:off x="7955006" y="22482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3" name="Rectangle 208"/>
              <p:cNvSpPr>
                <a:spLocks noChangeArrowheads="1"/>
              </p:cNvSpPr>
              <p:nvPr/>
            </p:nvSpPr>
            <p:spPr bwMode="auto">
              <a:xfrm>
                <a:off x="8278717" y="2248232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4" name="Line 209"/>
              <p:cNvSpPr>
                <a:spLocks noChangeShapeType="1"/>
              </p:cNvSpPr>
              <p:nvPr/>
            </p:nvSpPr>
            <p:spPr bwMode="auto">
              <a:xfrm flipV="1">
                <a:off x="6393403" y="821501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Line 210"/>
              <p:cNvSpPr>
                <a:spLocks noChangeShapeType="1"/>
              </p:cNvSpPr>
              <p:nvPr/>
            </p:nvSpPr>
            <p:spPr bwMode="auto">
              <a:xfrm flipH="1">
                <a:off x="6357436" y="2103955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Line 211"/>
              <p:cNvSpPr>
                <a:spLocks noChangeShapeType="1"/>
              </p:cNvSpPr>
              <p:nvPr/>
            </p:nvSpPr>
            <p:spPr bwMode="auto">
              <a:xfrm flipH="1">
                <a:off x="6357436" y="184399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Line 212"/>
              <p:cNvSpPr>
                <a:spLocks noChangeShapeType="1"/>
              </p:cNvSpPr>
              <p:nvPr/>
            </p:nvSpPr>
            <p:spPr bwMode="auto">
              <a:xfrm flipH="1">
                <a:off x="6357436" y="1592707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Line 213"/>
              <p:cNvSpPr>
                <a:spLocks noChangeShapeType="1"/>
              </p:cNvSpPr>
              <p:nvPr/>
            </p:nvSpPr>
            <p:spPr bwMode="auto">
              <a:xfrm flipH="1">
                <a:off x="6357436" y="1332749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Line 214"/>
              <p:cNvSpPr>
                <a:spLocks noChangeShapeType="1"/>
              </p:cNvSpPr>
              <p:nvPr/>
            </p:nvSpPr>
            <p:spPr bwMode="auto">
              <a:xfrm flipH="1">
                <a:off x="6357436" y="1081457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Line 215"/>
              <p:cNvSpPr>
                <a:spLocks noChangeShapeType="1"/>
              </p:cNvSpPr>
              <p:nvPr/>
            </p:nvSpPr>
            <p:spPr bwMode="auto">
              <a:xfrm flipH="1">
                <a:off x="6357436" y="82150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Rectangle 216"/>
              <p:cNvSpPr>
                <a:spLocks noChangeArrowheads="1"/>
              </p:cNvSpPr>
              <p:nvPr/>
            </p:nvSpPr>
            <p:spPr bwMode="auto">
              <a:xfrm>
                <a:off x="6183591" y="2036879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2" name="Rectangle 217"/>
              <p:cNvSpPr>
                <a:spLocks noChangeArrowheads="1"/>
              </p:cNvSpPr>
              <p:nvPr/>
            </p:nvSpPr>
            <p:spPr bwMode="auto">
              <a:xfrm>
                <a:off x="6183591" y="178558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3" name="Rectangle 218"/>
              <p:cNvSpPr>
                <a:spLocks noChangeArrowheads="1"/>
              </p:cNvSpPr>
              <p:nvPr/>
            </p:nvSpPr>
            <p:spPr bwMode="auto">
              <a:xfrm>
                <a:off x="6183591" y="1525631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4" name="Rectangle 219"/>
              <p:cNvSpPr>
                <a:spLocks noChangeArrowheads="1"/>
              </p:cNvSpPr>
              <p:nvPr/>
            </p:nvSpPr>
            <p:spPr bwMode="auto">
              <a:xfrm>
                <a:off x="6183591" y="127433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5" name="Rectangle 220"/>
              <p:cNvSpPr>
                <a:spLocks noChangeArrowheads="1"/>
              </p:cNvSpPr>
              <p:nvPr/>
            </p:nvSpPr>
            <p:spPr bwMode="auto">
              <a:xfrm>
                <a:off x="6183591" y="1014381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6" name="Rectangle 221"/>
              <p:cNvSpPr>
                <a:spLocks noChangeArrowheads="1"/>
              </p:cNvSpPr>
              <p:nvPr/>
            </p:nvSpPr>
            <p:spPr bwMode="auto">
              <a:xfrm>
                <a:off x="6183591" y="76309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7" name="Rectangle 223"/>
              <p:cNvSpPr>
                <a:spLocks noChangeArrowheads="1"/>
              </p:cNvSpPr>
              <p:nvPr/>
            </p:nvSpPr>
            <p:spPr bwMode="auto">
              <a:xfrm>
                <a:off x="7072840" y="568696"/>
                <a:ext cx="780662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lvl="0" algn="ctr"/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Kirby</a:t>
                </a:r>
                <a:r>
                  <a:rPr lang="fr-FR" altLang="fr-FR" sz="1000" dirty="0">
                    <a:solidFill>
                      <a:srgbClr val="000000"/>
                    </a:solidFill>
                  </a:rPr>
                  <a:t> (</a:t>
                </a:r>
                <a:r>
                  <a:rPr lang="fr-FR" altLang="fr-FR" sz="1000" dirty="0" smtClean="0">
                    <a:solidFill>
                      <a:srgbClr val="000000"/>
                    </a:solidFill>
                  </a:rPr>
                  <a:t>N=51)</a:t>
                </a:r>
                <a:endParaRPr kumimoji="0" lang="fr-FR" altLang="fr-FR" sz="1000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81" name="Freeform 227"/>
              <p:cNvSpPr>
                <a:spLocks/>
              </p:cNvSpPr>
              <p:nvPr/>
            </p:nvSpPr>
            <p:spPr bwMode="auto">
              <a:xfrm>
                <a:off x="6393403" y="821501"/>
                <a:ext cx="1942263" cy="1091819"/>
              </a:xfrm>
              <a:custGeom>
                <a:avLst/>
                <a:gdLst>
                  <a:gd name="T0" fmla="*/ 0 w 324"/>
                  <a:gd name="T1" fmla="*/ 0 h 126"/>
                  <a:gd name="T2" fmla="*/ 6 w 324"/>
                  <a:gd name="T3" fmla="*/ 0 h 126"/>
                  <a:gd name="T4" fmla="*/ 6 w 324"/>
                  <a:gd name="T5" fmla="*/ 5 h 126"/>
                  <a:gd name="T6" fmla="*/ 7 w 324"/>
                  <a:gd name="T7" fmla="*/ 5 h 126"/>
                  <a:gd name="T8" fmla="*/ 7 w 324"/>
                  <a:gd name="T9" fmla="*/ 10 h 126"/>
                  <a:gd name="T10" fmla="*/ 36 w 324"/>
                  <a:gd name="T11" fmla="*/ 10 h 126"/>
                  <a:gd name="T12" fmla="*/ 36 w 324"/>
                  <a:gd name="T13" fmla="*/ 14 h 126"/>
                  <a:gd name="T14" fmla="*/ 40 w 324"/>
                  <a:gd name="T15" fmla="*/ 14 h 126"/>
                  <a:gd name="T16" fmla="*/ 40 w 324"/>
                  <a:gd name="T17" fmla="*/ 19 h 126"/>
                  <a:gd name="T18" fmla="*/ 50 w 324"/>
                  <a:gd name="T19" fmla="*/ 19 h 126"/>
                  <a:gd name="T20" fmla="*/ 50 w 324"/>
                  <a:gd name="T21" fmla="*/ 23 h 126"/>
                  <a:gd name="T22" fmla="*/ 52 w 324"/>
                  <a:gd name="T23" fmla="*/ 23 h 126"/>
                  <a:gd name="T24" fmla="*/ 52 w 324"/>
                  <a:gd name="T25" fmla="*/ 28 h 126"/>
                  <a:gd name="T26" fmla="*/ 56 w 324"/>
                  <a:gd name="T27" fmla="*/ 28 h 126"/>
                  <a:gd name="T28" fmla="*/ 56 w 324"/>
                  <a:gd name="T29" fmla="*/ 33 h 126"/>
                  <a:gd name="T30" fmla="*/ 70 w 324"/>
                  <a:gd name="T31" fmla="*/ 33 h 126"/>
                  <a:gd name="T32" fmla="*/ 70 w 324"/>
                  <a:gd name="T33" fmla="*/ 37 h 126"/>
                  <a:gd name="T34" fmla="*/ 77 w 324"/>
                  <a:gd name="T35" fmla="*/ 37 h 126"/>
                  <a:gd name="T36" fmla="*/ 77 w 324"/>
                  <a:gd name="T37" fmla="*/ 42 h 126"/>
                  <a:gd name="T38" fmla="*/ 85 w 324"/>
                  <a:gd name="T39" fmla="*/ 42 h 126"/>
                  <a:gd name="T40" fmla="*/ 85 w 324"/>
                  <a:gd name="T41" fmla="*/ 46 h 126"/>
                  <a:gd name="T42" fmla="*/ 97 w 324"/>
                  <a:gd name="T43" fmla="*/ 46 h 126"/>
                  <a:gd name="T44" fmla="*/ 97 w 324"/>
                  <a:gd name="T45" fmla="*/ 51 h 126"/>
                  <a:gd name="T46" fmla="*/ 98 w 324"/>
                  <a:gd name="T47" fmla="*/ 51 h 126"/>
                  <a:gd name="T48" fmla="*/ 98 w 324"/>
                  <a:gd name="T49" fmla="*/ 56 h 126"/>
                  <a:gd name="T50" fmla="*/ 99 w 324"/>
                  <a:gd name="T51" fmla="*/ 56 h 126"/>
                  <a:gd name="T52" fmla="*/ 99 w 324"/>
                  <a:gd name="T53" fmla="*/ 60 h 126"/>
                  <a:gd name="T54" fmla="*/ 105 w 324"/>
                  <a:gd name="T55" fmla="*/ 60 h 126"/>
                  <a:gd name="T56" fmla="*/ 105 w 324"/>
                  <a:gd name="T57" fmla="*/ 65 h 126"/>
                  <a:gd name="T58" fmla="*/ 105 w 324"/>
                  <a:gd name="T59" fmla="*/ 65 h 126"/>
                  <a:gd name="T60" fmla="*/ 105 w 324"/>
                  <a:gd name="T61" fmla="*/ 70 h 126"/>
                  <a:gd name="T62" fmla="*/ 115 w 324"/>
                  <a:gd name="T63" fmla="*/ 70 h 126"/>
                  <a:gd name="T64" fmla="*/ 115 w 324"/>
                  <a:gd name="T65" fmla="*/ 74 h 126"/>
                  <a:gd name="T66" fmla="*/ 124 w 324"/>
                  <a:gd name="T67" fmla="*/ 74 h 126"/>
                  <a:gd name="T68" fmla="*/ 124 w 324"/>
                  <a:gd name="T69" fmla="*/ 79 h 126"/>
                  <a:gd name="T70" fmla="*/ 125 w 324"/>
                  <a:gd name="T71" fmla="*/ 79 h 126"/>
                  <a:gd name="T72" fmla="*/ 125 w 324"/>
                  <a:gd name="T73" fmla="*/ 83 h 126"/>
                  <a:gd name="T74" fmla="*/ 130 w 324"/>
                  <a:gd name="T75" fmla="*/ 83 h 126"/>
                  <a:gd name="T76" fmla="*/ 130 w 324"/>
                  <a:gd name="T77" fmla="*/ 88 h 126"/>
                  <a:gd name="T78" fmla="*/ 132 w 324"/>
                  <a:gd name="T79" fmla="*/ 88 h 126"/>
                  <a:gd name="T80" fmla="*/ 132 w 324"/>
                  <a:gd name="T81" fmla="*/ 93 h 126"/>
                  <a:gd name="T82" fmla="*/ 144 w 324"/>
                  <a:gd name="T83" fmla="*/ 93 h 126"/>
                  <a:gd name="T84" fmla="*/ 144 w 324"/>
                  <a:gd name="T85" fmla="*/ 97 h 126"/>
                  <a:gd name="T86" fmla="*/ 173 w 324"/>
                  <a:gd name="T87" fmla="*/ 97 h 126"/>
                  <a:gd name="T88" fmla="*/ 173 w 324"/>
                  <a:gd name="T89" fmla="*/ 102 h 126"/>
                  <a:gd name="T90" fmla="*/ 198 w 324"/>
                  <a:gd name="T91" fmla="*/ 102 h 126"/>
                  <a:gd name="T92" fmla="*/ 198 w 324"/>
                  <a:gd name="T93" fmla="*/ 106 h 126"/>
                  <a:gd name="T94" fmla="*/ 218 w 324"/>
                  <a:gd name="T95" fmla="*/ 106 h 126"/>
                  <a:gd name="T96" fmla="*/ 218 w 324"/>
                  <a:gd name="T97" fmla="*/ 111 h 126"/>
                  <a:gd name="T98" fmla="*/ 274 w 324"/>
                  <a:gd name="T99" fmla="*/ 111 h 126"/>
                  <a:gd name="T100" fmla="*/ 274 w 324"/>
                  <a:gd name="T101" fmla="*/ 118 h 126"/>
                  <a:gd name="T102" fmla="*/ 276 w 324"/>
                  <a:gd name="T103" fmla="*/ 118 h 126"/>
                  <a:gd name="T104" fmla="*/ 276 w 324"/>
                  <a:gd name="T105" fmla="*/ 126 h 126"/>
                  <a:gd name="T106" fmla="*/ 324 w 324"/>
                  <a:gd name="T107" fmla="*/ 126 h 126"/>
                  <a:gd name="T108" fmla="*/ 324 w 324"/>
                  <a:gd name="T109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</a:cxnLst>
                <a:rect l="0" t="0" r="r" b="b"/>
                <a:pathLst>
                  <a:path w="324" h="126">
                    <a:moveTo>
                      <a:pt x="0" y="0"/>
                    </a:moveTo>
                    <a:lnTo>
                      <a:pt x="6" y="0"/>
                    </a:lnTo>
                    <a:lnTo>
                      <a:pt x="6" y="5"/>
                    </a:lnTo>
                    <a:lnTo>
                      <a:pt x="7" y="5"/>
                    </a:lnTo>
                    <a:lnTo>
                      <a:pt x="7" y="10"/>
                    </a:lnTo>
                    <a:lnTo>
                      <a:pt x="36" y="10"/>
                    </a:lnTo>
                    <a:lnTo>
                      <a:pt x="36" y="14"/>
                    </a:lnTo>
                    <a:lnTo>
                      <a:pt x="40" y="14"/>
                    </a:lnTo>
                    <a:lnTo>
                      <a:pt x="40" y="19"/>
                    </a:lnTo>
                    <a:lnTo>
                      <a:pt x="50" y="19"/>
                    </a:lnTo>
                    <a:lnTo>
                      <a:pt x="50" y="23"/>
                    </a:lnTo>
                    <a:lnTo>
                      <a:pt x="52" y="23"/>
                    </a:lnTo>
                    <a:lnTo>
                      <a:pt x="52" y="28"/>
                    </a:lnTo>
                    <a:lnTo>
                      <a:pt x="56" y="28"/>
                    </a:lnTo>
                    <a:lnTo>
                      <a:pt x="56" y="33"/>
                    </a:lnTo>
                    <a:lnTo>
                      <a:pt x="70" y="33"/>
                    </a:lnTo>
                    <a:lnTo>
                      <a:pt x="70" y="37"/>
                    </a:lnTo>
                    <a:lnTo>
                      <a:pt x="77" y="37"/>
                    </a:lnTo>
                    <a:lnTo>
                      <a:pt x="77" y="42"/>
                    </a:lnTo>
                    <a:lnTo>
                      <a:pt x="85" y="42"/>
                    </a:lnTo>
                    <a:lnTo>
                      <a:pt x="85" y="46"/>
                    </a:lnTo>
                    <a:lnTo>
                      <a:pt x="97" y="46"/>
                    </a:lnTo>
                    <a:lnTo>
                      <a:pt x="97" y="51"/>
                    </a:lnTo>
                    <a:lnTo>
                      <a:pt x="98" y="51"/>
                    </a:lnTo>
                    <a:lnTo>
                      <a:pt x="98" y="56"/>
                    </a:lnTo>
                    <a:lnTo>
                      <a:pt x="99" y="56"/>
                    </a:lnTo>
                    <a:lnTo>
                      <a:pt x="99" y="60"/>
                    </a:lnTo>
                    <a:lnTo>
                      <a:pt x="105" y="60"/>
                    </a:lnTo>
                    <a:lnTo>
                      <a:pt x="105" y="65"/>
                    </a:lnTo>
                    <a:lnTo>
                      <a:pt x="105" y="65"/>
                    </a:lnTo>
                    <a:lnTo>
                      <a:pt x="105" y="70"/>
                    </a:lnTo>
                    <a:lnTo>
                      <a:pt x="115" y="70"/>
                    </a:lnTo>
                    <a:lnTo>
                      <a:pt x="115" y="74"/>
                    </a:lnTo>
                    <a:lnTo>
                      <a:pt x="124" y="74"/>
                    </a:lnTo>
                    <a:lnTo>
                      <a:pt x="124" y="79"/>
                    </a:lnTo>
                    <a:lnTo>
                      <a:pt x="125" y="79"/>
                    </a:lnTo>
                    <a:lnTo>
                      <a:pt x="125" y="83"/>
                    </a:lnTo>
                    <a:lnTo>
                      <a:pt x="130" y="83"/>
                    </a:lnTo>
                    <a:lnTo>
                      <a:pt x="130" y="88"/>
                    </a:lnTo>
                    <a:lnTo>
                      <a:pt x="132" y="88"/>
                    </a:lnTo>
                    <a:lnTo>
                      <a:pt x="132" y="93"/>
                    </a:lnTo>
                    <a:lnTo>
                      <a:pt x="144" y="93"/>
                    </a:lnTo>
                    <a:lnTo>
                      <a:pt x="144" y="97"/>
                    </a:lnTo>
                    <a:lnTo>
                      <a:pt x="173" y="97"/>
                    </a:lnTo>
                    <a:lnTo>
                      <a:pt x="173" y="102"/>
                    </a:lnTo>
                    <a:lnTo>
                      <a:pt x="198" y="102"/>
                    </a:lnTo>
                    <a:lnTo>
                      <a:pt x="198" y="106"/>
                    </a:lnTo>
                    <a:lnTo>
                      <a:pt x="218" y="106"/>
                    </a:lnTo>
                    <a:lnTo>
                      <a:pt x="218" y="111"/>
                    </a:lnTo>
                    <a:lnTo>
                      <a:pt x="274" y="111"/>
                    </a:lnTo>
                    <a:lnTo>
                      <a:pt x="274" y="118"/>
                    </a:lnTo>
                    <a:lnTo>
                      <a:pt x="276" y="118"/>
                    </a:lnTo>
                    <a:lnTo>
                      <a:pt x="276" y="126"/>
                    </a:lnTo>
                    <a:lnTo>
                      <a:pt x="324" y="126"/>
                    </a:lnTo>
                    <a:lnTo>
                      <a:pt x="324" y="126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Freeform 228"/>
              <p:cNvSpPr>
                <a:spLocks/>
              </p:cNvSpPr>
              <p:nvPr/>
            </p:nvSpPr>
            <p:spPr bwMode="auto">
              <a:xfrm>
                <a:off x="6393403" y="821501"/>
                <a:ext cx="1942263" cy="1213132"/>
              </a:xfrm>
              <a:custGeom>
                <a:avLst/>
                <a:gdLst>
                  <a:gd name="T0" fmla="*/ 0 w 324"/>
                  <a:gd name="T1" fmla="*/ 0 h 140"/>
                  <a:gd name="T2" fmla="*/ 12 w 324"/>
                  <a:gd name="T3" fmla="*/ 0 h 140"/>
                  <a:gd name="T4" fmla="*/ 12 w 324"/>
                  <a:gd name="T5" fmla="*/ 8 h 140"/>
                  <a:gd name="T6" fmla="*/ 29 w 324"/>
                  <a:gd name="T7" fmla="*/ 8 h 140"/>
                  <a:gd name="T8" fmla="*/ 29 w 324"/>
                  <a:gd name="T9" fmla="*/ 16 h 140"/>
                  <a:gd name="T10" fmla="*/ 34 w 324"/>
                  <a:gd name="T11" fmla="*/ 16 h 140"/>
                  <a:gd name="T12" fmla="*/ 34 w 324"/>
                  <a:gd name="T13" fmla="*/ 24 h 140"/>
                  <a:gd name="T14" fmla="*/ 38 w 324"/>
                  <a:gd name="T15" fmla="*/ 24 h 140"/>
                  <a:gd name="T16" fmla="*/ 38 w 324"/>
                  <a:gd name="T17" fmla="*/ 31 h 140"/>
                  <a:gd name="T18" fmla="*/ 42 w 324"/>
                  <a:gd name="T19" fmla="*/ 31 h 140"/>
                  <a:gd name="T20" fmla="*/ 42 w 324"/>
                  <a:gd name="T21" fmla="*/ 39 h 140"/>
                  <a:gd name="T22" fmla="*/ 44 w 324"/>
                  <a:gd name="T23" fmla="*/ 39 h 140"/>
                  <a:gd name="T24" fmla="*/ 44 w 324"/>
                  <a:gd name="T25" fmla="*/ 47 h 140"/>
                  <a:gd name="T26" fmla="*/ 46 w 324"/>
                  <a:gd name="T27" fmla="*/ 47 h 140"/>
                  <a:gd name="T28" fmla="*/ 46 w 324"/>
                  <a:gd name="T29" fmla="*/ 55 h 140"/>
                  <a:gd name="T30" fmla="*/ 52 w 324"/>
                  <a:gd name="T31" fmla="*/ 55 h 140"/>
                  <a:gd name="T32" fmla="*/ 52 w 324"/>
                  <a:gd name="T33" fmla="*/ 63 h 140"/>
                  <a:gd name="T34" fmla="*/ 66 w 324"/>
                  <a:gd name="T35" fmla="*/ 63 h 140"/>
                  <a:gd name="T36" fmla="*/ 66 w 324"/>
                  <a:gd name="T37" fmla="*/ 70 h 140"/>
                  <a:gd name="T38" fmla="*/ 76 w 324"/>
                  <a:gd name="T39" fmla="*/ 70 h 140"/>
                  <a:gd name="T40" fmla="*/ 76 w 324"/>
                  <a:gd name="T41" fmla="*/ 78 h 140"/>
                  <a:gd name="T42" fmla="*/ 80 w 324"/>
                  <a:gd name="T43" fmla="*/ 78 h 140"/>
                  <a:gd name="T44" fmla="*/ 80 w 324"/>
                  <a:gd name="T45" fmla="*/ 86 h 140"/>
                  <a:gd name="T46" fmla="*/ 100 w 324"/>
                  <a:gd name="T47" fmla="*/ 86 h 140"/>
                  <a:gd name="T48" fmla="*/ 100 w 324"/>
                  <a:gd name="T49" fmla="*/ 94 h 140"/>
                  <a:gd name="T50" fmla="*/ 102 w 324"/>
                  <a:gd name="T51" fmla="*/ 94 h 140"/>
                  <a:gd name="T52" fmla="*/ 102 w 324"/>
                  <a:gd name="T53" fmla="*/ 101 h 140"/>
                  <a:gd name="T54" fmla="*/ 109 w 324"/>
                  <a:gd name="T55" fmla="*/ 101 h 140"/>
                  <a:gd name="T56" fmla="*/ 109 w 324"/>
                  <a:gd name="T57" fmla="*/ 109 h 140"/>
                  <a:gd name="T58" fmla="*/ 110 w 324"/>
                  <a:gd name="T59" fmla="*/ 109 h 140"/>
                  <a:gd name="T60" fmla="*/ 110 w 324"/>
                  <a:gd name="T61" fmla="*/ 117 h 140"/>
                  <a:gd name="T62" fmla="*/ 112 w 324"/>
                  <a:gd name="T63" fmla="*/ 117 h 140"/>
                  <a:gd name="T64" fmla="*/ 112 w 324"/>
                  <a:gd name="T65" fmla="*/ 125 h 140"/>
                  <a:gd name="T66" fmla="*/ 114 w 324"/>
                  <a:gd name="T67" fmla="*/ 125 h 140"/>
                  <a:gd name="T68" fmla="*/ 114 w 324"/>
                  <a:gd name="T69" fmla="*/ 132 h 140"/>
                  <a:gd name="T70" fmla="*/ 277 w 324"/>
                  <a:gd name="T71" fmla="*/ 132 h 140"/>
                  <a:gd name="T72" fmla="*/ 277 w 324"/>
                  <a:gd name="T73" fmla="*/ 140 h 140"/>
                  <a:gd name="T74" fmla="*/ 324 w 324"/>
                  <a:gd name="T75" fmla="*/ 140 h 140"/>
                  <a:gd name="T76" fmla="*/ 324 w 324"/>
                  <a:gd name="T77" fmla="*/ 140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</a:cxnLst>
                <a:rect l="0" t="0" r="r" b="b"/>
                <a:pathLst>
                  <a:path w="324" h="140">
                    <a:moveTo>
                      <a:pt x="0" y="0"/>
                    </a:moveTo>
                    <a:lnTo>
                      <a:pt x="12" y="0"/>
                    </a:lnTo>
                    <a:lnTo>
                      <a:pt x="12" y="8"/>
                    </a:lnTo>
                    <a:lnTo>
                      <a:pt x="29" y="8"/>
                    </a:lnTo>
                    <a:lnTo>
                      <a:pt x="29" y="16"/>
                    </a:lnTo>
                    <a:lnTo>
                      <a:pt x="34" y="16"/>
                    </a:lnTo>
                    <a:lnTo>
                      <a:pt x="34" y="24"/>
                    </a:lnTo>
                    <a:lnTo>
                      <a:pt x="38" y="24"/>
                    </a:lnTo>
                    <a:lnTo>
                      <a:pt x="38" y="31"/>
                    </a:lnTo>
                    <a:lnTo>
                      <a:pt x="42" y="31"/>
                    </a:lnTo>
                    <a:lnTo>
                      <a:pt x="42" y="39"/>
                    </a:lnTo>
                    <a:lnTo>
                      <a:pt x="44" y="39"/>
                    </a:lnTo>
                    <a:lnTo>
                      <a:pt x="44" y="47"/>
                    </a:lnTo>
                    <a:lnTo>
                      <a:pt x="46" y="47"/>
                    </a:lnTo>
                    <a:lnTo>
                      <a:pt x="46" y="55"/>
                    </a:lnTo>
                    <a:lnTo>
                      <a:pt x="52" y="55"/>
                    </a:lnTo>
                    <a:lnTo>
                      <a:pt x="52" y="63"/>
                    </a:lnTo>
                    <a:lnTo>
                      <a:pt x="66" y="63"/>
                    </a:lnTo>
                    <a:lnTo>
                      <a:pt x="66" y="70"/>
                    </a:lnTo>
                    <a:lnTo>
                      <a:pt x="76" y="70"/>
                    </a:lnTo>
                    <a:lnTo>
                      <a:pt x="76" y="78"/>
                    </a:lnTo>
                    <a:lnTo>
                      <a:pt x="80" y="78"/>
                    </a:lnTo>
                    <a:lnTo>
                      <a:pt x="80" y="86"/>
                    </a:lnTo>
                    <a:lnTo>
                      <a:pt x="100" y="86"/>
                    </a:lnTo>
                    <a:lnTo>
                      <a:pt x="100" y="94"/>
                    </a:lnTo>
                    <a:lnTo>
                      <a:pt x="102" y="94"/>
                    </a:lnTo>
                    <a:lnTo>
                      <a:pt x="102" y="101"/>
                    </a:lnTo>
                    <a:lnTo>
                      <a:pt x="109" y="101"/>
                    </a:lnTo>
                    <a:lnTo>
                      <a:pt x="109" y="109"/>
                    </a:lnTo>
                    <a:lnTo>
                      <a:pt x="110" y="109"/>
                    </a:lnTo>
                    <a:lnTo>
                      <a:pt x="110" y="117"/>
                    </a:lnTo>
                    <a:lnTo>
                      <a:pt x="112" y="117"/>
                    </a:lnTo>
                    <a:lnTo>
                      <a:pt x="112" y="125"/>
                    </a:lnTo>
                    <a:lnTo>
                      <a:pt x="114" y="125"/>
                    </a:lnTo>
                    <a:lnTo>
                      <a:pt x="114" y="132"/>
                    </a:lnTo>
                    <a:lnTo>
                      <a:pt x="277" y="132"/>
                    </a:lnTo>
                    <a:lnTo>
                      <a:pt x="277" y="140"/>
                    </a:lnTo>
                    <a:lnTo>
                      <a:pt x="324" y="140"/>
                    </a:lnTo>
                    <a:lnTo>
                      <a:pt x="324" y="140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Rectangle 229"/>
              <p:cNvSpPr>
                <a:spLocks noChangeArrowheads="1"/>
              </p:cNvSpPr>
              <p:nvPr/>
            </p:nvSpPr>
            <p:spPr bwMode="auto">
              <a:xfrm>
                <a:off x="6469495" y="1957790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418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84" name="Rectangle 230"/>
              <p:cNvSpPr>
                <a:spLocks noChangeArrowheads="1"/>
              </p:cNvSpPr>
              <p:nvPr/>
            </p:nvSpPr>
            <p:spPr bwMode="auto">
              <a:xfrm>
                <a:off x="7224916" y="1454051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4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85" name="Rectangle 231"/>
              <p:cNvSpPr>
                <a:spLocks noChangeArrowheads="1"/>
              </p:cNvSpPr>
              <p:nvPr/>
            </p:nvSpPr>
            <p:spPr bwMode="auto">
              <a:xfrm>
                <a:off x="7216864" y="1811186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11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86" name="Line 232"/>
              <p:cNvSpPr>
                <a:spLocks noChangeShapeType="1"/>
              </p:cNvSpPr>
              <p:nvPr/>
            </p:nvSpPr>
            <p:spPr bwMode="auto">
              <a:xfrm>
                <a:off x="905805" y="4259593"/>
                <a:ext cx="197223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Line 233"/>
              <p:cNvSpPr>
                <a:spLocks noChangeShapeType="1"/>
              </p:cNvSpPr>
              <p:nvPr/>
            </p:nvSpPr>
            <p:spPr bwMode="auto">
              <a:xfrm>
                <a:off x="905805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Line 234"/>
              <p:cNvSpPr>
                <a:spLocks noChangeShapeType="1"/>
              </p:cNvSpPr>
              <p:nvPr/>
            </p:nvSpPr>
            <p:spPr bwMode="auto">
              <a:xfrm>
                <a:off x="1235510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Line 235"/>
              <p:cNvSpPr>
                <a:spLocks noChangeShapeType="1"/>
              </p:cNvSpPr>
              <p:nvPr/>
            </p:nvSpPr>
            <p:spPr bwMode="auto">
              <a:xfrm>
                <a:off x="1565214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Line 236"/>
              <p:cNvSpPr>
                <a:spLocks noChangeShapeType="1"/>
              </p:cNvSpPr>
              <p:nvPr/>
            </p:nvSpPr>
            <p:spPr bwMode="auto">
              <a:xfrm>
                <a:off x="1894920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Line 237"/>
              <p:cNvSpPr>
                <a:spLocks noChangeShapeType="1"/>
              </p:cNvSpPr>
              <p:nvPr/>
            </p:nvSpPr>
            <p:spPr bwMode="auto">
              <a:xfrm>
                <a:off x="2224624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Line 238"/>
              <p:cNvSpPr>
                <a:spLocks noChangeShapeType="1"/>
              </p:cNvSpPr>
              <p:nvPr/>
            </p:nvSpPr>
            <p:spPr bwMode="auto">
              <a:xfrm>
                <a:off x="2554329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Line 239"/>
              <p:cNvSpPr>
                <a:spLocks noChangeShapeType="1"/>
              </p:cNvSpPr>
              <p:nvPr/>
            </p:nvSpPr>
            <p:spPr bwMode="auto">
              <a:xfrm>
                <a:off x="2878039" y="4259593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Rectangle 240"/>
              <p:cNvSpPr>
                <a:spLocks noChangeArrowheads="1"/>
              </p:cNvSpPr>
              <p:nvPr/>
            </p:nvSpPr>
            <p:spPr bwMode="auto">
              <a:xfrm>
                <a:off x="866840" y="4351878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5" name="Rectangle 241"/>
              <p:cNvSpPr>
                <a:spLocks noChangeArrowheads="1"/>
              </p:cNvSpPr>
              <p:nvPr/>
            </p:nvSpPr>
            <p:spPr bwMode="auto">
              <a:xfrm>
                <a:off x="1178560" y="4351878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6" name="Rectangle 242"/>
              <p:cNvSpPr>
                <a:spLocks noChangeArrowheads="1"/>
              </p:cNvSpPr>
              <p:nvPr/>
            </p:nvSpPr>
            <p:spPr bwMode="auto">
              <a:xfrm>
                <a:off x="1508266" y="4351878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7" name="Rectangle 243"/>
              <p:cNvSpPr>
                <a:spLocks noChangeArrowheads="1"/>
              </p:cNvSpPr>
              <p:nvPr/>
            </p:nvSpPr>
            <p:spPr bwMode="auto">
              <a:xfrm>
                <a:off x="1837969" y="4351878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8" name="Rectangle 244"/>
              <p:cNvSpPr>
                <a:spLocks noChangeArrowheads="1"/>
              </p:cNvSpPr>
              <p:nvPr/>
            </p:nvSpPr>
            <p:spPr bwMode="auto">
              <a:xfrm>
                <a:off x="2167677" y="4351878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9" name="Rectangle 245"/>
              <p:cNvSpPr>
                <a:spLocks noChangeArrowheads="1"/>
              </p:cNvSpPr>
              <p:nvPr/>
            </p:nvSpPr>
            <p:spPr bwMode="auto">
              <a:xfrm>
                <a:off x="2497382" y="4351878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0" name="Rectangle 246"/>
              <p:cNvSpPr>
                <a:spLocks noChangeArrowheads="1"/>
              </p:cNvSpPr>
              <p:nvPr/>
            </p:nvSpPr>
            <p:spPr bwMode="auto">
              <a:xfrm>
                <a:off x="2821091" y="4351878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1" name="Line 247"/>
              <p:cNvSpPr>
                <a:spLocks noChangeShapeType="1"/>
              </p:cNvSpPr>
              <p:nvPr/>
            </p:nvSpPr>
            <p:spPr bwMode="auto">
              <a:xfrm flipV="1">
                <a:off x="905805" y="2925147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Line 248"/>
              <p:cNvSpPr>
                <a:spLocks noChangeShapeType="1"/>
              </p:cNvSpPr>
              <p:nvPr/>
            </p:nvSpPr>
            <p:spPr bwMode="auto">
              <a:xfrm flipH="1">
                <a:off x="869837" y="420760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Line 249"/>
              <p:cNvSpPr>
                <a:spLocks noChangeShapeType="1"/>
              </p:cNvSpPr>
              <p:nvPr/>
            </p:nvSpPr>
            <p:spPr bwMode="auto">
              <a:xfrm flipH="1">
                <a:off x="869837" y="3947644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Line 250"/>
              <p:cNvSpPr>
                <a:spLocks noChangeShapeType="1"/>
              </p:cNvSpPr>
              <p:nvPr/>
            </p:nvSpPr>
            <p:spPr bwMode="auto">
              <a:xfrm flipH="1">
                <a:off x="869837" y="3696353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Line 251"/>
              <p:cNvSpPr>
                <a:spLocks noChangeShapeType="1"/>
              </p:cNvSpPr>
              <p:nvPr/>
            </p:nvSpPr>
            <p:spPr bwMode="auto">
              <a:xfrm flipH="1">
                <a:off x="869837" y="3436395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Line 252"/>
              <p:cNvSpPr>
                <a:spLocks noChangeShapeType="1"/>
              </p:cNvSpPr>
              <p:nvPr/>
            </p:nvSpPr>
            <p:spPr bwMode="auto">
              <a:xfrm flipH="1">
                <a:off x="869837" y="3185103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Line 253"/>
              <p:cNvSpPr>
                <a:spLocks noChangeShapeType="1"/>
              </p:cNvSpPr>
              <p:nvPr/>
            </p:nvSpPr>
            <p:spPr bwMode="auto">
              <a:xfrm flipH="1">
                <a:off x="869837" y="2925147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Rectangle 254"/>
              <p:cNvSpPr>
                <a:spLocks noChangeArrowheads="1"/>
              </p:cNvSpPr>
              <p:nvPr/>
            </p:nvSpPr>
            <p:spPr bwMode="auto">
              <a:xfrm>
                <a:off x="695993" y="415240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9" name="Rectangle 255"/>
              <p:cNvSpPr>
                <a:spLocks noChangeArrowheads="1"/>
              </p:cNvSpPr>
              <p:nvPr/>
            </p:nvSpPr>
            <p:spPr bwMode="auto">
              <a:xfrm>
                <a:off x="695993" y="3901109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0" name="Rectangle 256"/>
              <p:cNvSpPr>
                <a:spLocks noChangeArrowheads="1"/>
              </p:cNvSpPr>
              <p:nvPr/>
            </p:nvSpPr>
            <p:spPr bwMode="auto">
              <a:xfrm>
                <a:off x="695993" y="3641152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1" name="Rectangle 257"/>
              <p:cNvSpPr>
                <a:spLocks noChangeArrowheads="1"/>
              </p:cNvSpPr>
              <p:nvPr/>
            </p:nvSpPr>
            <p:spPr bwMode="auto">
              <a:xfrm>
                <a:off x="695993" y="3389859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2" name="Rectangle 258"/>
              <p:cNvSpPr>
                <a:spLocks noChangeArrowheads="1"/>
              </p:cNvSpPr>
              <p:nvPr/>
            </p:nvSpPr>
            <p:spPr bwMode="auto">
              <a:xfrm>
                <a:off x="695993" y="3129902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3" name="Rectangle 259"/>
              <p:cNvSpPr>
                <a:spLocks noChangeArrowheads="1"/>
              </p:cNvSpPr>
              <p:nvPr/>
            </p:nvSpPr>
            <p:spPr bwMode="auto">
              <a:xfrm>
                <a:off x="695993" y="2878611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4" name="Rectangle 261"/>
              <p:cNvSpPr>
                <a:spLocks noChangeArrowheads="1"/>
              </p:cNvSpPr>
              <p:nvPr/>
            </p:nvSpPr>
            <p:spPr bwMode="auto">
              <a:xfrm>
                <a:off x="1477009" y="2672342"/>
                <a:ext cx="1091646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tratford</a:t>
                </a:r>
                <a:r>
                  <a:rPr lang="fr-FR" altLang="fr-FR" sz="1000" dirty="0">
                    <a:solidFill>
                      <a:srgbClr val="000000"/>
                    </a:solidFill>
                  </a:rPr>
                  <a:t> </a:t>
                </a:r>
                <a:r>
                  <a:rPr lang="fr-FR" altLang="fr-FR" sz="1000" dirty="0" smtClean="0">
                    <a:solidFill>
                      <a:srgbClr val="000000"/>
                    </a:solidFill>
                  </a:rPr>
                  <a:t>(N=102)</a:t>
                </a:r>
                <a:endParaRPr kumimoji="0" lang="fr-FR" altLang="fr-FR" sz="1000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7" name="Rectangle 264"/>
              <p:cNvSpPr>
                <a:spLocks noChangeArrowheads="1"/>
              </p:cNvSpPr>
              <p:nvPr/>
            </p:nvSpPr>
            <p:spPr bwMode="auto">
              <a:xfrm rot="16200000">
                <a:off x="197309" y="3474372"/>
                <a:ext cx="796238" cy="181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Overall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rvival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8" name="Freeform 265"/>
              <p:cNvSpPr>
                <a:spLocks/>
              </p:cNvSpPr>
              <p:nvPr/>
            </p:nvSpPr>
            <p:spPr bwMode="auto">
              <a:xfrm>
                <a:off x="905805" y="2925147"/>
                <a:ext cx="1810380" cy="1152475"/>
              </a:xfrm>
              <a:custGeom>
                <a:avLst/>
                <a:gdLst>
                  <a:gd name="T0" fmla="*/ 0 w 302"/>
                  <a:gd name="T1" fmla="*/ 0 h 133"/>
                  <a:gd name="T2" fmla="*/ 6 w 302"/>
                  <a:gd name="T3" fmla="*/ 0 h 133"/>
                  <a:gd name="T4" fmla="*/ 6 w 302"/>
                  <a:gd name="T5" fmla="*/ 3 h 133"/>
                  <a:gd name="T6" fmla="*/ 11 w 302"/>
                  <a:gd name="T7" fmla="*/ 3 h 133"/>
                  <a:gd name="T8" fmla="*/ 11 w 302"/>
                  <a:gd name="T9" fmla="*/ 5 h 133"/>
                  <a:gd name="T10" fmla="*/ 17 w 302"/>
                  <a:gd name="T11" fmla="*/ 5 h 133"/>
                  <a:gd name="T12" fmla="*/ 17 w 302"/>
                  <a:gd name="T13" fmla="*/ 8 h 133"/>
                  <a:gd name="T14" fmla="*/ 22 w 302"/>
                  <a:gd name="T15" fmla="*/ 8 h 133"/>
                  <a:gd name="T16" fmla="*/ 22 w 302"/>
                  <a:gd name="T17" fmla="*/ 10 h 133"/>
                  <a:gd name="T18" fmla="*/ 33 w 302"/>
                  <a:gd name="T19" fmla="*/ 10 h 133"/>
                  <a:gd name="T20" fmla="*/ 33 w 302"/>
                  <a:gd name="T21" fmla="*/ 15 h 133"/>
                  <a:gd name="T22" fmla="*/ 39 w 302"/>
                  <a:gd name="T23" fmla="*/ 15 h 133"/>
                  <a:gd name="T24" fmla="*/ 39 w 302"/>
                  <a:gd name="T25" fmla="*/ 25 h 133"/>
                  <a:gd name="T26" fmla="*/ 44 w 302"/>
                  <a:gd name="T27" fmla="*/ 25 h 133"/>
                  <a:gd name="T28" fmla="*/ 44 w 302"/>
                  <a:gd name="T29" fmla="*/ 27 h 133"/>
                  <a:gd name="T30" fmla="*/ 55 w 302"/>
                  <a:gd name="T31" fmla="*/ 27 h 133"/>
                  <a:gd name="T32" fmla="*/ 55 w 302"/>
                  <a:gd name="T33" fmla="*/ 29 h 133"/>
                  <a:gd name="T34" fmla="*/ 61 w 302"/>
                  <a:gd name="T35" fmla="*/ 29 h 133"/>
                  <a:gd name="T36" fmla="*/ 61 w 302"/>
                  <a:gd name="T37" fmla="*/ 32 h 133"/>
                  <a:gd name="T38" fmla="*/ 72 w 302"/>
                  <a:gd name="T39" fmla="*/ 32 h 133"/>
                  <a:gd name="T40" fmla="*/ 72 w 302"/>
                  <a:gd name="T41" fmla="*/ 42 h 133"/>
                  <a:gd name="T42" fmla="*/ 77 w 302"/>
                  <a:gd name="T43" fmla="*/ 42 h 133"/>
                  <a:gd name="T44" fmla="*/ 77 w 302"/>
                  <a:gd name="T45" fmla="*/ 49 h 133"/>
                  <a:gd name="T46" fmla="*/ 83 w 302"/>
                  <a:gd name="T47" fmla="*/ 49 h 133"/>
                  <a:gd name="T48" fmla="*/ 83 w 302"/>
                  <a:gd name="T49" fmla="*/ 54 h 133"/>
                  <a:gd name="T50" fmla="*/ 94 w 302"/>
                  <a:gd name="T51" fmla="*/ 54 h 133"/>
                  <a:gd name="T52" fmla="*/ 94 w 302"/>
                  <a:gd name="T53" fmla="*/ 59 h 133"/>
                  <a:gd name="T54" fmla="*/ 99 w 302"/>
                  <a:gd name="T55" fmla="*/ 59 h 133"/>
                  <a:gd name="T56" fmla="*/ 99 w 302"/>
                  <a:gd name="T57" fmla="*/ 67 h 133"/>
                  <a:gd name="T58" fmla="*/ 105 w 302"/>
                  <a:gd name="T59" fmla="*/ 67 h 133"/>
                  <a:gd name="T60" fmla="*/ 105 w 302"/>
                  <a:gd name="T61" fmla="*/ 75 h 133"/>
                  <a:gd name="T62" fmla="*/ 110 w 302"/>
                  <a:gd name="T63" fmla="*/ 75 h 133"/>
                  <a:gd name="T64" fmla="*/ 110 w 302"/>
                  <a:gd name="T65" fmla="*/ 78 h 133"/>
                  <a:gd name="T66" fmla="*/ 116 w 302"/>
                  <a:gd name="T67" fmla="*/ 78 h 133"/>
                  <a:gd name="T68" fmla="*/ 116 w 302"/>
                  <a:gd name="T69" fmla="*/ 84 h 133"/>
                  <a:gd name="T70" fmla="*/ 121 w 302"/>
                  <a:gd name="T71" fmla="*/ 84 h 133"/>
                  <a:gd name="T72" fmla="*/ 121 w 302"/>
                  <a:gd name="T73" fmla="*/ 90 h 133"/>
                  <a:gd name="T74" fmla="*/ 127 w 302"/>
                  <a:gd name="T75" fmla="*/ 90 h 133"/>
                  <a:gd name="T76" fmla="*/ 127 w 302"/>
                  <a:gd name="T77" fmla="*/ 93 h 133"/>
                  <a:gd name="T78" fmla="*/ 159 w 302"/>
                  <a:gd name="T79" fmla="*/ 93 h 133"/>
                  <a:gd name="T80" fmla="*/ 159 w 302"/>
                  <a:gd name="T81" fmla="*/ 96 h 133"/>
                  <a:gd name="T82" fmla="*/ 170 w 302"/>
                  <a:gd name="T83" fmla="*/ 96 h 133"/>
                  <a:gd name="T84" fmla="*/ 170 w 302"/>
                  <a:gd name="T85" fmla="*/ 100 h 133"/>
                  <a:gd name="T86" fmla="*/ 192 w 302"/>
                  <a:gd name="T87" fmla="*/ 100 h 133"/>
                  <a:gd name="T88" fmla="*/ 192 w 302"/>
                  <a:gd name="T89" fmla="*/ 105 h 133"/>
                  <a:gd name="T90" fmla="*/ 225 w 302"/>
                  <a:gd name="T91" fmla="*/ 105 h 133"/>
                  <a:gd name="T92" fmla="*/ 225 w 302"/>
                  <a:gd name="T93" fmla="*/ 111 h 133"/>
                  <a:gd name="T94" fmla="*/ 269 w 302"/>
                  <a:gd name="T95" fmla="*/ 111 h 133"/>
                  <a:gd name="T96" fmla="*/ 269 w 302"/>
                  <a:gd name="T97" fmla="*/ 118 h 133"/>
                  <a:gd name="T98" fmla="*/ 297 w 302"/>
                  <a:gd name="T99" fmla="*/ 118 h 133"/>
                  <a:gd name="T100" fmla="*/ 297 w 302"/>
                  <a:gd name="T101" fmla="*/ 133 h 133"/>
                  <a:gd name="T102" fmla="*/ 302 w 302"/>
                  <a:gd name="T103" fmla="*/ 133 h 133"/>
                  <a:gd name="T104" fmla="*/ 302 w 302"/>
                  <a:gd name="T105" fmla="*/ 133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</a:cxnLst>
                <a:rect l="0" t="0" r="r" b="b"/>
                <a:pathLst>
                  <a:path w="302" h="133">
                    <a:moveTo>
                      <a:pt x="0" y="0"/>
                    </a:moveTo>
                    <a:lnTo>
                      <a:pt x="6" y="0"/>
                    </a:lnTo>
                    <a:lnTo>
                      <a:pt x="6" y="3"/>
                    </a:lnTo>
                    <a:lnTo>
                      <a:pt x="11" y="3"/>
                    </a:lnTo>
                    <a:lnTo>
                      <a:pt x="11" y="5"/>
                    </a:lnTo>
                    <a:lnTo>
                      <a:pt x="17" y="5"/>
                    </a:lnTo>
                    <a:lnTo>
                      <a:pt x="17" y="8"/>
                    </a:lnTo>
                    <a:lnTo>
                      <a:pt x="22" y="8"/>
                    </a:lnTo>
                    <a:lnTo>
                      <a:pt x="22" y="10"/>
                    </a:lnTo>
                    <a:lnTo>
                      <a:pt x="33" y="10"/>
                    </a:lnTo>
                    <a:lnTo>
                      <a:pt x="33" y="15"/>
                    </a:lnTo>
                    <a:lnTo>
                      <a:pt x="39" y="15"/>
                    </a:lnTo>
                    <a:lnTo>
                      <a:pt x="39" y="25"/>
                    </a:lnTo>
                    <a:lnTo>
                      <a:pt x="44" y="25"/>
                    </a:lnTo>
                    <a:lnTo>
                      <a:pt x="44" y="27"/>
                    </a:lnTo>
                    <a:lnTo>
                      <a:pt x="55" y="27"/>
                    </a:lnTo>
                    <a:lnTo>
                      <a:pt x="55" y="29"/>
                    </a:lnTo>
                    <a:lnTo>
                      <a:pt x="61" y="29"/>
                    </a:lnTo>
                    <a:lnTo>
                      <a:pt x="61" y="32"/>
                    </a:lnTo>
                    <a:lnTo>
                      <a:pt x="72" y="32"/>
                    </a:lnTo>
                    <a:lnTo>
                      <a:pt x="72" y="42"/>
                    </a:lnTo>
                    <a:lnTo>
                      <a:pt x="77" y="42"/>
                    </a:lnTo>
                    <a:lnTo>
                      <a:pt x="77" y="49"/>
                    </a:lnTo>
                    <a:lnTo>
                      <a:pt x="83" y="49"/>
                    </a:lnTo>
                    <a:lnTo>
                      <a:pt x="83" y="54"/>
                    </a:lnTo>
                    <a:lnTo>
                      <a:pt x="94" y="54"/>
                    </a:lnTo>
                    <a:lnTo>
                      <a:pt x="94" y="59"/>
                    </a:lnTo>
                    <a:lnTo>
                      <a:pt x="99" y="59"/>
                    </a:lnTo>
                    <a:lnTo>
                      <a:pt x="99" y="67"/>
                    </a:lnTo>
                    <a:lnTo>
                      <a:pt x="105" y="67"/>
                    </a:lnTo>
                    <a:lnTo>
                      <a:pt x="105" y="75"/>
                    </a:lnTo>
                    <a:lnTo>
                      <a:pt x="110" y="75"/>
                    </a:lnTo>
                    <a:lnTo>
                      <a:pt x="110" y="78"/>
                    </a:lnTo>
                    <a:lnTo>
                      <a:pt x="116" y="78"/>
                    </a:lnTo>
                    <a:lnTo>
                      <a:pt x="116" y="84"/>
                    </a:lnTo>
                    <a:lnTo>
                      <a:pt x="121" y="84"/>
                    </a:lnTo>
                    <a:lnTo>
                      <a:pt x="121" y="90"/>
                    </a:lnTo>
                    <a:lnTo>
                      <a:pt x="127" y="90"/>
                    </a:lnTo>
                    <a:lnTo>
                      <a:pt x="127" y="93"/>
                    </a:lnTo>
                    <a:lnTo>
                      <a:pt x="159" y="93"/>
                    </a:lnTo>
                    <a:lnTo>
                      <a:pt x="159" y="96"/>
                    </a:lnTo>
                    <a:lnTo>
                      <a:pt x="170" y="96"/>
                    </a:lnTo>
                    <a:lnTo>
                      <a:pt x="170" y="100"/>
                    </a:lnTo>
                    <a:lnTo>
                      <a:pt x="192" y="100"/>
                    </a:lnTo>
                    <a:lnTo>
                      <a:pt x="192" y="105"/>
                    </a:lnTo>
                    <a:lnTo>
                      <a:pt x="225" y="105"/>
                    </a:lnTo>
                    <a:lnTo>
                      <a:pt x="225" y="111"/>
                    </a:lnTo>
                    <a:lnTo>
                      <a:pt x="269" y="111"/>
                    </a:lnTo>
                    <a:lnTo>
                      <a:pt x="269" y="118"/>
                    </a:lnTo>
                    <a:lnTo>
                      <a:pt x="297" y="118"/>
                    </a:lnTo>
                    <a:lnTo>
                      <a:pt x="297" y="133"/>
                    </a:lnTo>
                    <a:lnTo>
                      <a:pt x="302" y="133"/>
                    </a:lnTo>
                    <a:lnTo>
                      <a:pt x="302" y="133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Freeform 266"/>
              <p:cNvSpPr>
                <a:spLocks/>
              </p:cNvSpPr>
              <p:nvPr/>
            </p:nvSpPr>
            <p:spPr bwMode="auto">
              <a:xfrm>
                <a:off x="905805" y="2925147"/>
                <a:ext cx="1942261" cy="1074488"/>
              </a:xfrm>
              <a:custGeom>
                <a:avLst/>
                <a:gdLst>
                  <a:gd name="T0" fmla="*/ 0 w 324"/>
                  <a:gd name="T1" fmla="*/ 0 h 124"/>
                  <a:gd name="T2" fmla="*/ 17 w 324"/>
                  <a:gd name="T3" fmla="*/ 0 h 124"/>
                  <a:gd name="T4" fmla="*/ 17 w 324"/>
                  <a:gd name="T5" fmla="*/ 9 h 124"/>
                  <a:gd name="T6" fmla="*/ 22 w 324"/>
                  <a:gd name="T7" fmla="*/ 9 h 124"/>
                  <a:gd name="T8" fmla="*/ 22 w 324"/>
                  <a:gd name="T9" fmla="*/ 21 h 124"/>
                  <a:gd name="T10" fmla="*/ 33 w 324"/>
                  <a:gd name="T11" fmla="*/ 21 h 124"/>
                  <a:gd name="T12" fmla="*/ 33 w 324"/>
                  <a:gd name="T13" fmla="*/ 38 h 124"/>
                  <a:gd name="T14" fmla="*/ 39 w 324"/>
                  <a:gd name="T15" fmla="*/ 38 h 124"/>
                  <a:gd name="T16" fmla="*/ 39 w 324"/>
                  <a:gd name="T17" fmla="*/ 51 h 124"/>
                  <a:gd name="T18" fmla="*/ 44 w 324"/>
                  <a:gd name="T19" fmla="*/ 51 h 124"/>
                  <a:gd name="T20" fmla="*/ 44 w 324"/>
                  <a:gd name="T21" fmla="*/ 65 h 124"/>
                  <a:gd name="T22" fmla="*/ 55 w 324"/>
                  <a:gd name="T23" fmla="*/ 65 h 124"/>
                  <a:gd name="T24" fmla="*/ 55 w 324"/>
                  <a:gd name="T25" fmla="*/ 70 h 124"/>
                  <a:gd name="T26" fmla="*/ 72 w 324"/>
                  <a:gd name="T27" fmla="*/ 70 h 124"/>
                  <a:gd name="T28" fmla="*/ 72 w 324"/>
                  <a:gd name="T29" fmla="*/ 76 h 124"/>
                  <a:gd name="T30" fmla="*/ 83 w 324"/>
                  <a:gd name="T31" fmla="*/ 76 h 124"/>
                  <a:gd name="T32" fmla="*/ 83 w 324"/>
                  <a:gd name="T33" fmla="*/ 82 h 124"/>
                  <a:gd name="T34" fmla="*/ 88 w 324"/>
                  <a:gd name="T35" fmla="*/ 82 h 124"/>
                  <a:gd name="T36" fmla="*/ 88 w 324"/>
                  <a:gd name="T37" fmla="*/ 88 h 124"/>
                  <a:gd name="T38" fmla="*/ 99 w 324"/>
                  <a:gd name="T39" fmla="*/ 88 h 124"/>
                  <a:gd name="T40" fmla="*/ 99 w 324"/>
                  <a:gd name="T41" fmla="*/ 102 h 124"/>
                  <a:gd name="T42" fmla="*/ 110 w 324"/>
                  <a:gd name="T43" fmla="*/ 102 h 124"/>
                  <a:gd name="T44" fmla="*/ 110 w 324"/>
                  <a:gd name="T45" fmla="*/ 108 h 124"/>
                  <a:gd name="T46" fmla="*/ 138 w 324"/>
                  <a:gd name="T47" fmla="*/ 108 h 124"/>
                  <a:gd name="T48" fmla="*/ 138 w 324"/>
                  <a:gd name="T49" fmla="*/ 116 h 124"/>
                  <a:gd name="T50" fmla="*/ 143 w 324"/>
                  <a:gd name="T51" fmla="*/ 116 h 124"/>
                  <a:gd name="T52" fmla="*/ 143 w 324"/>
                  <a:gd name="T53" fmla="*/ 124 h 124"/>
                  <a:gd name="T54" fmla="*/ 324 w 324"/>
                  <a:gd name="T55" fmla="*/ 124 h 124"/>
                  <a:gd name="T56" fmla="*/ 324 w 324"/>
                  <a:gd name="T57" fmla="*/ 124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324" h="124">
                    <a:moveTo>
                      <a:pt x="0" y="0"/>
                    </a:moveTo>
                    <a:lnTo>
                      <a:pt x="17" y="0"/>
                    </a:lnTo>
                    <a:lnTo>
                      <a:pt x="17" y="9"/>
                    </a:lnTo>
                    <a:lnTo>
                      <a:pt x="22" y="9"/>
                    </a:lnTo>
                    <a:lnTo>
                      <a:pt x="22" y="21"/>
                    </a:lnTo>
                    <a:lnTo>
                      <a:pt x="33" y="21"/>
                    </a:lnTo>
                    <a:lnTo>
                      <a:pt x="33" y="38"/>
                    </a:lnTo>
                    <a:lnTo>
                      <a:pt x="39" y="38"/>
                    </a:lnTo>
                    <a:lnTo>
                      <a:pt x="39" y="51"/>
                    </a:lnTo>
                    <a:lnTo>
                      <a:pt x="44" y="51"/>
                    </a:lnTo>
                    <a:lnTo>
                      <a:pt x="44" y="65"/>
                    </a:lnTo>
                    <a:lnTo>
                      <a:pt x="55" y="65"/>
                    </a:lnTo>
                    <a:lnTo>
                      <a:pt x="55" y="70"/>
                    </a:lnTo>
                    <a:lnTo>
                      <a:pt x="72" y="70"/>
                    </a:lnTo>
                    <a:lnTo>
                      <a:pt x="72" y="76"/>
                    </a:lnTo>
                    <a:lnTo>
                      <a:pt x="83" y="76"/>
                    </a:lnTo>
                    <a:lnTo>
                      <a:pt x="83" y="82"/>
                    </a:lnTo>
                    <a:lnTo>
                      <a:pt x="88" y="82"/>
                    </a:lnTo>
                    <a:lnTo>
                      <a:pt x="88" y="88"/>
                    </a:lnTo>
                    <a:lnTo>
                      <a:pt x="99" y="88"/>
                    </a:lnTo>
                    <a:lnTo>
                      <a:pt x="99" y="102"/>
                    </a:lnTo>
                    <a:lnTo>
                      <a:pt x="110" y="102"/>
                    </a:lnTo>
                    <a:lnTo>
                      <a:pt x="110" y="108"/>
                    </a:lnTo>
                    <a:lnTo>
                      <a:pt x="138" y="108"/>
                    </a:lnTo>
                    <a:lnTo>
                      <a:pt x="138" y="116"/>
                    </a:lnTo>
                    <a:lnTo>
                      <a:pt x="143" y="116"/>
                    </a:lnTo>
                    <a:lnTo>
                      <a:pt x="143" y="124"/>
                    </a:lnTo>
                    <a:lnTo>
                      <a:pt x="324" y="124"/>
                    </a:lnTo>
                    <a:lnTo>
                      <a:pt x="324" y="124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Rectangle 267"/>
              <p:cNvSpPr>
                <a:spLocks noChangeArrowheads="1"/>
              </p:cNvSpPr>
              <p:nvPr/>
            </p:nvSpPr>
            <p:spPr bwMode="auto">
              <a:xfrm>
                <a:off x="989106" y="4059413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566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1" name="Rectangle 268"/>
              <p:cNvSpPr>
                <a:spLocks noChangeArrowheads="1"/>
              </p:cNvSpPr>
              <p:nvPr/>
            </p:nvSpPr>
            <p:spPr bwMode="auto">
              <a:xfrm>
                <a:off x="1742419" y="3581262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7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3" name="Line 270"/>
              <p:cNvSpPr>
                <a:spLocks noChangeShapeType="1"/>
              </p:cNvSpPr>
              <p:nvPr/>
            </p:nvSpPr>
            <p:spPr bwMode="auto">
              <a:xfrm>
                <a:off x="3636169" y="4257601"/>
                <a:ext cx="194226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Line 271"/>
              <p:cNvSpPr>
                <a:spLocks noChangeShapeType="1"/>
              </p:cNvSpPr>
              <p:nvPr/>
            </p:nvSpPr>
            <p:spPr bwMode="auto">
              <a:xfrm>
                <a:off x="3636169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Line 272"/>
              <p:cNvSpPr>
                <a:spLocks noChangeShapeType="1"/>
              </p:cNvSpPr>
              <p:nvPr/>
            </p:nvSpPr>
            <p:spPr bwMode="auto">
              <a:xfrm>
                <a:off x="3959879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Line 273"/>
              <p:cNvSpPr>
                <a:spLocks noChangeShapeType="1"/>
              </p:cNvSpPr>
              <p:nvPr/>
            </p:nvSpPr>
            <p:spPr bwMode="auto">
              <a:xfrm>
                <a:off x="4283589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Line 274"/>
              <p:cNvSpPr>
                <a:spLocks noChangeShapeType="1"/>
              </p:cNvSpPr>
              <p:nvPr/>
            </p:nvSpPr>
            <p:spPr bwMode="auto">
              <a:xfrm>
                <a:off x="4607300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Line 275"/>
              <p:cNvSpPr>
                <a:spLocks noChangeShapeType="1"/>
              </p:cNvSpPr>
              <p:nvPr/>
            </p:nvSpPr>
            <p:spPr bwMode="auto">
              <a:xfrm>
                <a:off x="4931010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Line 276"/>
              <p:cNvSpPr>
                <a:spLocks noChangeShapeType="1"/>
              </p:cNvSpPr>
              <p:nvPr/>
            </p:nvSpPr>
            <p:spPr bwMode="auto">
              <a:xfrm>
                <a:off x="5254720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Line 277"/>
              <p:cNvSpPr>
                <a:spLocks noChangeShapeType="1"/>
              </p:cNvSpPr>
              <p:nvPr/>
            </p:nvSpPr>
            <p:spPr bwMode="auto">
              <a:xfrm>
                <a:off x="5578430" y="4257601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Rectangle 278"/>
              <p:cNvSpPr>
                <a:spLocks noChangeArrowheads="1"/>
              </p:cNvSpPr>
              <p:nvPr/>
            </p:nvSpPr>
            <p:spPr bwMode="auto">
              <a:xfrm>
                <a:off x="3597205" y="4349887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2" name="Rectangle 279"/>
              <p:cNvSpPr>
                <a:spLocks noChangeArrowheads="1"/>
              </p:cNvSpPr>
              <p:nvPr/>
            </p:nvSpPr>
            <p:spPr bwMode="auto">
              <a:xfrm>
                <a:off x="3902931" y="4349887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3" name="Rectangle 280"/>
              <p:cNvSpPr>
                <a:spLocks noChangeArrowheads="1"/>
              </p:cNvSpPr>
              <p:nvPr/>
            </p:nvSpPr>
            <p:spPr bwMode="auto">
              <a:xfrm>
                <a:off x="4226641" y="4349887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4" name="Rectangle 281"/>
              <p:cNvSpPr>
                <a:spLocks noChangeArrowheads="1"/>
              </p:cNvSpPr>
              <p:nvPr/>
            </p:nvSpPr>
            <p:spPr bwMode="auto">
              <a:xfrm>
                <a:off x="4550352" y="4349887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5" name="Rectangle 282"/>
              <p:cNvSpPr>
                <a:spLocks noChangeArrowheads="1"/>
              </p:cNvSpPr>
              <p:nvPr/>
            </p:nvSpPr>
            <p:spPr bwMode="auto">
              <a:xfrm>
                <a:off x="4874062" y="4349887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6" name="Rectangle 283"/>
              <p:cNvSpPr>
                <a:spLocks noChangeArrowheads="1"/>
              </p:cNvSpPr>
              <p:nvPr/>
            </p:nvSpPr>
            <p:spPr bwMode="auto">
              <a:xfrm>
                <a:off x="5197772" y="4349887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7" name="Rectangle 284"/>
              <p:cNvSpPr>
                <a:spLocks noChangeArrowheads="1"/>
              </p:cNvSpPr>
              <p:nvPr/>
            </p:nvSpPr>
            <p:spPr bwMode="auto">
              <a:xfrm>
                <a:off x="5521482" y="4349887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8" name="Line 285"/>
              <p:cNvSpPr>
                <a:spLocks noChangeShapeType="1"/>
              </p:cNvSpPr>
              <p:nvPr/>
            </p:nvSpPr>
            <p:spPr bwMode="auto">
              <a:xfrm flipV="1">
                <a:off x="3636169" y="2923156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Line 286"/>
              <p:cNvSpPr>
                <a:spLocks noChangeShapeType="1"/>
              </p:cNvSpPr>
              <p:nvPr/>
            </p:nvSpPr>
            <p:spPr bwMode="auto">
              <a:xfrm flipH="1">
                <a:off x="3600201" y="4205610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Line 287"/>
              <p:cNvSpPr>
                <a:spLocks noChangeShapeType="1"/>
              </p:cNvSpPr>
              <p:nvPr/>
            </p:nvSpPr>
            <p:spPr bwMode="auto">
              <a:xfrm flipH="1">
                <a:off x="3600201" y="3945653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Line 288"/>
              <p:cNvSpPr>
                <a:spLocks noChangeShapeType="1"/>
              </p:cNvSpPr>
              <p:nvPr/>
            </p:nvSpPr>
            <p:spPr bwMode="auto">
              <a:xfrm flipH="1">
                <a:off x="3600201" y="369436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Line 289"/>
              <p:cNvSpPr>
                <a:spLocks noChangeShapeType="1"/>
              </p:cNvSpPr>
              <p:nvPr/>
            </p:nvSpPr>
            <p:spPr bwMode="auto">
              <a:xfrm flipH="1">
                <a:off x="3600201" y="3434404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Line 290"/>
              <p:cNvSpPr>
                <a:spLocks noChangeShapeType="1"/>
              </p:cNvSpPr>
              <p:nvPr/>
            </p:nvSpPr>
            <p:spPr bwMode="auto">
              <a:xfrm flipH="1">
                <a:off x="3600201" y="3183113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Line 291"/>
              <p:cNvSpPr>
                <a:spLocks noChangeShapeType="1"/>
              </p:cNvSpPr>
              <p:nvPr/>
            </p:nvSpPr>
            <p:spPr bwMode="auto">
              <a:xfrm flipH="1">
                <a:off x="3600201" y="2923156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Rectangle 292"/>
              <p:cNvSpPr>
                <a:spLocks noChangeArrowheads="1"/>
              </p:cNvSpPr>
              <p:nvPr/>
            </p:nvSpPr>
            <p:spPr bwMode="auto">
              <a:xfrm>
                <a:off x="3426356" y="4150409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46" name="Rectangle 293"/>
              <p:cNvSpPr>
                <a:spLocks noChangeArrowheads="1"/>
              </p:cNvSpPr>
              <p:nvPr/>
            </p:nvSpPr>
            <p:spPr bwMode="auto">
              <a:xfrm>
                <a:off x="3426356" y="3899117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47" name="Rectangle 294"/>
              <p:cNvSpPr>
                <a:spLocks noChangeArrowheads="1"/>
              </p:cNvSpPr>
              <p:nvPr/>
            </p:nvSpPr>
            <p:spPr bwMode="auto">
              <a:xfrm>
                <a:off x="3426356" y="363916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48" name="Rectangle 295"/>
              <p:cNvSpPr>
                <a:spLocks noChangeArrowheads="1"/>
              </p:cNvSpPr>
              <p:nvPr/>
            </p:nvSpPr>
            <p:spPr bwMode="auto">
              <a:xfrm>
                <a:off x="3426356" y="338786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49" name="Rectangle 296"/>
              <p:cNvSpPr>
                <a:spLocks noChangeArrowheads="1"/>
              </p:cNvSpPr>
              <p:nvPr/>
            </p:nvSpPr>
            <p:spPr bwMode="auto">
              <a:xfrm>
                <a:off x="3426356" y="3127912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50" name="Rectangle 297"/>
              <p:cNvSpPr>
                <a:spLocks noChangeArrowheads="1"/>
              </p:cNvSpPr>
              <p:nvPr/>
            </p:nvSpPr>
            <p:spPr bwMode="auto">
              <a:xfrm>
                <a:off x="3426356" y="287662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51" name="Rectangle 299"/>
              <p:cNvSpPr>
                <a:spLocks noChangeArrowheads="1"/>
              </p:cNvSpPr>
              <p:nvPr/>
            </p:nvSpPr>
            <p:spPr bwMode="auto">
              <a:xfrm>
                <a:off x="4008130" y="2670351"/>
                <a:ext cx="1511439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Van den Broeck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(N=12)</a:t>
                </a:r>
                <a:endParaRPr kumimoji="0" lang="fr-FR" altLang="fr-FR" sz="1000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55" name="Freeform 303"/>
              <p:cNvSpPr>
                <a:spLocks/>
              </p:cNvSpPr>
              <p:nvPr/>
            </p:nvSpPr>
            <p:spPr bwMode="auto">
              <a:xfrm>
                <a:off x="3636169" y="2923156"/>
                <a:ext cx="1942261" cy="511249"/>
              </a:xfrm>
              <a:custGeom>
                <a:avLst/>
                <a:gdLst>
                  <a:gd name="T0" fmla="*/ 0 w 324"/>
                  <a:gd name="T1" fmla="*/ 0 h 59"/>
                  <a:gd name="T2" fmla="*/ 45 w 324"/>
                  <a:gd name="T3" fmla="*/ 0 h 59"/>
                  <a:gd name="T4" fmla="*/ 45 w 324"/>
                  <a:gd name="T5" fmla="*/ 15 h 59"/>
                  <a:gd name="T6" fmla="*/ 51 w 324"/>
                  <a:gd name="T7" fmla="*/ 15 h 59"/>
                  <a:gd name="T8" fmla="*/ 51 w 324"/>
                  <a:gd name="T9" fmla="*/ 30 h 59"/>
                  <a:gd name="T10" fmla="*/ 54 w 324"/>
                  <a:gd name="T11" fmla="*/ 30 h 59"/>
                  <a:gd name="T12" fmla="*/ 54 w 324"/>
                  <a:gd name="T13" fmla="*/ 45 h 59"/>
                  <a:gd name="T14" fmla="*/ 305 w 324"/>
                  <a:gd name="T15" fmla="*/ 45 h 59"/>
                  <a:gd name="T16" fmla="*/ 305 w 324"/>
                  <a:gd name="T17" fmla="*/ 59 h 59"/>
                  <a:gd name="T18" fmla="*/ 324 w 324"/>
                  <a:gd name="T19" fmla="*/ 59 h 59"/>
                  <a:gd name="T20" fmla="*/ 324 w 324"/>
                  <a:gd name="T21" fmla="*/ 59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24" h="59">
                    <a:moveTo>
                      <a:pt x="0" y="0"/>
                    </a:moveTo>
                    <a:lnTo>
                      <a:pt x="45" y="0"/>
                    </a:lnTo>
                    <a:lnTo>
                      <a:pt x="45" y="15"/>
                    </a:lnTo>
                    <a:lnTo>
                      <a:pt x="51" y="15"/>
                    </a:lnTo>
                    <a:lnTo>
                      <a:pt x="51" y="30"/>
                    </a:lnTo>
                    <a:lnTo>
                      <a:pt x="54" y="30"/>
                    </a:lnTo>
                    <a:lnTo>
                      <a:pt x="54" y="45"/>
                    </a:lnTo>
                    <a:lnTo>
                      <a:pt x="305" y="45"/>
                    </a:lnTo>
                    <a:lnTo>
                      <a:pt x="305" y="59"/>
                    </a:lnTo>
                    <a:lnTo>
                      <a:pt x="324" y="59"/>
                    </a:lnTo>
                    <a:lnTo>
                      <a:pt x="324" y="59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Freeform 304"/>
              <p:cNvSpPr>
                <a:spLocks/>
              </p:cNvSpPr>
              <p:nvPr/>
            </p:nvSpPr>
            <p:spPr bwMode="auto">
              <a:xfrm>
                <a:off x="3636169" y="2923156"/>
                <a:ext cx="275753" cy="1282454"/>
              </a:xfrm>
              <a:custGeom>
                <a:avLst/>
                <a:gdLst>
                  <a:gd name="T0" fmla="*/ 0 w 46"/>
                  <a:gd name="T1" fmla="*/ 0 h 148"/>
                  <a:gd name="T2" fmla="*/ 34 w 46"/>
                  <a:gd name="T3" fmla="*/ 0 h 148"/>
                  <a:gd name="T4" fmla="*/ 34 w 46"/>
                  <a:gd name="T5" fmla="*/ 74 h 148"/>
                  <a:gd name="T6" fmla="*/ 46 w 46"/>
                  <a:gd name="T7" fmla="*/ 74 h 148"/>
                  <a:gd name="T8" fmla="*/ 46 w 46"/>
                  <a:gd name="T9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46" h="148">
                    <a:moveTo>
                      <a:pt x="0" y="0"/>
                    </a:moveTo>
                    <a:lnTo>
                      <a:pt x="34" y="0"/>
                    </a:lnTo>
                    <a:lnTo>
                      <a:pt x="34" y="74"/>
                    </a:lnTo>
                    <a:lnTo>
                      <a:pt x="46" y="74"/>
                    </a:lnTo>
                    <a:lnTo>
                      <a:pt x="46" y="148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Rectangle 305"/>
              <p:cNvSpPr>
                <a:spLocks noChangeArrowheads="1"/>
              </p:cNvSpPr>
              <p:nvPr/>
            </p:nvSpPr>
            <p:spPr bwMode="auto">
              <a:xfrm>
                <a:off x="3726872" y="4059413"/>
                <a:ext cx="604333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0325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59" name="Rectangle 307"/>
              <p:cNvSpPr>
                <a:spLocks noChangeArrowheads="1"/>
              </p:cNvSpPr>
              <p:nvPr/>
            </p:nvSpPr>
            <p:spPr bwMode="auto">
              <a:xfrm>
                <a:off x="4472252" y="4103107"/>
                <a:ext cx="16671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0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60" name="Line 308"/>
              <p:cNvSpPr>
                <a:spLocks noChangeShapeType="1"/>
              </p:cNvSpPr>
              <p:nvPr/>
            </p:nvSpPr>
            <p:spPr bwMode="auto">
              <a:xfrm>
                <a:off x="6439895" y="4255259"/>
                <a:ext cx="18223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Line 309"/>
              <p:cNvSpPr>
                <a:spLocks noChangeShapeType="1"/>
              </p:cNvSpPr>
              <p:nvPr/>
            </p:nvSpPr>
            <p:spPr bwMode="auto">
              <a:xfrm>
                <a:off x="6439895" y="4255259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Line 310"/>
              <p:cNvSpPr>
                <a:spLocks noChangeShapeType="1"/>
              </p:cNvSpPr>
              <p:nvPr/>
            </p:nvSpPr>
            <p:spPr bwMode="auto">
              <a:xfrm>
                <a:off x="6805567" y="4255259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Line 311"/>
              <p:cNvSpPr>
                <a:spLocks noChangeShapeType="1"/>
              </p:cNvSpPr>
              <p:nvPr/>
            </p:nvSpPr>
            <p:spPr bwMode="auto">
              <a:xfrm>
                <a:off x="7171240" y="4255259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Line 312"/>
              <p:cNvSpPr>
                <a:spLocks noChangeShapeType="1"/>
              </p:cNvSpPr>
              <p:nvPr/>
            </p:nvSpPr>
            <p:spPr bwMode="auto">
              <a:xfrm>
                <a:off x="7536912" y="4255259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Line 313"/>
              <p:cNvSpPr>
                <a:spLocks noChangeShapeType="1"/>
              </p:cNvSpPr>
              <p:nvPr/>
            </p:nvSpPr>
            <p:spPr bwMode="auto">
              <a:xfrm>
                <a:off x="7896590" y="4255259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Line 314"/>
              <p:cNvSpPr>
                <a:spLocks noChangeShapeType="1"/>
              </p:cNvSpPr>
              <p:nvPr/>
            </p:nvSpPr>
            <p:spPr bwMode="auto">
              <a:xfrm>
                <a:off x="8262263" y="4255259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Rectangle 315"/>
              <p:cNvSpPr>
                <a:spLocks noChangeArrowheads="1"/>
              </p:cNvSpPr>
              <p:nvPr/>
            </p:nvSpPr>
            <p:spPr bwMode="auto">
              <a:xfrm>
                <a:off x="6400929" y="4347545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68" name="Rectangle 316"/>
              <p:cNvSpPr>
                <a:spLocks noChangeArrowheads="1"/>
              </p:cNvSpPr>
              <p:nvPr/>
            </p:nvSpPr>
            <p:spPr bwMode="auto">
              <a:xfrm>
                <a:off x="6748619" y="4347545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69" name="Rectangle 317"/>
              <p:cNvSpPr>
                <a:spLocks noChangeArrowheads="1"/>
              </p:cNvSpPr>
              <p:nvPr/>
            </p:nvSpPr>
            <p:spPr bwMode="auto">
              <a:xfrm>
                <a:off x="7114290" y="4347545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0" name="Rectangle 319"/>
              <p:cNvSpPr>
                <a:spLocks noChangeArrowheads="1"/>
              </p:cNvSpPr>
              <p:nvPr/>
            </p:nvSpPr>
            <p:spPr bwMode="auto">
              <a:xfrm>
                <a:off x="7479965" y="4347545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1" name="Rectangle 320"/>
              <p:cNvSpPr>
                <a:spLocks noChangeArrowheads="1"/>
              </p:cNvSpPr>
              <p:nvPr/>
            </p:nvSpPr>
            <p:spPr bwMode="auto">
              <a:xfrm>
                <a:off x="7839641" y="4347545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2" name="Rectangle 321"/>
              <p:cNvSpPr>
                <a:spLocks noChangeArrowheads="1"/>
              </p:cNvSpPr>
              <p:nvPr/>
            </p:nvSpPr>
            <p:spPr bwMode="auto">
              <a:xfrm>
                <a:off x="8205315" y="4347545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3" name="Line 322"/>
              <p:cNvSpPr>
                <a:spLocks noChangeShapeType="1"/>
              </p:cNvSpPr>
              <p:nvPr/>
            </p:nvSpPr>
            <p:spPr bwMode="auto">
              <a:xfrm flipV="1">
                <a:off x="6439895" y="2920814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Line 323"/>
              <p:cNvSpPr>
                <a:spLocks noChangeShapeType="1"/>
              </p:cNvSpPr>
              <p:nvPr/>
            </p:nvSpPr>
            <p:spPr bwMode="auto">
              <a:xfrm flipH="1">
                <a:off x="6403927" y="420326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Line 324"/>
              <p:cNvSpPr>
                <a:spLocks noChangeShapeType="1"/>
              </p:cNvSpPr>
              <p:nvPr/>
            </p:nvSpPr>
            <p:spPr bwMode="auto">
              <a:xfrm flipH="1">
                <a:off x="6403927" y="394331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Line 325"/>
              <p:cNvSpPr>
                <a:spLocks noChangeShapeType="1"/>
              </p:cNvSpPr>
              <p:nvPr/>
            </p:nvSpPr>
            <p:spPr bwMode="auto">
              <a:xfrm flipH="1">
                <a:off x="6403927" y="3692019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Line 326"/>
              <p:cNvSpPr>
                <a:spLocks noChangeShapeType="1"/>
              </p:cNvSpPr>
              <p:nvPr/>
            </p:nvSpPr>
            <p:spPr bwMode="auto">
              <a:xfrm flipH="1">
                <a:off x="6403927" y="3432062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Line 327"/>
              <p:cNvSpPr>
                <a:spLocks noChangeShapeType="1"/>
              </p:cNvSpPr>
              <p:nvPr/>
            </p:nvSpPr>
            <p:spPr bwMode="auto">
              <a:xfrm flipH="1">
                <a:off x="6403927" y="318077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Line 328"/>
              <p:cNvSpPr>
                <a:spLocks noChangeShapeType="1"/>
              </p:cNvSpPr>
              <p:nvPr/>
            </p:nvSpPr>
            <p:spPr bwMode="auto">
              <a:xfrm flipH="1">
                <a:off x="6403927" y="2920814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Rectangle 329"/>
              <p:cNvSpPr>
                <a:spLocks noChangeArrowheads="1"/>
              </p:cNvSpPr>
              <p:nvPr/>
            </p:nvSpPr>
            <p:spPr bwMode="auto">
              <a:xfrm>
                <a:off x="6230082" y="4148067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1" name="Rectangle 330"/>
              <p:cNvSpPr>
                <a:spLocks noChangeArrowheads="1"/>
              </p:cNvSpPr>
              <p:nvPr/>
            </p:nvSpPr>
            <p:spPr bwMode="auto">
              <a:xfrm>
                <a:off x="6230082" y="3896775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2" name="Rectangle 331"/>
              <p:cNvSpPr>
                <a:spLocks noChangeArrowheads="1"/>
              </p:cNvSpPr>
              <p:nvPr/>
            </p:nvSpPr>
            <p:spPr bwMode="auto">
              <a:xfrm>
                <a:off x="6230082" y="363681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3" name="Rectangle 332"/>
              <p:cNvSpPr>
                <a:spLocks noChangeArrowheads="1"/>
              </p:cNvSpPr>
              <p:nvPr/>
            </p:nvSpPr>
            <p:spPr bwMode="auto">
              <a:xfrm>
                <a:off x="6230082" y="3385526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4" name="Rectangle 333"/>
              <p:cNvSpPr>
                <a:spLocks noChangeArrowheads="1"/>
              </p:cNvSpPr>
              <p:nvPr/>
            </p:nvSpPr>
            <p:spPr bwMode="auto">
              <a:xfrm>
                <a:off x="6230082" y="312557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5" name="Rectangle 334"/>
              <p:cNvSpPr>
                <a:spLocks noChangeArrowheads="1"/>
              </p:cNvSpPr>
              <p:nvPr/>
            </p:nvSpPr>
            <p:spPr bwMode="auto">
              <a:xfrm>
                <a:off x="6230082" y="287427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86" name="Rectangle 336"/>
              <p:cNvSpPr>
                <a:spLocks noChangeArrowheads="1"/>
              </p:cNvSpPr>
              <p:nvPr/>
            </p:nvSpPr>
            <p:spPr bwMode="auto">
              <a:xfrm>
                <a:off x="7088796" y="2668009"/>
                <a:ext cx="875240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Winter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(N=30)</a:t>
                </a:r>
                <a:endParaRPr kumimoji="0" lang="fr-FR" altLang="fr-FR" sz="1000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0" name="Freeform 340"/>
              <p:cNvSpPr>
                <a:spLocks/>
              </p:cNvSpPr>
              <p:nvPr/>
            </p:nvSpPr>
            <p:spPr bwMode="auto">
              <a:xfrm>
                <a:off x="6439895" y="2920814"/>
                <a:ext cx="1942261" cy="1221798"/>
              </a:xfrm>
              <a:custGeom>
                <a:avLst/>
                <a:gdLst>
                  <a:gd name="T0" fmla="*/ 0 w 324"/>
                  <a:gd name="T1" fmla="*/ 0 h 141"/>
                  <a:gd name="T2" fmla="*/ 35 w 324"/>
                  <a:gd name="T3" fmla="*/ 0 h 141"/>
                  <a:gd name="T4" fmla="*/ 35 w 324"/>
                  <a:gd name="T5" fmla="*/ 7 h 141"/>
                  <a:gd name="T6" fmla="*/ 36 w 324"/>
                  <a:gd name="T7" fmla="*/ 7 h 141"/>
                  <a:gd name="T8" fmla="*/ 36 w 324"/>
                  <a:gd name="T9" fmla="*/ 14 h 141"/>
                  <a:gd name="T10" fmla="*/ 40 w 324"/>
                  <a:gd name="T11" fmla="*/ 14 h 141"/>
                  <a:gd name="T12" fmla="*/ 40 w 324"/>
                  <a:gd name="T13" fmla="*/ 20 h 141"/>
                  <a:gd name="T14" fmla="*/ 48 w 324"/>
                  <a:gd name="T15" fmla="*/ 20 h 141"/>
                  <a:gd name="T16" fmla="*/ 48 w 324"/>
                  <a:gd name="T17" fmla="*/ 27 h 141"/>
                  <a:gd name="T18" fmla="*/ 49 w 324"/>
                  <a:gd name="T19" fmla="*/ 27 h 141"/>
                  <a:gd name="T20" fmla="*/ 49 w 324"/>
                  <a:gd name="T21" fmla="*/ 34 h 141"/>
                  <a:gd name="T22" fmla="*/ 51 w 324"/>
                  <a:gd name="T23" fmla="*/ 34 h 141"/>
                  <a:gd name="T24" fmla="*/ 51 w 324"/>
                  <a:gd name="T25" fmla="*/ 41 h 141"/>
                  <a:gd name="T26" fmla="*/ 53 w 324"/>
                  <a:gd name="T27" fmla="*/ 41 h 141"/>
                  <a:gd name="T28" fmla="*/ 53 w 324"/>
                  <a:gd name="T29" fmla="*/ 47 h 141"/>
                  <a:gd name="T30" fmla="*/ 97 w 324"/>
                  <a:gd name="T31" fmla="*/ 47 h 141"/>
                  <a:gd name="T32" fmla="*/ 97 w 324"/>
                  <a:gd name="T33" fmla="*/ 55 h 141"/>
                  <a:gd name="T34" fmla="*/ 117 w 324"/>
                  <a:gd name="T35" fmla="*/ 55 h 141"/>
                  <a:gd name="T36" fmla="*/ 117 w 324"/>
                  <a:gd name="T37" fmla="*/ 62 h 141"/>
                  <a:gd name="T38" fmla="*/ 123 w 324"/>
                  <a:gd name="T39" fmla="*/ 62 h 141"/>
                  <a:gd name="T40" fmla="*/ 123 w 324"/>
                  <a:gd name="T41" fmla="*/ 69 h 141"/>
                  <a:gd name="T42" fmla="*/ 128 w 324"/>
                  <a:gd name="T43" fmla="*/ 69 h 141"/>
                  <a:gd name="T44" fmla="*/ 128 w 324"/>
                  <a:gd name="T45" fmla="*/ 76 h 141"/>
                  <a:gd name="T46" fmla="*/ 134 w 324"/>
                  <a:gd name="T47" fmla="*/ 76 h 141"/>
                  <a:gd name="T48" fmla="*/ 134 w 324"/>
                  <a:gd name="T49" fmla="*/ 83 h 141"/>
                  <a:gd name="T50" fmla="*/ 134 w 324"/>
                  <a:gd name="T51" fmla="*/ 83 h 141"/>
                  <a:gd name="T52" fmla="*/ 134 w 324"/>
                  <a:gd name="T53" fmla="*/ 90 h 141"/>
                  <a:gd name="T54" fmla="*/ 148 w 324"/>
                  <a:gd name="T55" fmla="*/ 90 h 141"/>
                  <a:gd name="T56" fmla="*/ 148 w 324"/>
                  <a:gd name="T57" fmla="*/ 98 h 141"/>
                  <a:gd name="T58" fmla="*/ 198 w 324"/>
                  <a:gd name="T59" fmla="*/ 98 h 141"/>
                  <a:gd name="T60" fmla="*/ 198 w 324"/>
                  <a:gd name="T61" fmla="*/ 105 h 141"/>
                  <a:gd name="T62" fmla="*/ 202 w 324"/>
                  <a:gd name="T63" fmla="*/ 105 h 141"/>
                  <a:gd name="T64" fmla="*/ 202 w 324"/>
                  <a:gd name="T65" fmla="*/ 112 h 141"/>
                  <a:gd name="T66" fmla="*/ 230 w 324"/>
                  <a:gd name="T67" fmla="*/ 112 h 141"/>
                  <a:gd name="T68" fmla="*/ 230 w 324"/>
                  <a:gd name="T69" fmla="*/ 119 h 141"/>
                  <a:gd name="T70" fmla="*/ 235 w 324"/>
                  <a:gd name="T71" fmla="*/ 119 h 141"/>
                  <a:gd name="T72" fmla="*/ 235 w 324"/>
                  <a:gd name="T73" fmla="*/ 126 h 141"/>
                  <a:gd name="T74" fmla="*/ 296 w 324"/>
                  <a:gd name="T75" fmla="*/ 126 h 141"/>
                  <a:gd name="T76" fmla="*/ 296 w 324"/>
                  <a:gd name="T77" fmla="*/ 134 h 141"/>
                  <a:gd name="T78" fmla="*/ 322 w 324"/>
                  <a:gd name="T79" fmla="*/ 134 h 141"/>
                  <a:gd name="T80" fmla="*/ 322 w 324"/>
                  <a:gd name="T81" fmla="*/ 141 h 141"/>
                  <a:gd name="T82" fmla="*/ 324 w 324"/>
                  <a:gd name="T83" fmla="*/ 141 h 141"/>
                  <a:gd name="T84" fmla="*/ 324 w 324"/>
                  <a:gd name="T8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324" h="141">
                    <a:moveTo>
                      <a:pt x="0" y="0"/>
                    </a:moveTo>
                    <a:lnTo>
                      <a:pt x="35" y="0"/>
                    </a:lnTo>
                    <a:lnTo>
                      <a:pt x="35" y="7"/>
                    </a:lnTo>
                    <a:lnTo>
                      <a:pt x="36" y="7"/>
                    </a:lnTo>
                    <a:lnTo>
                      <a:pt x="36" y="14"/>
                    </a:lnTo>
                    <a:lnTo>
                      <a:pt x="40" y="14"/>
                    </a:lnTo>
                    <a:lnTo>
                      <a:pt x="40" y="20"/>
                    </a:lnTo>
                    <a:lnTo>
                      <a:pt x="48" y="20"/>
                    </a:lnTo>
                    <a:lnTo>
                      <a:pt x="48" y="27"/>
                    </a:lnTo>
                    <a:lnTo>
                      <a:pt x="49" y="27"/>
                    </a:lnTo>
                    <a:lnTo>
                      <a:pt x="49" y="34"/>
                    </a:lnTo>
                    <a:lnTo>
                      <a:pt x="51" y="34"/>
                    </a:lnTo>
                    <a:lnTo>
                      <a:pt x="51" y="41"/>
                    </a:lnTo>
                    <a:lnTo>
                      <a:pt x="53" y="41"/>
                    </a:lnTo>
                    <a:lnTo>
                      <a:pt x="53" y="47"/>
                    </a:lnTo>
                    <a:lnTo>
                      <a:pt x="97" y="47"/>
                    </a:lnTo>
                    <a:lnTo>
                      <a:pt x="97" y="55"/>
                    </a:lnTo>
                    <a:lnTo>
                      <a:pt x="117" y="55"/>
                    </a:lnTo>
                    <a:lnTo>
                      <a:pt x="117" y="62"/>
                    </a:lnTo>
                    <a:lnTo>
                      <a:pt x="123" y="62"/>
                    </a:lnTo>
                    <a:lnTo>
                      <a:pt x="123" y="69"/>
                    </a:lnTo>
                    <a:lnTo>
                      <a:pt x="128" y="69"/>
                    </a:lnTo>
                    <a:lnTo>
                      <a:pt x="128" y="76"/>
                    </a:lnTo>
                    <a:lnTo>
                      <a:pt x="134" y="76"/>
                    </a:lnTo>
                    <a:lnTo>
                      <a:pt x="134" y="83"/>
                    </a:lnTo>
                    <a:lnTo>
                      <a:pt x="134" y="83"/>
                    </a:lnTo>
                    <a:lnTo>
                      <a:pt x="134" y="90"/>
                    </a:lnTo>
                    <a:lnTo>
                      <a:pt x="148" y="90"/>
                    </a:lnTo>
                    <a:lnTo>
                      <a:pt x="148" y="98"/>
                    </a:lnTo>
                    <a:lnTo>
                      <a:pt x="198" y="98"/>
                    </a:lnTo>
                    <a:lnTo>
                      <a:pt x="198" y="105"/>
                    </a:lnTo>
                    <a:lnTo>
                      <a:pt x="202" y="105"/>
                    </a:lnTo>
                    <a:lnTo>
                      <a:pt x="202" y="112"/>
                    </a:lnTo>
                    <a:lnTo>
                      <a:pt x="230" y="112"/>
                    </a:lnTo>
                    <a:lnTo>
                      <a:pt x="230" y="119"/>
                    </a:lnTo>
                    <a:lnTo>
                      <a:pt x="235" y="119"/>
                    </a:lnTo>
                    <a:lnTo>
                      <a:pt x="235" y="126"/>
                    </a:lnTo>
                    <a:lnTo>
                      <a:pt x="296" y="126"/>
                    </a:lnTo>
                    <a:lnTo>
                      <a:pt x="296" y="134"/>
                    </a:lnTo>
                    <a:lnTo>
                      <a:pt x="322" y="134"/>
                    </a:lnTo>
                    <a:lnTo>
                      <a:pt x="322" y="141"/>
                    </a:lnTo>
                    <a:lnTo>
                      <a:pt x="324" y="141"/>
                    </a:lnTo>
                    <a:lnTo>
                      <a:pt x="324" y="141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Freeform 341"/>
              <p:cNvSpPr>
                <a:spLocks/>
              </p:cNvSpPr>
              <p:nvPr/>
            </p:nvSpPr>
            <p:spPr bwMode="auto">
              <a:xfrm>
                <a:off x="6439895" y="2920814"/>
                <a:ext cx="1738443" cy="1282454"/>
              </a:xfrm>
              <a:custGeom>
                <a:avLst/>
                <a:gdLst>
                  <a:gd name="T0" fmla="*/ 0 w 290"/>
                  <a:gd name="T1" fmla="*/ 0 h 148"/>
                  <a:gd name="T2" fmla="*/ 29 w 290"/>
                  <a:gd name="T3" fmla="*/ 0 h 148"/>
                  <a:gd name="T4" fmla="*/ 29 w 290"/>
                  <a:gd name="T5" fmla="*/ 19 h 148"/>
                  <a:gd name="T6" fmla="*/ 30 w 290"/>
                  <a:gd name="T7" fmla="*/ 19 h 148"/>
                  <a:gd name="T8" fmla="*/ 30 w 290"/>
                  <a:gd name="T9" fmla="*/ 37 h 148"/>
                  <a:gd name="T10" fmla="*/ 41 w 290"/>
                  <a:gd name="T11" fmla="*/ 37 h 148"/>
                  <a:gd name="T12" fmla="*/ 41 w 290"/>
                  <a:gd name="T13" fmla="*/ 56 h 148"/>
                  <a:gd name="T14" fmla="*/ 43 w 290"/>
                  <a:gd name="T15" fmla="*/ 56 h 148"/>
                  <a:gd name="T16" fmla="*/ 43 w 290"/>
                  <a:gd name="T17" fmla="*/ 74 h 148"/>
                  <a:gd name="T18" fmla="*/ 52 w 290"/>
                  <a:gd name="T19" fmla="*/ 74 h 148"/>
                  <a:gd name="T20" fmla="*/ 52 w 290"/>
                  <a:gd name="T21" fmla="*/ 93 h 148"/>
                  <a:gd name="T22" fmla="*/ 66 w 290"/>
                  <a:gd name="T23" fmla="*/ 93 h 148"/>
                  <a:gd name="T24" fmla="*/ 66 w 290"/>
                  <a:gd name="T25" fmla="*/ 111 h 148"/>
                  <a:gd name="T26" fmla="*/ 133 w 290"/>
                  <a:gd name="T27" fmla="*/ 111 h 148"/>
                  <a:gd name="T28" fmla="*/ 133 w 290"/>
                  <a:gd name="T29" fmla="*/ 130 h 148"/>
                  <a:gd name="T30" fmla="*/ 290 w 290"/>
                  <a:gd name="T31" fmla="*/ 130 h 148"/>
                  <a:gd name="T32" fmla="*/ 290 w 290"/>
                  <a:gd name="T33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90" h="148">
                    <a:moveTo>
                      <a:pt x="0" y="0"/>
                    </a:moveTo>
                    <a:lnTo>
                      <a:pt x="29" y="0"/>
                    </a:lnTo>
                    <a:lnTo>
                      <a:pt x="29" y="19"/>
                    </a:lnTo>
                    <a:lnTo>
                      <a:pt x="30" y="19"/>
                    </a:lnTo>
                    <a:lnTo>
                      <a:pt x="30" y="37"/>
                    </a:lnTo>
                    <a:lnTo>
                      <a:pt x="41" y="37"/>
                    </a:lnTo>
                    <a:lnTo>
                      <a:pt x="41" y="56"/>
                    </a:lnTo>
                    <a:lnTo>
                      <a:pt x="43" y="56"/>
                    </a:lnTo>
                    <a:lnTo>
                      <a:pt x="43" y="74"/>
                    </a:lnTo>
                    <a:lnTo>
                      <a:pt x="52" y="74"/>
                    </a:lnTo>
                    <a:lnTo>
                      <a:pt x="52" y="93"/>
                    </a:lnTo>
                    <a:lnTo>
                      <a:pt x="66" y="93"/>
                    </a:lnTo>
                    <a:lnTo>
                      <a:pt x="66" y="111"/>
                    </a:lnTo>
                    <a:lnTo>
                      <a:pt x="133" y="111"/>
                    </a:lnTo>
                    <a:lnTo>
                      <a:pt x="133" y="130"/>
                    </a:lnTo>
                    <a:lnTo>
                      <a:pt x="290" y="130"/>
                    </a:lnTo>
                    <a:lnTo>
                      <a:pt x="290" y="148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Rectangle 342"/>
              <p:cNvSpPr>
                <a:spLocks noChangeArrowheads="1"/>
              </p:cNvSpPr>
              <p:nvPr/>
            </p:nvSpPr>
            <p:spPr bwMode="auto">
              <a:xfrm>
                <a:off x="6528132" y="4059413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785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3" name="Rectangle 343"/>
              <p:cNvSpPr>
                <a:spLocks noChangeArrowheads="1"/>
              </p:cNvSpPr>
              <p:nvPr/>
            </p:nvSpPr>
            <p:spPr bwMode="auto">
              <a:xfrm>
                <a:off x="7352981" y="3615687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9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4" name="Rectangle 344"/>
              <p:cNvSpPr>
                <a:spLocks noChangeArrowheads="1"/>
              </p:cNvSpPr>
              <p:nvPr/>
            </p:nvSpPr>
            <p:spPr bwMode="auto">
              <a:xfrm>
                <a:off x="7334878" y="3904395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12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5" name="Line 345"/>
              <p:cNvSpPr>
                <a:spLocks noChangeShapeType="1"/>
              </p:cNvSpPr>
              <p:nvPr/>
            </p:nvSpPr>
            <p:spPr bwMode="auto">
              <a:xfrm>
                <a:off x="939275" y="6405948"/>
                <a:ext cx="190629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Line 346"/>
              <p:cNvSpPr>
                <a:spLocks noChangeShapeType="1"/>
              </p:cNvSpPr>
              <p:nvPr/>
            </p:nvSpPr>
            <p:spPr bwMode="auto">
              <a:xfrm>
                <a:off x="939275" y="6405948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Line 347"/>
              <p:cNvSpPr>
                <a:spLocks noChangeShapeType="1"/>
              </p:cNvSpPr>
              <p:nvPr/>
            </p:nvSpPr>
            <p:spPr bwMode="auto">
              <a:xfrm>
                <a:off x="1322932" y="6405948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Line 348"/>
              <p:cNvSpPr>
                <a:spLocks noChangeShapeType="1"/>
              </p:cNvSpPr>
              <p:nvPr/>
            </p:nvSpPr>
            <p:spPr bwMode="auto">
              <a:xfrm>
                <a:off x="1700594" y="6405948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Line 349"/>
              <p:cNvSpPr>
                <a:spLocks noChangeShapeType="1"/>
              </p:cNvSpPr>
              <p:nvPr/>
            </p:nvSpPr>
            <p:spPr bwMode="auto">
              <a:xfrm>
                <a:off x="2084250" y="6405948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Line 350"/>
              <p:cNvSpPr>
                <a:spLocks noChangeShapeType="1"/>
              </p:cNvSpPr>
              <p:nvPr/>
            </p:nvSpPr>
            <p:spPr bwMode="auto">
              <a:xfrm>
                <a:off x="2461913" y="6405948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Line 351"/>
              <p:cNvSpPr>
                <a:spLocks noChangeShapeType="1"/>
              </p:cNvSpPr>
              <p:nvPr/>
            </p:nvSpPr>
            <p:spPr bwMode="auto">
              <a:xfrm>
                <a:off x="2845569" y="6405948"/>
                <a:ext cx="0" cy="51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Rectangle 352"/>
              <p:cNvSpPr>
                <a:spLocks noChangeArrowheads="1"/>
              </p:cNvSpPr>
              <p:nvPr/>
            </p:nvSpPr>
            <p:spPr bwMode="auto">
              <a:xfrm>
                <a:off x="900309" y="6498233"/>
                <a:ext cx="75465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3" name="Rectangle 353"/>
              <p:cNvSpPr>
                <a:spLocks noChangeArrowheads="1"/>
              </p:cNvSpPr>
              <p:nvPr/>
            </p:nvSpPr>
            <p:spPr bwMode="auto">
              <a:xfrm>
                <a:off x="1265983" y="6498233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4" name="Rectangle 354"/>
              <p:cNvSpPr>
                <a:spLocks noChangeArrowheads="1"/>
              </p:cNvSpPr>
              <p:nvPr/>
            </p:nvSpPr>
            <p:spPr bwMode="auto">
              <a:xfrm>
                <a:off x="1643645" y="6498233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5" name="Rectangle 355"/>
              <p:cNvSpPr>
                <a:spLocks noChangeArrowheads="1"/>
              </p:cNvSpPr>
              <p:nvPr/>
            </p:nvSpPr>
            <p:spPr bwMode="auto">
              <a:xfrm>
                <a:off x="2027301" y="6498233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6" name="Rectangle 356"/>
              <p:cNvSpPr>
                <a:spLocks noChangeArrowheads="1"/>
              </p:cNvSpPr>
              <p:nvPr/>
            </p:nvSpPr>
            <p:spPr bwMode="auto">
              <a:xfrm>
                <a:off x="2404963" y="6498233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" name="Rectangle 357"/>
              <p:cNvSpPr>
                <a:spLocks noChangeArrowheads="1"/>
              </p:cNvSpPr>
              <p:nvPr/>
            </p:nvSpPr>
            <p:spPr bwMode="auto">
              <a:xfrm>
                <a:off x="2788620" y="6498233"/>
                <a:ext cx="150930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8" name="Line 358"/>
              <p:cNvSpPr>
                <a:spLocks noChangeShapeType="1"/>
              </p:cNvSpPr>
              <p:nvPr/>
            </p:nvSpPr>
            <p:spPr bwMode="auto">
              <a:xfrm flipV="1">
                <a:off x="939275" y="5071502"/>
                <a:ext cx="0" cy="12824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Line 359"/>
              <p:cNvSpPr>
                <a:spLocks noChangeShapeType="1"/>
              </p:cNvSpPr>
              <p:nvPr/>
            </p:nvSpPr>
            <p:spPr bwMode="auto">
              <a:xfrm flipH="1">
                <a:off x="903307" y="6353956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Line 360"/>
              <p:cNvSpPr>
                <a:spLocks noChangeShapeType="1"/>
              </p:cNvSpPr>
              <p:nvPr/>
            </p:nvSpPr>
            <p:spPr bwMode="auto">
              <a:xfrm flipH="1">
                <a:off x="903307" y="6093999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Line 361"/>
              <p:cNvSpPr>
                <a:spLocks noChangeShapeType="1"/>
              </p:cNvSpPr>
              <p:nvPr/>
            </p:nvSpPr>
            <p:spPr bwMode="auto">
              <a:xfrm flipH="1">
                <a:off x="903307" y="5842708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Line 362"/>
              <p:cNvSpPr>
                <a:spLocks noChangeShapeType="1"/>
              </p:cNvSpPr>
              <p:nvPr/>
            </p:nvSpPr>
            <p:spPr bwMode="auto">
              <a:xfrm flipH="1">
                <a:off x="903307" y="5582751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Line 363"/>
              <p:cNvSpPr>
                <a:spLocks noChangeShapeType="1"/>
              </p:cNvSpPr>
              <p:nvPr/>
            </p:nvSpPr>
            <p:spPr bwMode="auto">
              <a:xfrm flipH="1">
                <a:off x="903307" y="5331459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Line 364"/>
              <p:cNvSpPr>
                <a:spLocks noChangeShapeType="1"/>
              </p:cNvSpPr>
              <p:nvPr/>
            </p:nvSpPr>
            <p:spPr bwMode="auto">
              <a:xfrm flipH="1">
                <a:off x="903307" y="5071502"/>
                <a:ext cx="359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Rectangle 365"/>
              <p:cNvSpPr>
                <a:spLocks noChangeArrowheads="1"/>
              </p:cNvSpPr>
              <p:nvPr/>
            </p:nvSpPr>
            <p:spPr bwMode="auto">
              <a:xfrm>
                <a:off x="741337" y="626313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6" name="Rectangle 366"/>
              <p:cNvSpPr>
                <a:spLocks noChangeArrowheads="1"/>
              </p:cNvSpPr>
              <p:nvPr/>
            </p:nvSpPr>
            <p:spPr bwMode="auto">
              <a:xfrm>
                <a:off x="741337" y="6011838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7" name="Rectangle 367"/>
              <p:cNvSpPr>
                <a:spLocks noChangeArrowheads="1"/>
              </p:cNvSpPr>
              <p:nvPr/>
            </p:nvSpPr>
            <p:spPr bwMode="auto">
              <a:xfrm>
                <a:off x="741337" y="5751881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8" name="Rectangle 368"/>
              <p:cNvSpPr>
                <a:spLocks noChangeArrowheads="1"/>
              </p:cNvSpPr>
              <p:nvPr/>
            </p:nvSpPr>
            <p:spPr bwMode="auto">
              <a:xfrm>
                <a:off x="741337" y="5500590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9" name="Rectangle 369"/>
              <p:cNvSpPr>
                <a:spLocks noChangeArrowheads="1"/>
              </p:cNvSpPr>
              <p:nvPr/>
            </p:nvSpPr>
            <p:spPr bwMode="auto">
              <a:xfrm>
                <a:off x="741337" y="5240633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0" name="Rectangle 370"/>
              <p:cNvSpPr>
                <a:spLocks noChangeArrowheads="1"/>
              </p:cNvSpPr>
              <p:nvPr/>
            </p:nvSpPr>
            <p:spPr bwMode="auto">
              <a:xfrm>
                <a:off x="741337" y="4989341"/>
                <a:ext cx="188663" cy="125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1" name="Rectangle 372"/>
              <p:cNvSpPr>
                <a:spLocks noChangeArrowheads="1"/>
              </p:cNvSpPr>
              <p:nvPr/>
            </p:nvSpPr>
            <p:spPr bwMode="auto">
              <a:xfrm>
                <a:off x="1588434" y="4804743"/>
                <a:ext cx="865622" cy="1779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i="0" u="sng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Zhang</a:t>
                </a:r>
                <a:r>
                  <a:rPr kumimoji="0" lang="fr-FR" altLang="fr-FR" sz="1000" i="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(N=42)</a:t>
                </a:r>
                <a:endParaRPr kumimoji="0" lang="fr-FR" altLang="fr-FR" sz="1000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3" name="Rectangle 374"/>
              <p:cNvSpPr>
                <a:spLocks noChangeArrowheads="1"/>
              </p:cNvSpPr>
              <p:nvPr/>
            </p:nvSpPr>
            <p:spPr bwMode="auto">
              <a:xfrm>
                <a:off x="1179900" y="6616514"/>
                <a:ext cx="1509303" cy="139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nths after diagnosis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4" name="Rectangle 375"/>
              <p:cNvSpPr>
                <a:spLocks noChangeArrowheads="1"/>
              </p:cNvSpPr>
              <p:nvPr/>
            </p:nvSpPr>
            <p:spPr bwMode="auto">
              <a:xfrm rot="16200000">
                <a:off x="197309" y="5620727"/>
                <a:ext cx="796238" cy="181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Overall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rvival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5" name="Freeform 376"/>
              <p:cNvSpPr>
                <a:spLocks/>
              </p:cNvSpPr>
              <p:nvPr/>
            </p:nvSpPr>
            <p:spPr bwMode="auto">
              <a:xfrm>
                <a:off x="939275" y="5071502"/>
                <a:ext cx="1942262" cy="1282454"/>
              </a:xfrm>
              <a:custGeom>
                <a:avLst/>
                <a:gdLst>
                  <a:gd name="T0" fmla="*/ 0 w 324"/>
                  <a:gd name="T1" fmla="*/ 0 h 148"/>
                  <a:gd name="T2" fmla="*/ 19 w 324"/>
                  <a:gd name="T3" fmla="*/ 0 h 148"/>
                  <a:gd name="T4" fmla="*/ 19 w 324"/>
                  <a:gd name="T5" fmla="*/ 13 h 148"/>
                  <a:gd name="T6" fmla="*/ 32 w 324"/>
                  <a:gd name="T7" fmla="*/ 13 h 148"/>
                  <a:gd name="T8" fmla="*/ 32 w 324"/>
                  <a:gd name="T9" fmla="*/ 25 h 148"/>
                  <a:gd name="T10" fmla="*/ 64 w 324"/>
                  <a:gd name="T11" fmla="*/ 25 h 148"/>
                  <a:gd name="T12" fmla="*/ 64 w 324"/>
                  <a:gd name="T13" fmla="*/ 37 h 148"/>
                  <a:gd name="T14" fmla="*/ 70 w 324"/>
                  <a:gd name="T15" fmla="*/ 37 h 148"/>
                  <a:gd name="T16" fmla="*/ 70 w 324"/>
                  <a:gd name="T17" fmla="*/ 50 h 148"/>
                  <a:gd name="T18" fmla="*/ 89 w 324"/>
                  <a:gd name="T19" fmla="*/ 50 h 148"/>
                  <a:gd name="T20" fmla="*/ 89 w 324"/>
                  <a:gd name="T21" fmla="*/ 62 h 148"/>
                  <a:gd name="T22" fmla="*/ 184 w 324"/>
                  <a:gd name="T23" fmla="*/ 62 h 148"/>
                  <a:gd name="T24" fmla="*/ 184 w 324"/>
                  <a:gd name="T25" fmla="*/ 83 h 148"/>
                  <a:gd name="T26" fmla="*/ 267 w 324"/>
                  <a:gd name="T27" fmla="*/ 83 h 148"/>
                  <a:gd name="T28" fmla="*/ 267 w 324"/>
                  <a:gd name="T29" fmla="*/ 116 h 148"/>
                  <a:gd name="T30" fmla="*/ 324 w 324"/>
                  <a:gd name="T31" fmla="*/ 116 h 148"/>
                  <a:gd name="T32" fmla="*/ 324 w 324"/>
                  <a:gd name="T33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24" h="148">
                    <a:moveTo>
                      <a:pt x="0" y="0"/>
                    </a:moveTo>
                    <a:lnTo>
                      <a:pt x="19" y="0"/>
                    </a:lnTo>
                    <a:lnTo>
                      <a:pt x="19" y="13"/>
                    </a:lnTo>
                    <a:lnTo>
                      <a:pt x="32" y="13"/>
                    </a:lnTo>
                    <a:lnTo>
                      <a:pt x="32" y="25"/>
                    </a:lnTo>
                    <a:lnTo>
                      <a:pt x="64" y="25"/>
                    </a:lnTo>
                    <a:lnTo>
                      <a:pt x="64" y="37"/>
                    </a:lnTo>
                    <a:lnTo>
                      <a:pt x="70" y="37"/>
                    </a:lnTo>
                    <a:lnTo>
                      <a:pt x="70" y="50"/>
                    </a:lnTo>
                    <a:lnTo>
                      <a:pt x="89" y="50"/>
                    </a:lnTo>
                    <a:lnTo>
                      <a:pt x="89" y="62"/>
                    </a:lnTo>
                    <a:lnTo>
                      <a:pt x="184" y="62"/>
                    </a:lnTo>
                    <a:lnTo>
                      <a:pt x="184" y="83"/>
                    </a:lnTo>
                    <a:lnTo>
                      <a:pt x="267" y="83"/>
                    </a:lnTo>
                    <a:lnTo>
                      <a:pt x="267" y="116"/>
                    </a:lnTo>
                    <a:lnTo>
                      <a:pt x="324" y="116"/>
                    </a:lnTo>
                    <a:lnTo>
                      <a:pt x="324" y="148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Freeform 377"/>
              <p:cNvSpPr>
                <a:spLocks/>
              </p:cNvSpPr>
              <p:nvPr/>
            </p:nvSpPr>
            <p:spPr bwMode="auto">
              <a:xfrm>
                <a:off x="939275" y="5071502"/>
                <a:ext cx="1564601" cy="1282454"/>
              </a:xfrm>
              <a:custGeom>
                <a:avLst/>
                <a:gdLst>
                  <a:gd name="T0" fmla="*/ 0 w 261"/>
                  <a:gd name="T1" fmla="*/ 0 h 148"/>
                  <a:gd name="T2" fmla="*/ 13 w 261"/>
                  <a:gd name="T3" fmla="*/ 0 h 148"/>
                  <a:gd name="T4" fmla="*/ 13 w 261"/>
                  <a:gd name="T5" fmla="*/ 5 h 148"/>
                  <a:gd name="T6" fmla="*/ 19 w 261"/>
                  <a:gd name="T7" fmla="*/ 5 h 148"/>
                  <a:gd name="T8" fmla="*/ 19 w 261"/>
                  <a:gd name="T9" fmla="*/ 11 h 148"/>
                  <a:gd name="T10" fmla="*/ 26 w 261"/>
                  <a:gd name="T11" fmla="*/ 11 h 148"/>
                  <a:gd name="T12" fmla="*/ 26 w 261"/>
                  <a:gd name="T13" fmla="*/ 16 h 148"/>
                  <a:gd name="T14" fmla="*/ 32 w 261"/>
                  <a:gd name="T15" fmla="*/ 16 h 148"/>
                  <a:gd name="T16" fmla="*/ 32 w 261"/>
                  <a:gd name="T17" fmla="*/ 21 h 148"/>
                  <a:gd name="T18" fmla="*/ 39 w 261"/>
                  <a:gd name="T19" fmla="*/ 21 h 148"/>
                  <a:gd name="T20" fmla="*/ 39 w 261"/>
                  <a:gd name="T21" fmla="*/ 26 h 148"/>
                  <a:gd name="T22" fmla="*/ 45 w 261"/>
                  <a:gd name="T23" fmla="*/ 26 h 148"/>
                  <a:gd name="T24" fmla="*/ 45 w 261"/>
                  <a:gd name="T25" fmla="*/ 36 h 148"/>
                  <a:gd name="T26" fmla="*/ 51 w 261"/>
                  <a:gd name="T27" fmla="*/ 36 h 148"/>
                  <a:gd name="T28" fmla="*/ 51 w 261"/>
                  <a:gd name="T29" fmla="*/ 41 h 148"/>
                  <a:gd name="T30" fmla="*/ 58 w 261"/>
                  <a:gd name="T31" fmla="*/ 41 h 148"/>
                  <a:gd name="T32" fmla="*/ 58 w 261"/>
                  <a:gd name="T33" fmla="*/ 46 h 148"/>
                  <a:gd name="T34" fmla="*/ 77 w 261"/>
                  <a:gd name="T35" fmla="*/ 46 h 148"/>
                  <a:gd name="T36" fmla="*/ 77 w 261"/>
                  <a:gd name="T37" fmla="*/ 52 h 148"/>
                  <a:gd name="T38" fmla="*/ 83 w 261"/>
                  <a:gd name="T39" fmla="*/ 52 h 148"/>
                  <a:gd name="T40" fmla="*/ 83 w 261"/>
                  <a:gd name="T41" fmla="*/ 69 h 148"/>
                  <a:gd name="T42" fmla="*/ 96 w 261"/>
                  <a:gd name="T43" fmla="*/ 69 h 148"/>
                  <a:gd name="T44" fmla="*/ 96 w 261"/>
                  <a:gd name="T45" fmla="*/ 74 h 148"/>
                  <a:gd name="T46" fmla="*/ 102 w 261"/>
                  <a:gd name="T47" fmla="*/ 74 h 148"/>
                  <a:gd name="T48" fmla="*/ 102 w 261"/>
                  <a:gd name="T49" fmla="*/ 80 h 148"/>
                  <a:gd name="T50" fmla="*/ 121 w 261"/>
                  <a:gd name="T51" fmla="*/ 80 h 148"/>
                  <a:gd name="T52" fmla="*/ 121 w 261"/>
                  <a:gd name="T53" fmla="*/ 86 h 148"/>
                  <a:gd name="T54" fmla="*/ 146 w 261"/>
                  <a:gd name="T55" fmla="*/ 86 h 148"/>
                  <a:gd name="T56" fmla="*/ 146 w 261"/>
                  <a:gd name="T57" fmla="*/ 95 h 148"/>
                  <a:gd name="T58" fmla="*/ 159 w 261"/>
                  <a:gd name="T59" fmla="*/ 95 h 148"/>
                  <a:gd name="T60" fmla="*/ 159 w 261"/>
                  <a:gd name="T61" fmla="*/ 108 h 148"/>
                  <a:gd name="T62" fmla="*/ 178 w 261"/>
                  <a:gd name="T63" fmla="*/ 108 h 148"/>
                  <a:gd name="T64" fmla="*/ 178 w 261"/>
                  <a:gd name="T65" fmla="*/ 122 h 148"/>
                  <a:gd name="T66" fmla="*/ 229 w 261"/>
                  <a:gd name="T67" fmla="*/ 122 h 148"/>
                  <a:gd name="T68" fmla="*/ 229 w 261"/>
                  <a:gd name="T69" fmla="*/ 135 h 148"/>
                  <a:gd name="T70" fmla="*/ 261 w 261"/>
                  <a:gd name="T71" fmla="*/ 135 h 148"/>
                  <a:gd name="T72" fmla="*/ 261 w 261"/>
                  <a:gd name="T73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</a:cxnLst>
                <a:rect l="0" t="0" r="r" b="b"/>
                <a:pathLst>
                  <a:path w="261" h="148">
                    <a:moveTo>
                      <a:pt x="0" y="0"/>
                    </a:moveTo>
                    <a:lnTo>
                      <a:pt x="13" y="0"/>
                    </a:lnTo>
                    <a:lnTo>
                      <a:pt x="13" y="5"/>
                    </a:lnTo>
                    <a:lnTo>
                      <a:pt x="19" y="5"/>
                    </a:lnTo>
                    <a:lnTo>
                      <a:pt x="19" y="11"/>
                    </a:lnTo>
                    <a:lnTo>
                      <a:pt x="26" y="11"/>
                    </a:lnTo>
                    <a:lnTo>
                      <a:pt x="26" y="16"/>
                    </a:lnTo>
                    <a:lnTo>
                      <a:pt x="32" y="16"/>
                    </a:lnTo>
                    <a:lnTo>
                      <a:pt x="32" y="21"/>
                    </a:lnTo>
                    <a:lnTo>
                      <a:pt x="39" y="21"/>
                    </a:lnTo>
                    <a:lnTo>
                      <a:pt x="39" y="26"/>
                    </a:lnTo>
                    <a:lnTo>
                      <a:pt x="45" y="26"/>
                    </a:lnTo>
                    <a:lnTo>
                      <a:pt x="45" y="36"/>
                    </a:lnTo>
                    <a:lnTo>
                      <a:pt x="51" y="36"/>
                    </a:lnTo>
                    <a:lnTo>
                      <a:pt x="51" y="41"/>
                    </a:lnTo>
                    <a:lnTo>
                      <a:pt x="58" y="41"/>
                    </a:lnTo>
                    <a:lnTo>
                      <a:pt x="58" y="46"/>
                    </a:lnTo>
                    <a:lnTo>
                      <a:pt x="77" y="46"/>
                    </a:lnTo>
                    <a:lnTo>
                      <a:pt x="77" y="52"/>
                    </a:lnTo>
                    <a:lnTo>
                      <a:pt x="83" y="52"/>
                    </a:lnTo>
                    <a:lnTo>
                      <a:pt x="83" y="69"/>
                    </a:lnTo>
                    <a:lnTo>
                      <a:pt x="96" y="69"/>
                    </a:lnTo>
                    <a:lnTo>
                      <a:pt x="96" y="74"/>
                    </a:lnTo>
                    <a:lnTo>
                      <a:pt x="102" y="74"/>
                    </a:lnTo>
                    <a:lnTo>
                      <a:pt x="102" y="80"/>
                    </a:lnTo>
                    <a:lnTo>
                      <a:pt x="121" y="80"/>
                    </a:lnTo>
                    <a:lnTo>
                      <a:pt x="121" y="86"/>
                    </a:lnTo>
                    <a:lnTo>
                      <a:pt x="146" y="86"/>
                    </a:lnTo>
                    <a:lnTo>
                      <a:pt x="146" y="95"/>
                    </a:lnTo>
                    <a:lnTo>
                      <a:pt x="159" y="95"/>
                    </a:lnTo>
                    <a:lnTo>
                      <a:pt x="159" y="108"/>
                    </a:lnTo>
                    <a:lnTo>
                      <a:pt x="178" y="108"/>
                    </a:lnTo>
                    <a:lnTo>
                      <a:pt x="178" y="122"/>
                    </a:lnTo>
                    <a:lnTo>
                      <a:pt x="229" y="122"/>
                    </a:lnTo>
                    <a:lnTo>
                      <a:pt x="229" y="135"/>
                    </a:lnTo>
                    <a:lnTo>
                      <a:pt x="261" y="135"/>
                    </a:lnTo>
                    <a:lnTo>
                      <a:pt x="261" y="148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Rectangle 378"/>
              <p:cNvSpPr>
                <a:spLocks noChangeArrowheads="1"/>
              </p:cNvSpPr>
              <p:nvPr/>
            </p:nvSpPr>
            <p:spPr bwMode="auto">
              <a:xfrm>
                <a:off x="1010700" y="6203681"/>
                <a:ext cx="5337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0.0769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8" name="Rectangle 379"/>
              <p:cNvSpPr>
                <a:spLocks noChangeArrowheads="1"/>
              </p:cNvSpPr>
              <p:nvPr/>
            </p:nvSpPr>
            <p:spPr bwMode="auto">
              <a:xfrm>
                <a:off x="1915324" y="5452591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8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29" name="Rectangle 380"/>
              <p:cNvSpPr>
                <a:spLocks noChangeArrowheads="1"/>
              </p:cNvSpPr>
              <p:nvPr/>
            </p:nvSpPr>
            <p:spPr bwMode="auto">
              <a:xfrm>
                <a:off x="1922944" y="5821943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36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42" name="Rectangle 193"/>
              <p:cNvSpPr>
                <a:spLocks noChangeArrowheads="1"/>
              </p:cNvSpPr>
              <p:nvPr/>
            </p:nvSpPr>
            <p:spPr bwMode="auto">
              <a:xfrm>
                <a:off x="4466224" y="1717898"/>
                <a:ext cx="230832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19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2" name="Rectangle 154"/>
              <p:cNvSpPr>
                <a:spLocks noChangeArrowheads="1"/>
              </p:cNvSpPr>
              <p:nvPr/>
            </p:nvSpPr>
            <p:spPr bwMode="auto">
              <a:xfrm>
                <a:off x="1742419" y="1188879"/>
                <a:ext cx="230832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%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3" name="Rectangle 192"/>
              <p:cNvSpPr>
                <a:spLocks noChangeArrowheads="1"/>
              </p:cNvSpPr>
              <p:nvPr/>
            </p:nvSpPr>
            <p:spPr bwMode="auto">
              <a:xfrm>
                <a:off x="2123728" y="1156303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4" name="Rectangle 193"/>
              <p:cNvSpPr>
                <a:spLocks noChangeArrowheads="1"/>
              </p:cNvSpPr>
              <p:nvPr/>
            </p:nvSpPr>
            <p:spPr bwMode="auto">
              <a:xfrm>
                <a:off x="1115696" y="1756953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5" name="Rectangle 192"/>
              <p:cNvSpPr>
                <a:spLocks noChangeArrowheads="1"/>
              </p:cNvSpPr>
              <p:nvPr/>
            </p:nvSpPr>
            <p:spPr bwMode="auto">
              <a:xfrm>
                <a:off x="7557343" y="1215190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6" name="Rectangle 193"/>
              <p:cNvSpPr>
                <a:spLocks noChangeArrowheads="1"/>
              </p:cNvSpPr>
              <p:nvPr/>
            </p:nvSpPr>
            <p:spPr bwMode="auto">
              <a:xfrm>
                <a:off x="6503993" y="1738203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7" name="Rectangle 192"/>
              <p:cNvSpPr>
                <a:spLocks noChangeArrowheads="1"/>
              </p:cNvSpPr>
              <p:nvPr/>
            </p:nvSpPr>
            <p:spPr bwMode="auto">
              <a:xfrm>
                <a:off x="2128212" y="3304296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8" name="Rectangle 193"/>
              <p:cNvSpPr>
                <a:spLocks noChangeArrowheads="1"/>
              </p:cNvSpPr>
              <p:nvPr/>
            </p:nvSpPr>
            <p:spPr bwMode="auto">
              <a:xfrm>
                <a:off x="1028368" y="3864654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9" name="Rectangle 192"/>
              <p:cNvSpPr>
                <a:spLocks noChangeArrowheads="1"/>
              </p:cNvSpPr>
              <p:nvPr/>
            </p:nvSpPr>
            <p:spPr bwMode="auto">
              <a:xfrm>
                <a:off x="4689649" y="3410728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0" name="Rectangle 193"/>
              <p:cNvSpPr>
                <a:spLocks noChangeArrowheads="1"/>
              </p:cNvSpPr>
              <p:nvPr/>
            </p:nvSpPr>
            <p:spPr bwMode="auto">
              <a:xfrm>
                <a:off x="3977897" y="3780842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1" name="Rectangle 192"/>
              <p:cNvSpPr>
                <a:spLocks noChangeArrowheads="1"/>
              </p:cNvSpPr>
              <p:nvPr/>
            </p:nvSpPr>
            <p:spPr bwMode="auto">
              <a:xfrm>
                <a:off x="7524328" y="3349119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3" name="Rectangle 193"/>
              <p:cNvSpPr>
                <a:spLocks noChangeArrowheads="1"/>
              </p:cNvSpPr>
              <p:nvPr/>
            </p:nvSpPr>
            <p:spPr bwMode="auto">
              <a:xfrm>
                <a:off x="1236772" y="5884639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4" name="Rectangle 192"/>
              <p:cNvSpPr>
                <a:spLocks noChangeArrowheads="1"/>
              </p:cNvSpPr>
              <p:nvPr/>
            </p:nvSpPr>
            <p:spPr bwMode="auto">
              <a:xfrm>
                <a:off x="2253739" y="5359826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5" name="Rectangle 193"/>
              <p:cNvSpPr>
                <a:spLocks noChangeArrowheads="1"/>
              </p:cNvSpPr>
              <p:nvPr/>
            </p:nvSpPr>
            <p:spPr bwMode="auto">
              <a:xfrm>
                <a:off x="3909923" y="5911998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6" name="Rectangle 192"/>
              <p:cNvSpPr>
                <a:spLocks noChangeArrowheads="1"/>
              </p:cNvSpPr>
              <p:nvPr/>
            </p:nvSpPr>
            <p:spPr bwMode="auto">
              <a:xfrm>
                <a:off x="4942130" y="5364325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7" name="Rectangle 193"/>
              <p:cNvSpPr>
                <a:spLocks noChangeArrowheads="1"/>
              </p:cNvSpPr>
              <p:nvPr/>
            </p:nvSpPr>
            <p:spPr bwMode="auto">
              <a:xfrm>
                <a:off x="6660232" y="5911998"/>
                <a:ext cx="436017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68" name="Rectangle 192"/>
              <p:cNvSpPr>
                <a:spLocks noChangeArrowheads="1"/>
              </p:cNvSpPr>
              <p:nvPr/>
            </p:nvSpPr>
            <p:spPr bwMode="auto">
              <a:xfrm>
                <a:off x="7677199" y="5387185"/>
                <a:ext cx="423193" cy="138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TS-</a:t>
                </a:r>
                <a:r>
                  <a:rPr kumimoji="0" lang="fr-FR" altLang="fr-F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ike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  <p:cxnSp>
          <p:nvCxnSpPr>
            <p:cNvPr id="332" name="Connecteur droit 331"/>
            <p:cNvCxnSpPr/>
            <p:nvPr/>
          </p:nvCxnSpPr>
          <p:spPr>
            <a:xfrm flipV="1">
              <a:off x="1727878" y="767975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Connecteur droit 332"/>
            <p:cNvCxnSpPr/>
            <p:nvPr/>
          </p:nvCxnSpPr>
          <p:spPr>
            <a:xfrm flipV="1">
              <a:off x="1727878" y="2862725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Connecteur droit 333"/>
            <p:cNvCxnSpPr/>
            <p:nvPr/>
          </p:nvCxnSpPr>
          <p:spPr>
            <a:xfrm flipV="1">
              <a:off x="1884844" y="5014079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Connecteur droit 334"/>
            <p:cNvCxnSpPr/>
            <p:nvPr/>
          </p:nvCxnSpPr>
          <p:spPr>
            <a:xfrm flipV="1">
              <a:off x="4449392" y="767421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Connecteur droit 335"/>
            <p:cNvCxnSpPr/>
            <p:nvPr/>
          </p:nvCxnSpPr>
          <p:spPr>
            <a:xfrm flipV="1">
              <a:off x="4449392" y="2862171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Connecteur droit 336"/>
            <p:cNvCxnSpPr/>
            <p:nvPr/>
          </p:nvCxnSpPr>
          <p:spPr>
            <a:xfrm flipV="1">
              <a:off x="4670296" y="5013525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Connecteur droit 337"/>
            <p:cNvCxnSpPr/>
            <p:nvPr/>
          </p:nvCxnSpPr>
          <p:spPr>
            <a:xfrm flipV="1">
              <a:off x="7190576" y="761165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Connecteur droit 338"/>
            <p:cNvCxnSpPr/>
            <p:nvPr/>
          </p:nvCxnSpPr>
          <p:spPr>
            <a:xfrm flipV="1">
              <a:off x="7326667" y="2855915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Connecteur droit 339"/>
            <p:cNvCxnSpPr/>
            <p:nvPr/>
          </p:nvCxnSpPr>
          <p:spPr>
            <a:xfrm flipV="1">
              <a:off x="7403172" y="5007269"/>
              <a:ext cx="0" cy="126000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85555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6</Words>
  <Application>Microsoft Office PowerPoint</Application>
  <PresentationFormat>Affichage à l'écran (4:3)</PresentationFormat>
  <Paragraphs>17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ia Lopresti</dc:creator>
  <cp:lastModifiedBy>BERTUCCI Francois</cp:lastModifiedBy>
  <cp:revision>2</cp:revision>
  <dcterms:created xsi:type="dcterms:W3CDTF">2017-05-16T13:58:10Z</dcterms:created>
  <dcterms:modified xsi:type="dcterms:W3CDTF">2017-07-17T10:22:59Z</dcterms:modified>
</cp:coreProperties>
</file>